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89" r:id="rId2"/>
    <p:sldId id="290" r:id="rId3"/>
    <p:sldId id="291" r:id="rId4"/>
    <p:sldId id="292" r:id="rId5"/>
    <p:sldId id="282"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87C1E37-3176-42BA-8FAF-4957BE0C6EE5}" v="21" dt="2020-02-26T12:19:49.34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173" autoAdjust="0"/>
    <p:restoredTop sz="94660"/>
  </p:normalViewPr>
  <p:slideViewPr>
    <p:cSldViewPr snapToGrid="0">
      <p:cViewPr varScale="1">
        <p:scale>
          <a:sx n="38" d="100"/>
          <a:sy n="38" d="100"/>
        </p:scale>
        <p:origin x="1024"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hwu\Desktop\10127.txt"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1"/>
          <c:order val="0"/>
          <c:tx>
            <c:strRef>
              <c:f>'10127D221A 200ug'!$C$1</c:f>
              <c:strCache>
                <c:ptCount val="1"/>
                <c:pt idx="0">
                  <c:v>Average RFU</c:v>
                </c:pt>
              </c:strCache>
            </c:strRef>
          </c:tx>
          <c:spPr>
            <a:solidFill>
              <a:srgbClr val="333333"/>
            </a:solidFill>
            <a:ln w="25400">
              <a:noFill/>
            </a:ln>
          </c:spPr>
          <c:invertIfNegative val="0"/>
          <c:errBars>
            <c:errBarType val="both"/>
            <c:errValType val="cust"/>
            <c:noEndCap val="0"/>
            <c:plus>
              <c:numRef>
                <c:f>'10127D221A 200ug'!$D$2:$D$586</c:f>
                <c:numCache>
                  <c:formatCode>General</c:formatCode>
                  <c:ptCount val="585"/>
                  <c:pt idx="0">
                    <c:v>0.9574271077563381</c:v>
                  </c:pt>
                  <c:pt idx="1">
                    <c:v>1.7320508075688772</c:v>
                  </c:pt>
                  <c:pt idx="2">
                    <c:v>1.707825127659933</c:v>
                  </c:pt>
                  <c:pt idx="3">
                    <c:v>2.3629078131263039</c:v>
                  </c:pt>
                  <c:pt idx="4">
                    <c:v>2.6299556396765835</c:v>
                  </c:pt>
                  <c:pt idx="5">
                    <c:v>2.2173557826083452</c:v>
                  </c:pt>
                  <c:pt idx="6">
                    <c:v>2.6299556396765835</c:v>
                  </c:pt>
                  <c:pt idx="7">
                    <c:v>2.2173557826083452</c:v>
                  </c:pt>
                  <c:pt idx="8">
                    <c:v>1.2583057392117916</c:v>
                  </c:pt>
                  <c:pt idx="9">
                    <c:v>0.57735026918962573</c:v>
                  </c:pt>
                  <c:pt idx="10">
                    <c:v>1.2909944487358056</c:v>
                  </c:pt>
                  <c:pt idx="11">
                    <c:v>2.5819888974716112</c:v>
                  </c:pt>
                  <c:pt idx="12">
                    <c:v>1.4142135623730951</c:v>
                  </c:pt>
                  <c:pt idx="13">
                    <c:v>0.9574271077563381</c:v>
                  </c:pt>
                  <c:pt idx="14">
                    <c:v>0.9574271077563381</c:v>
                  </c:pt>
                  <c:pt idx="15">
                    <c:v>1.5</c:v>
                  </c:pt>
                  <c:pt idx="16">
                    <c:v>0.9574271077563381</c:v>
                  </c:pt>
                  <c:pt idx="17">
                    <c:v>0.57735026918962573</c:v>
                  </c:pt>
                  <c:pt idx="18">
                    <c:v>0.5</c:v>
                  </c:pt>
                  <c:pt idx="19">
                    <c:v>0.9574271077563381</c:v>
                  </c:pt>
                  <c:pt idx="20">
                    <c:v>1.2583057392117916</c:v>
                  </c:pt>
                  <c:pt idx="21">
                    <c:v>2.0615528128088303</c:v>
                  </c:pt>
                  <c:pt idx="22">
                    <c:v>2.9439202887759488</c:v>
                  </c:pt>
                  <c:pt idx="23">
                    <c:v>5.715476066494082</c:v>
                  </c:pt>
                  <c:pt idx="24">
                    <c:v>0.5</c:v>
                  </c:pt>
                  <c:pt idx="25">
                    <c:v>0.5</c:v>
                  </c:pt>
                  <c:pt idx="26">
                    <c:v>0.5</c:v>
                  </c:pt>
                  <c:pt idx="27">
                    <c:v>2.6457513110645907</c:v>
                  </c:pt>
                  <c:pt idx="28">
                    <c:v>1.5</c:v>
                  </c:pt>
                  <c:pt idx="29">
                    <c:v>1.4142135623730951</c:v>
                  </c:pt>
                  <c:pt idx="30">
                    <c:v>12.120918557051139</c:v>
                  </c:pt>
                  <c:pt idx="31">
                    <c:v>1.5</c:v>
                  </c:pt>
                  <c:pt idx="32">
                    <c:v>8.0156097709406993</c:v>
                  </c:pt>
                  <c:pt idx="33">
                    <c:v>2.3804761428476167</c:v>
                  </c:pt>
                  <c:pt idx="34">
                    <c:v>1.707825127659933</c:v>
                  </c:pt>
                  <c:pt idx="35">
                    <c:v>0.5</c:v>
                  </c:pt>
                  <c:pt idx="36">
                    <c:v>0.81649658092772603</c:v>
                  </c:pt>
                  <c:pt idx="37">
                    <c:v>0.9574271077563381</c:v>
                  </c:pt>
                  <c:pt idx="38">
                    <c:v>0.9574271077563381</c:v>
                  </c:pt>
                  <c:pt idx="39">
                    <c:v>0.9574271077563381</c:v>
                  </c:pt>
                  <c:pt idx="40">
                    <c:v>0.9574271077563381</c:v>
                  </c:pt>
                  <c:pt idx="41">
                    <c:v>0.9574271077563381</c:v>
                  </c:pt>
                  <c:pt idx="42">
                    <c:v>2.753785273643051</c:v>
                  </c:pt>
                  <c:pt idx="43">
                    <c:v>0.81649658092772603</c:v>
                  </c:pt>
                  <c:pt idx="44">
                    <c:v>1.2909944487358056</c:v>
                  </c:pt>
                  <c:pt idx="45">
                    <c:v>1.2583057392117916</c:v>
                  </c:pt>
                  <c:pt idx="46">
                    <c:v>1</c:v>
                  </c:pt>
                  <c:pt idx="47">
                    <c:v>1</c:v>
                  </c:pt>
                  <c:pt idx="48">
                    <c:v>2.4494897427831779</c:v>
                  </c:pt>
                  <c:pt idx="49">
                    <c:v>0.5</c:v>
                  </c:pt>
                  <c:pt idx="50">
                    <c:v>0</c:v>
                  </c:pt>
                  <c:pt idx="51">
                    <c:v>0.5</c:v>
                  </c:pt>
                  <c:pt idx="52">
                    <c:v>1</c:v>
                  </c:pt>
                  <c:pt idx="53">
                    <c:v>1</c:v>
                  </c:pt>
                  <c:pt idx="54">
                    <c:v>1.2909944487358056</c:v>
                  </c:pt>
                  <c:pt idx="55">
                    <c:v>2.2173557826083452</c:v>
                  </c:pt>
                  <c:pt idx="56">
                    <c:v>0.5</c:v>
                  </c:pt>
                  <c:pt idx="57">
                    <c:v>1.707825127659933</c:v>
                  </c:pt>
                  <c:pt idx="58">
                    <c:v>0.57735026918962573</c:v>
                  </c:pt>
                  <c:pt idx="59">
                    <c:v>2.2173557826083452</c:v>
                  </c:pt>
                  <c:pt idx="60">
                    <c:v>0.57735026918962573</c:v>
                  </c:pt>
                  <c:pt idx="61">
                    <c:v>0.57735026918962573</c:v>
                  </c:pt>
                  <c:pt idx="62">
                    <c:v>0.81649658092772603</c:v>
                  </c:pt>
                  <c:pt idx="63">
                    <c:v>0.9574271077563381</c:v>
                  </c:pt>
                  <c:pt idx="64">
                    <c:v>0.5</c:v>
                  </c:pt>
                  <c:pt idx="65">
                    <c:v>1.707825127659933</c:v>
                  </c:pt>
                  <c:pt idx="66">
                    <c:v>0.81649658092772603</c:v>
                  </c:pt>
                  <c:pt idx="67">
                    <c:v>0.5</c:v>
                  </c:pt>
                  <c:pt idx="68">
                    <c:v>2.2173557826083452</c:v>
                  </c:pt>
                  <c:pt idx="69">
                    <c:v>2.4494897427831779</c:v>
                  </c:pt>
                  <c:pt idx="70">
                    <c:v>1.5</c:v>
                  </c:pt>
                  <c:pt idx="71">
                    <c:v>13.889444433333777</c:v>
                  </c:pt>
                  <c:pt idx="72">
                    <c:v>0.57735026918962573</c:v>
                  </c:pt>
                  <c:pt idx="73">
                    <c:v>0.5</c:v>
                  </c:pt>
                  <c:pt idx="74">
                    <c:v>2.0615528128088303</c:v>
                  </c:pt>
                  <c:pt idx="75">
                    <c:v>1</c:v>
                  </c:pt>
                  <c:pt idx="76">
                    <c:v>0.5</c:v>
                  </c:pt>
                  <c:pt idx="77">
                    <c:v>1.1547005383792515</c:v>
                  </c:pt>
                  <c:pt idx="78">
                    <c:v>1.4142135623730951</c:v>
                  </c:pt>
                  <c:pt idx="79">
                    <c:v>0.57735026918962573</c:v>
                  </c:pt>
                  <c:pt idx="80">
                    <c:v>1.1547005383792515</c:v>
                  </c:pt>
                  <c:pt idx="81">
                    <c:v>1</c:v>
                  </c:pt>
                  <c:pt idx="82">
                    <c:v>1.5</c:v>
                  </c:pt>
                  <c:pt idx="83">
                    <c:v>0.81649658092772603</c:v>
                  </c:pt>
                  <c:pt idx="84">
                    <c:v>0.5</c:v>
                  </c:pt>
                  <c:pt idx="85">
                    <c:v>0.5</c:v>
                  </c:pt>
                  <c:pt idx="86">
                    <c:v>21.546461426415242</c:v>
                  </c:pt>
                  <c:pt idx="87">
                    <c:v>0.81649658092772603</c:v>
                  </c:pt>
                  <c:pt idx="88">
                    <c:v>0.5</c:v>
                  </c:pt>
                  <c:pt idx="89">
                    <c:v>1.6329931618554521</c:v>
                  </c:pt>
                  <c:pt idx="90">
                    <c:v>0</c:v>
                  </c:pt>
                  <c:pt idx="91">
                    <c:v>0.81649658092772603</c:v>
                  </c:pt>
                  <c:pt idx="92">
                    <c:v>0.5</c:v>
                  </c:pt>
                  <c:pt idx="93">
                    <c:v>0.57735026918962573</c:v>
                  </c:pt>
                  <c:pt idx="94">
                    <c:v>0.57735026918962573</c:v>
                  </c:pt>
                  <c:pt idx="95">
                    <c:v>0.9574271077563381</c:v>
                  </c:pt>
                  <c:pt idx="96">
                    <c:v>1.4142135623730951</c:v>
                  </c:pt>
                  <c:pt idx="97">
                    <c:v>0.57735026918962573</c:v>
                  </c:pt>
                  <c:pt idx="98">
                    <c:v>0.9574271077563381</c:v>
                  </c:pt>
                  <c:pt idx="99">
                    <c:v>1.5</c:v>
                  </c:pt>
                  <c:pt idx="100">
                    <c:v>0.81649658092772603</c:v>
                  </c:pt>
                  <c:pt idx="101">
                    <c:v>0.9574271077563381</c:v>
                  </c:pt>
                  <c:pt idx="102">
                    <c:v>0.57735026918962573</c:v>
                  </c:pt>
                  <c:pt idx="103">
                    <c:v>1.7320508075688772</c:v>
                  </c:pt>
                  <c:pt idx="104">
                    <c:v>1.707825127659933</c:v>
                  </c:pt>
                  <c:pt idx="105">
                    <c:v>0.57735026918962573</c:v>
                  </c:pt>
                  <c:pt idx="106">
                    <c:v>0.5</c:v>
                  </c:pt>
                  <c:pt idx="107">
                    <c:v>1.2583057392117916</c:v>
                  </c:pt>
                  <c:pt idx="108">
                    <c:v>0.9574271077563381</c:v>
                  </c:pt>
                  <c:pt idx="109">
                    <c:v>1.2909944487358056</c:v>
                  </c:pt>
                  <c:pt idx="110">
                    <c:v>0.5</c:v>
                  </c:pt>
                  <c:pt idx="111">
                    <c:v>1.2583057392117916</c:v>
                  </c:pt>
                  <c:pt idx="112">
                    <c:v>1.5</c:v>
                  </c:pt>
                  <c:pt idx="113">
                    <c:v>1.6329931618554521</c:v>
                  </c:pt>
                  <c:pt idx="114">
                    <c:v>0.9574271077563381</c:v>
                  </c:pt>
                  <c:pt idx="115">
                    <c:v>0.81649658092772603</c:v>
                  </c:pt>
                  <c:pt idx="116">
                    <c:v>0.9574271077563381</c:v>
                  </c:pt>
                  <c:pt idx="117">
                    <c:v>1.8929694486000912</c:v>
                  </c:pt>
                  <c:pt idx="118">
                    <c:v>0.9574271077563381</c:v>
                  </c:pt>
                  <c:pt idx="119">
                    <c:v>0.5</c:v>
                  </c:pt>
                  <c:pt idx="120">
                    <c:v>0.9574271077563381</c:v>
                  </c:pt>
                  <c:pt idx="121">
                    <c:v>1.5</c:v>
                  </c:pt>
                  <c:pt idx="122">
                    <c:v>4.0311288741492746</c:v>
                  </c:pt>
                  <c:pt idx="123">
                    <c:v>0.5</c:v>
                  </c:pt>
                  <c:pt idx="124">
                    <c:v>1.8929694486000912</c:v>
                  </c:pt>
                  <c:pt idx="125">
                    <c:v>1.1547005383792515</c:v>
                  </c:pt>
                  <c:pt idx="126">
                    <c:v>0.9574271077563381</c:v>
                  </c:pt>
                  <c:pt idx="127">
                    <c:v>1</c:v>
                  </c:pt>
                  <c:pt idx="128">
                    <c:v>0.9574271077563381</c:v>
                  </c:pt>
                  <c:pt idx="129">
                    <c:v>0.81649658092772603</c:v>
                  </c:pt>
                  <c:pt idx="130">
                    <c:v>1.5</c:v>
                  </c:pt>
                  <c:pt idx="131">
                    <c:v>0.57735026918962573</c:v>
                  </c:pt>
                  <c:pt idx="132">
                    <c:v>0.57735026918962573</c:v>
                  </c:pt>
                  <c:pt idx="133">
                    <c:v>0.57735026918962573</c:v>
                  </c:pt>
                  <c:pt idx="134">
                    <c:v>1.2583057392117916</c:v>
                  </c:pt>
                  <c:pt idx="135">
                    <c:v>0.57735026918962573</c:v>
                  </c:pt>
                  <c:pt idx="136">
                    <c:v>0.5</c:v>
                  </c:pt>
                  <c:pt idx="137">
                    <c:v>1.2909944487358056</c:v>
                  </c:pt>
                  <c:pt idx="138">
                    <c:v>0.9574271077563381</c:v>
                  </c:pt>
                  <c:pt idx="139">
                    <c:v>0.5</c:v>
                  </c:pt>
                  <c:pt idx="140">
                    <c:v>2.2173557826083452</c:v>
                  </c:pt>
                  <c:pt idx="141">
                    <c:v>0.5</c:v>
                  </c:pt>
                  <c:pt idx="142">
                    <c:v>0.5</c:v>
                  </c:pt>
                  <c:pt idx="143">
                    <c:v>0.81649658092772603</c:v>
                  </c:pt>
                  <c:pt idx="144">
                    <c:v>0.9574271077563381</c:v>
                  </c:pt>
                  <c:pt idx="145">
                    <c:v>1.707825127659933</c:v>
                  </c:pt>
                  <c:pt idx="146">
                    <c:v>0.57735026918962573</c:v>
                  </c:pt>
                  <c:pt idx="147">
                    <c:v>0</c:v>
                  </c:pt>
                  <c:pt idx="148">
                    <c:v>0.81649658092772603</c:v>
                  </c:pt>
                  <c:pt idx="149">
                    <c:v>0.57735026918962573</c:v>
                  </c:pt>
                  <c:pt idx="150">
                    <c:v>0.57735026918962573</c:v>
                  </c:pt>
                  <c:pt idx="151">
                    <c:v>0.57735026918962573</c:v>
                  </c:pt>
                  <c:pt idx="152">
                    <c:v>2.753785273643051</c:v>
                  </c:pt>
                  <c:pt idx="153">
                    <c:v>3.0956959368344519</c:v>
                  </c:pt>
                  <c:pt idx="154">
                    <c:v>1.2583057392117916</c:v>
                  </c:pt>
                  <c:pt idx="155">
                    <c:v>1.2909944487358056</c:v>
                  </c:pt>
                  <c:pt idx="156">
                    <c:v>0.5</c:v>
                  </c:pt>
                  <c:pt idx="157">
                    <c:v>0.5</c:v>
                  </c:pt>
                  <c:pt idx="158">
                    <c:v>1.2909944487358056</c:v>
                  </c:pt>
                  <c:pt idx="159">
                    <c:v>0</c:v>
                  </c:pt>
                  <c:pt idx="160">
                    <c:v>0.5</c:v>
                  </c:pt>
                  <c:pt idx="161">
                    <c:v>0</c:v>
                  </c:pt>
                  <c:pt idx="162">
                    <c:v>1.4142135623730951</c:v>
                  </c:pt>
                  <c:pt idx="163">
                    <c:v>0</c:v>
                  </c:pt>
                  <c:pt idx="164">
                    <c:v>0.5</c:v>
                  </c:pt>
                  <c:pt idx="165">
                    <c:v>0</c:v>
                  </c:pt>
                  <c:pt idx="166">
                    <c:v>4</c:v>
                  </c:pt>
                  <c:pt idx="167">
                    <c:v>0.5</c:v>
                  </c:pt>
                  <c:pt idx="168">
                    <c:v>1</c:v>
                  </c:pt>
                  <c:pt idx="169">
                    <c:v>0.81649658092772603</c:v>
                  </c:pt>
                  <c:pt idx="170">
                    <c:v>1.7320508075688772</c:v>
                  </c:pt>
                  <c:pt idx="171">
                    <c:v>1.7320508075688772</c:v>
                  </c:pt>
                  <c:pt idx="172">
                    <c:v>0.9574271077563381</c:v>
                  </c:pt>
                  <c:pt idx="173">
                    <c:v>1</c:v>
                  </c:pt>
                  <c:pt idx="174">
                    <c:v>0.81649658092772603</c:v>
                  </c:pt>
                  <c:pt idx="175">
                    <c:v>0.5</c:v>
                  </c:pt>
                  <c:pt idx="176">
                    <c:v>0.57735026918962573</c:v>
                  </c:pt>
                  <c:pt idx="177">
                    <c:v>0.5</c:v>
                  </c:pt>
                  <c:pt idx="178">
                    <c:v>0.9574271077563381</c:v>
                  </c:pt>
                  <c:pt idx="179">
                    <c:v>0.9574271077563381</c:v>
                  </c:pt>
                  <c:pt idx="180">
                    <c:v>0</c:v>
                  </c:pt>
                  <c:pt idx="181">
                    <c:v>0.57735026918962573</c:v>
                  </c:pt>
                  <c:pt idx="182">
                    <c:v>0.5</c:v>
                  </c:pt>
                  <c:pt idx="183">
                    <c:v>1.1547005383792515</c:v>
                  </c:pt>
                  <c:pt idx="184">
                    <c:v>0.5</c:v>
                  </c:pt>
                  <c:pt idx="185">
                    <c:v>1.2583057392117916</c:v>
                  </c:pt>
                  <c:pt idx="186">
                    <c:v>6.757711644237764</c:v>
                  </c:pt>
                  <c:pt idx="187">
                    <c:v>1.4142135623730951</c:v>
                  </c:pt>
                  <c:pt idx="188">
                    <c:v>1.2583057392117916</c:v>
                  </c:pt>
                  <c:pt idx="189">
                    <c:v>2.3629078131263039</c:v>
                  </c:pt>
                  <c:pt idx="190">
                    <c:v>1.2909944487358056</c:v>
                  </c:pt>
                  <c:pt idx="191">
                    <c:v>0.9574271077563381</c:v>
                  </c:pt>
                  <c:pt idx="192">
                    <c:v>0.9574271077563381</c:v>
                  </c:pt>
                  <c:pt idx="193">
                    <c:v>3.0956959368344519</c:v>
                  </c:pt>
                  <c:pt idx="194">
                    <c:v>0.9574271077563381</c:v>
                  </c:pt>
                  <c:pt idx="195">
                    <c:v>0.5</c:v>
                  </c:pt>
                  <c:pt idx="196">
                    <c:v>1.6329931618554521</c:v>
                  </c:pt>
                  <c:pt idx="197">
                    <c:v>1.2909944487358056</c:v>
                  </c:pt>
                  <c:pt idx="198">
                    <c:v>1.9148542155126762</c:v>
                  </c:pt>
                  <c:pt idx="199">
                    <c:v>1.9148542155126762</c:v>
                  </c:pt>
                  <c:pt idx="200">
                    <c:v>0.9574271077563381</c:v>
                  </c:pt>
                  <c:pt idx="201">
                    <c:v>3.7749172176353749</c:v>
                  </c:pt>
                  <c:pt idx="202">
                    <c:v>2.0816659994661326</c:v>
                  </c:pt>
                  <c:pt idx="203">
                    <c:v>1.2583057392117916</c:v>
                  </c:pt>
                  <c:pt idx="204">
                    <c:v>1.4142135623730951</c:v>
                  </c:pt>
                  <c:pt idx="205">
                    <c:v>0</c:v>
                  </c:pt>
                  <c:pt idx="206">
                    <c:v>1.4142135623730951</c:v>
                  </c:pt>
                  <c:pt idx="207">
                    <c:v>1.2909944487358056</c:v>
                  </c:pt>
                  <c:pt idx="208">
                    <c:v>0.81649658092772603</c:v>
                  </c:pt>
                  <c:pt idx="209">
                    <c:v>0.81649658092772603</c:v>
                  </c:pt>
                  <c:pt idx="210">
                    <c:v>1.4142135623730951</c:v>
                  </c:pt>
                  <c:pt idx="211">
                    <c:v>0.5</c:v>
                  </c:pt>
                  <c:pt idx="212">
                    <c:v>0.5</c:v>
                  </c:pt>
                  <c:pt idx="213">
                    <c:v>0.5</c:v>
                  </c:pt>
                  <c:pt idx="214">
                    <c:v>0.9574271077563381</c:v>
                  </c:pt>
                  <c:pt idx="215">
                    <c:v>0.5</c:v>
                  </c:pt>
                  <c:pt idx="216">
                    <c:v>2.6299556396765835</c:v>
                  </c:pt>
                  <c:pt idx="217">
                    <c:v>0.9574271077563381</c:v>
                  </c:pt>
                  <c:pt idx="218">
                    <c:v>0.57735026918962573</c:v>
                  </c:pt>
                  <c:pt idx="219">
                    <c:v>0.5</c:v>
                  </c:pt>
                  <c:pt idx="220">
                    <c:v>1.4142135623730951</c:v>
                  </c:pt>
                  <c:pt idx="221">
                    <c:v>1</c:v>
                  </c:pt>
                  <c:pt idx="222">
                    <c:v>0.9574271077563381</c:v>
                  </c:pt>
                  <c:pt idx="223">
                    <c:v>1.8257418583505538</c:v>
                  </c:pt>
                  <c:pt idx="224">
                    <c:v>1.2909944487358056</c:v>
                  </c:pt>
                  <c:pt idx="225">
                    <c:v>0.5</c:v>
                  </c:pt>
                  <c:pt idx="226">
                    <c:v>0.5</c:v>
                  </c:pt>
                  <c:pt idx="227">
                    <c:v>0.5</c:v>
                  </c:pt>
                  <c:pt idx="228">
                    <c:v>1.2583057392117916</c:v>
                  </c:pt>
                  <c:pt idx="229">
                    <c:v>0.9574271077563381</c:v>
                  </c:pt>
                  <c:pt idx="230">
                    <c:v>0.5</c:v>
                  </c:pt>
                  <c:pt idx="231">
                    <c:v>0.81649658092772603</c:v>
                  </c:pt>
                  <c:pt idx="232">
                    <c:v>0.81649658092772603</c:v>
                  </c:pt>
                  <c:pt idx="233">
                    <c:v>0.81649658092772603</c:v>
                  </c:pt>
                  <c:pt idx="234">
                    <c:v>1.4142135623730951</c:v>
                  </c:pt>
                  <c:pt idx="235">
                    <c:v>0.9574271077563381</c:v>
                  </c:pt>
                  <c:pt idx="236">
                    <c:v>0.5</c:v>
                  </c:pt>
                  <c:pt idx="237">
                    <c:v>0.81649658092772603</c:v>
                  </c:pt>
                  <c:pt idx="238">
                    <c:v>1.5</c:v>
                  </c:pt>
                  <c:pt idx="239">
                    <c:v>0.57735026918962573</c:v>
                  </c:pt>
                  <c:pt idx="240">
                    <c:v>2.3804761428476167</c:v>
                  </c:pt>
                  <c:pt idx="241">
                    <c:v>1.707825127659933</c:v>
                  </c:pt>
                  <c:pt idx="242">
                    <c:v>1.707825127659933</c:v>
                  </c:pt>
                  <c:pt idx="243">
                    <c:v>0</c:v>
                  </c:pt>
                  <c:pt idx="244">
                    <c:v>0.9574271077563381</c:v>
                  </c:pt>
                  <c:pt idx="245">
                    <c:v>0.81649658092772603</c:v>
                  </c:pt>
                  <c:pt idx="246">
                    <c:v>0.5</c:v>
                  </c:pt>
                  <c:pt idx="247">
                    <c:v>0.9574271077563381</c:v>
                  </c:pt>
                  <c:pt idx="248">
                    <c:v>228.07162617622268</c:v>
                  </c:pt>
                  <c:pt idx="249">
                    <c:v>1.2909944487358056</c:v>
                  </c:pt>
                  <c:pt idx="250">
                    <c:v>1.707825127659933</c:v>
                  </c:pt>
                  <c:pt idx="251">
                    <c:v>11.870832602082579</c:v>
                  </c:pt>
                  <c:pt idx="252">
                    <c:v>34.200389861325654</c:v>
                  </c:pt>
                  <c:pt idx="253">
                    <c:v>1.2583057392117916</c:v>
                  </c:pt>
                  <c:pt idx="254">
                    <c:v>1</c:v>
                  </c:pt>
                  <c:pt idx="255">
                    <c:v>0.5</c:v>
                  </c:pt>
                  <c:pt idx="256">
                    <c:v>0.5</c:v>
                  </c:pt>
                  <c:pt idx="257">
                    <c:v>0.57735026918962573</c:v>
                  </c:pt>
                  <c:pt idx="258">
                    <c:v>0.5</c:v>
                  </c:pt>
                  <c:pt idx="259">
                    <c:v>1</c:v>
                  </c:pt>
                  <c:pt idx="260">
                    <c:v>10.801234497346433</c:v>
                  </c:pt>
                  <c:pt idx="261">
                    <c:v>0.5</c:v>
                  </c:pt>
                  <c:pt idx="262">
                    <c:v>0.81649658092772603</c:v>
                  </c:pt>
                  <c:pt idx="263">
                    <c:v>0.9574271077563381</c:v>
                  </c:pt>
                  <c:pt idx="264">
                    <c:v>0.81649658092772603</c:v>
                  </c:pt>
                  <c:pt idx="265">
                    <c:v>0.57735026918962573</c:v>
                  </c:pt>
                  <c:pt idx="266">
                    <c:v>0.5</c:v>
                  </c:pt>
                  <c:pt idx="267">
                    <c:v>0.81649658092772603</c:v>
                  </c:pt>
                  <c:pt idx="268">
                    <c:v>1</c:v>
                  </c:pt>
                  <c:pt idx="269">
                    <c:v>0.9574271077563381</c:v>
                  </c:pt>
                  <c:pt idx="270">
                    <c:v>0.5</c:v>
                  </c:pt>
                  <c:pt idx="271">
                    <c:v>0.9574271077563381</c:v>
                  </c:pt>
                  <c:pt idx="272">
                    <c:v>0.5</c:v>
                  </c:pt>
                  <c:pt idx="273">
                    <c:v>0.5</c:v>
                  </c:pt>
                  <c:pt idx="274">
                    <c:v>0.57735026918962573</c:v>
                  </c:pt>
                  <c:pt idx="275">
                    <c:v>0.5</c:v>
                  </c:pt>
                  <c:pt idx="276">
                    <c:v>1</c:v>
                  </c:pt>
                  <c:pt idx="277">
                    <c:v>4.7169905660283016</c:v>
                  </c:pt>
                  <c:pt idx="278">
                    <c:v>0.5</c:v>
                  </c:pt>
                  <c:pt idx="279">
                    <c:v>2.2173557826083452</c:v>
                  </c:pt>
                  <c:pt idx="280">
                    <c:v>0.5</c:v>
                  </c:pt>
                  <c:pt idx="281">
                    <c:v>0.57735026918962573</c:v>
                  </c:pt>
                  <c:pt idx="282">
                    <c:v>0.57735026918962573</c:v>
                  </c:pt>
                  <c:pt idx="283">
                    <c:v>0.81649658092772603</c:v>
                  </c:pt>
                  <c:pt idx="284">
                    <c:v>0.5</c:v>
                  </c:pt>
                  <c:pt idx="285">
                    <c:v>0.5</c:v>
                  </c:pt>
                  <c:pt idx="286">
                    <c:v>0.57735026918962573</c:v>
                  </c:pt>
                  <c:pt idx="287">
                    <c:v>1.7320508075688772</c:v>
                  </c:pt>
                  <c:pt idx="288">
                    <c:v>0.5</c:v>
                  </c:pt>
                  <c:pt idx="289">
                    <c:v>0.9574271077563381</c:v>
                  </c:pt>
                  <c:pt idx="290">
                    <c:v>0.81649658092772603</c:v>
                  </c:pt>
                  <c:pt idx="291">
                    <c:v>0.5</c:v>
                  </c:pt>
                  <c:pt idx="292">
                    <c:v>2.5</c:v>
                  </c:pt>
                  <c:pt idx="293">
                    <c:v>0.9574271077563381</c:v>
                  </c:pt>
                  <c:pt idx="294">
                    <c:v>3.6968455021364721</c:v>
                  </c:pt>
                  <c:pt idx="295">
                    <c:v>0.5</c:v>
                  </c:pt>
                  <c:pt idx="296">
                    <c:v>0.81649658092772603</c:v>
                  </c:pt>
                  <c:pt idx="297">
                    <c:v>0.57735026918962573</c:v>
                  </c:pt>
                  <c:pt idx="298">
                    <c:v>0.5</c:v>
                  </c:pt>
                  <c:pt idx="299">
                    <c:v>1.1547005383792515</c:v>
                  </c:pt>
                  <c:pt idx="300">
                    <c:v>2.0615528128088303</c:v>
                  </c:pt>
                  <c:pt idx="301">
                    <c:v>1.4142135623730951</c:v>
                  </c:pt>
                  <c:pt idx="302">
                    <c:v>0.5</c:v>
                  </c:pt>
                  <c:pt idx="303">
                    <c:v>4.0311288741492746</c:v>
                  </c:pt>
                  <c:pt idx="304">
                    <c:v>0.5</c:v>
                  </c:pt>
                  <c:pt idx="305">
                    <c:v>0.9574271077563381</c:v>
                  </c:pt>
                  <c:pt idx="306">
                    <c:v>0.81649658092772603</c:v>
                  </c:pt>
                  <c:pt idx="307">
                    <c:v>1</c:v>
                  </c:pt>
                  <c:pt idx="308">
                    <c:v>7.2743842809317316</c:v>
                  </c:pt>
                  <c:pt idx="309">
                    <c:v>0.5</c:v>
                  </c:pt>
                  <c:pt idx="310">
                    <c:v>0</c:v>
                  </c:pt>
                  <c:pt idx="311">
                    <c:v>0.9574271077563381</c:v>
                  </c:pt>
                  <c:pt idx="312">
                    <c:v>0.57735026918962573</c:v>
                  </c:pt>
                  <c:pt idx="313">
                    <c:v>0.5</c:v>
                  </c:pt>
                  <c:pt idx="314">
                    <c:v>0.57735026918962573</c:v>
                  </c:pt>
                  <c:pt idx="315">
                    <c:v>1.7320508075688772</c:v>
                  </c:pt>
                  <c:pt idx="316">
                    <c:v>0.5</c:v>
                  </c:pt>
                  <c:pt idx="317">
                    <c:v>0.57735026918962573</c:v>
                  </c:pt>
                  <c:pt idx="318">
                    <c:v>1.707825127659933</c:v>
                  </c:pt>
                  <c:pt idx="319">
                    <c:v>0.5</c:v>
                  </c:pt>
                  <c:pt idx="320">
                    <c:v>0.57735026918962573</c:v>
                  </c:pt>
                  <c:pt idx="321">
                    <c:v>1.7320508075688772</c:v>
                  </c:pt>
                  <c:pt idx="322">
                    <c:v>0.9574271077563381</c:v>
                  </c:pt>
                  <c:pt idx="323">
                    <c:v>0.57735026918962573</c:v>
                  </c:pt>
                  <c:pt idx="324">
                    <c:v>0.5</c:v>
                  </c:pt>
                  <c:pt idx="325">
                    <c:v>0.9574271077563381</c:v>
                  </c:pt>
                  <c:pt idx="326">
                    <c:v>0.5</c:v>
                  </c:pt>
                  <c:pt idx="327">
                    <c:v>0</c:v>
                  </c:pt>
                  <c:pt idx="328">
                    <c:v>0.5</c:v>
                  </c:pt>
                  <c:pt idx="329">
                    <c:v>0.81649658092772603</c:v>
                  </c:pt>
                  <c:pt idx="330">
                    <c:v>0.5</c:v>
                  </c:pt>
                  <c:pt idx="331">
                    <c:v>0</c:v>
                  </c:pt>
                  <c:pt idx="332">
                    <c:v>0.57735026918962573</c:v>
                  </c:pt>
                  <c:pt idx="333">
                    <c:v>1</c:v>
                  </c:pt>
                  <c:pt idx="334">
                    <c:v>0.9574271077563381</c:v>
                  </c:pt>
                  <c:pt idx="335">
                    <c:v>8.5244745683629475</c:v>
                  </c:pt>
                  <c:pt idx="336">
                    <c:v>1.2583057392117916</c:v>
                  </c:pt>
                  <c:pt idx="337">
                    <c:v>1.707825127659933</c:v>
                  </c:pt>
                  <c:pt idx="338">
                    <c:v>0.5</c:v>
                  </c:pt>
                  <c:pt idx="339">
                    <c:v>1.2583057392117916</c:v>
                  </c:pt>
                  <c:pt idx="340">
                    <c:v>1.2909944487358056</c:v>
                  </c:pt>
                  <c:pt idx="341">
                    <c:v>0.57735026918962573</c:v>
                  </c:pt>
                  <c:pt idx="342">
                    <c:v>0.5</c:v>
                  </c:pt>
                  <c:pt idx="343">
                    <c:v>0.81649658092772603</c:v>
                  </c:pt>
                  <c:pt idx="344">
                    <c:v>0.57735026918962573</c:v>
                  </c:pt>
                  <c:pt idx="345">
                    <c:v>0.9574271077563381</c:v>
                  </c:pt>
                  <c:pt idx="346">
                    <c:v>0</c:v>
                  </c:pt>
                  <c:pt idx="347">
                    <c:v>1.8257418583505538</c:v>
                  </c:pt>
                  <c:pt idx="348">
                    <c:v>1.6329931618554521</c:v>
                  </c:pt>
                  <c:pt idx="349">
                    <c:v>3.7749172176353749</c:v>
                  </c:pt>
                  <c:pt idx="350">
                    <c:v>1.1547005383792515</c:v>
                  </c:pt>
                  <c:pt idx="351">
                    <c:v>1.4142135623730951</c:v>
                  </c:pt>
                  <c:pt idx="352">
                    <c:v>0</c:v>
                  </c:pt>
                  <c:pt idx="353">
                    <c:v>24.513601666557825</c:v>
                  </c:pt>
                  <c:pt idx="354">
                    <c:v>37.579914848227105</c:v>
                  </c:pt>
                  <c:pt idx="355">
                    <c:v>1.2583057392117916</c:v>
                  </c:pt>
                  <c:pt idx="356">
                    <c:v>0.9574271077563381</c:v>
                  </c:pt>
                  <c:pt idx="357">
                    <c:v>1.707825127659933</c:v>
                  </c:pt>
                  <c:pt idx="358">
                    <c:v>31.255666152982034</c:v>
                  </c:pt>
                  <c:pt idx="359">
                    <c:v>0.57735026918962573</c:v>
                  </c:pt>
                  <c:pt idx="360">
                    <c:v>1.5</c:v>
                  </c:pt>
                  <c:pt idx="361">
                    <c:v>0.81649658092772603</c:v>
                  </c:pt>
                  <c:pt idx="362">
                    <c:v>1.2583057392117916</c:v>
                  </c:pt>
                  <c:pt idx="363">
                    <c:v>0.57735026918962573</c:v>
                  </c:pt>
                  <c:pt idx="364">
                    <c:v>0.57735026918962573</c:v>
                  </c:pt>
                  <c:pt idx="365">
                    <c:v>0</c:v>
                  </c:pt>
                  <c:pt idx="366">
                    <c:v>1.4142135623730951</c:v>
                  </c:pt>
                  <c:pt idx="367">
                    <c:v>1</c:v>
                  </c:pt>
                  <c:pt idx="368">
                    <c:v>3.1622776601683795</c:v>
                  </c:pt>
                  <c:pt idx="369">
                    <c:v>0</c:v>
                  </c:pt>
                  <c:pt idx="370">
                    <c:v>0.5</c:v>
                  </c:pt>
                  <c:pt idx="371">
                    <c:v>2.6299556396765835</c:v>
                  </c:pt>
                  <c:pt idx="372">
                    <c:v>15.779733838059499</c:v>
                  </c:pt>
                  <c:pt idx="373">
                    <c:v>0.57735026918962573</c:v>
                  </c:pt>
                  <c:pt idx="374">
                    <c:v>0.5</c:v>
                  </c:pt>
                  <c:pt idx="375">
                    <c:v>0.5</c:v>
                  </c:pt>
                  <c:pt idx="376">
                    <c:v>0.5</c:v>
                  </c:pt>
                  <c:pt idx="377">
                    <c:v>0.57735026918962573</c:v>
                  </c:pt>
                  <c:pt idx="378">
                    <c:v>0.57735026918962573</c:v>
                  </c:pt>
                  <c:pt idx="379">
                    <c:v>1.5</c:v>
                  </c:pt>
                  <c:pt idx="380">
                    <c:v>0.5</c:v>
                  </c:pt>
                  <c:pt idx="381">
                    <c:v>0.5</c:v>
                  </c:pt>
                  <c:pt idx="382">
                    <c:v>0.5</c:v>
                  </c:pt>
                  <c:pt idx="383">
                    <c:v>0.9574271077563381</c:v>
                  </c:pt>
                  <c:pt idx="384">
                    <c:v>1.8929694486000912</c:v>
                  </c:pt>
                  <c:pt idx="385">
                    <c:v>1.2909944487358056</c:v>
                  </c:pt>
                  <c:pt idx="386">
                    <c:v>1.2583057392117916</c:v>
                  </c:pt>
                  <c:pt idx="387">
                    <c:v>0.9574271077563381</c:v>
                  </c:pt>
                  <c:pt idx="388">
                    <c:v>46.514334708058904</c:v>
                  </c:pt>
                  <c:pt idx="389">
                    <c:v>0.5</c:v>
                  </c:pt>
                  <c:pt idx="390">
                    <c:v>1.8929694486000912</c:v>
                  </c:pt>
                  <c:pt idx="391">
                    <c:v>0.5</c:v>
                  </c:pt>
                  <c:pt idx="392">
                    <c:v>0.5</c:v>
                  </c:pt>
                  <c:pt idx="393">
                    <c:v>0.81649658092772603</c:v>
                  </c:pt>
                  <c:pt idx="394">
                    <c:v>0.81649658092772603</c:v>
                  </c:pt>
                  <c:pt idx="395">
                    <c:v>1.8929694486000912</c:v>
                  </c:pt>
                  <c:pt idx="396">
                    <c:v>5.9721576223896387</c:v>
                  </c:pt>
                  <c:pt idx="397">
                    <c:v>1.2583057392117916</c:v>
                  </c:pt>
                  <c:pt idx="398">
                    <c:v>1.2583057392117916</c:v>
                  </c:pt>
                  <c:pt idx="399">
                    <c:v>0.57735026918962573</c:v>
                  </c:pt>
                  <c:pt idx="400">
                    <c:v>0.5</c:v>
                  </c:pt>
                  <c:pt idx="401">
                    <c:v>1</c:v>
                  </c:pt>
                  <c:pt idx="402">
                    <c:v>0.57735026918962573</c:v>
                  </c:pt>
                  <c:pt idx="403">
                    <c:v>4.2426406871192848</c:v>
                  </c:pt>
                  <c:pt idx="404">
                    <c:v>1.2583057392117916</c:v>
                  </c:pt>
                  <c:pt idx="405">
                    <c:v>0.57735026918962573</c:v>
                  </c:pt>
                  <c:pt idx="406">
                    <c:v>0.81649658092772603</c:v>
                  </c:pt>
                  <c:pt idx="407">
                    <c:v>0.5</c:v>
                  </c:pt>
                  <c:pt idx="408">
                    <c:v>2.0816659994661326</c:v>
                  </c:pt>
                  <c:pt idx="409">
                    <c:v>1.8257418583505538</c:v>
                  </c:pt>
                  <c:pt idx="410">
                    <c:v>1.4142135623730951</c:v>
                  </c:pt>
                  <c:pt idx="411">
                    <c:v>0.57735026918962573</c:v>
                  </c:pt>
                  <c:pt idx="412">
                    <c:v>4.358898943540674</c:v>
                  </c:pt>
                  <c:pt idx="413">
                    <c:v>0.9574271077563381</c:v>
                  </c:pt>
                  <c:pt idx="414">
                    <c:v>1</c:v>
                  </c:pt>
                  <c:pt idx="415">
                    <c:v>0.5</c:v>
                  </c:pt>
                  <c:pt idx="416">
                    <c:v>0.81649658092772603</c:v>
                  </c:pt>
                  <c:pt idx="417">
                    <c:v>0.57735026918962573</c:v>
                  </c:pt>
                  <c:pt idx="418">
                    <c:v>42.200908363051461</c:v>
                  </c:pt>
                  <c:pt idx="419">
                    <c:v>0.9574271077563381</c:v>
                  </c:pt>
                  <c:pt idx="420">
                    <c:v>2.0816659994661326</c:v>
                  </c:pt>
                  <c:pt idx="421">
                    <c:v>1.1547005383792515</c:v>
                  </c:pt>
                  <c:pt idx="422">
                    <c:v>1.8929694486000912</c:v>
                  </c:pt>
                  <c:pt idx="423">
                    <c:v>0</c:v>
                  </c:pt>
                  <c:pt idx="424">
                    <c:v>0.5</c:v>
                  </c:pt>
                  <c:pt idx="425">
                    <c:v>0.57735026918962573</c:v>
                  </c:pt>
                  <c:pt idx="426">
                    <c:v>0.5</c:v>
                  </c:pt>
                  <c:pt idx="427">
                    <c:v>0.5</c:v>
                  </c:pt>
                  <c:pt idx="428">
                    <c:v>0.9574271077563381</c:v>
                  </c:pt>
                  <c:pt idx="429">
                    <c:v>0.57735026918962573</c:v>
                  </c:pt>
                  <c:pt idx="430">
                    <c:v>1.1547005383792515</c:v>
                  </c:pt>
                  <c:pt idx="431">
                    <c:v>1.5</c:v>
                  </c:pt>
                  <c:pt idx="432">
                    <c:v>1.8257418583505538</c:v>
                  </c:pt>
                  <c:pt idx="433">
                    <c:v>1.7320508075688772</c:v>
                  </c:pt>
                  <c:pt idx="434">
                    <c:v>1.1547005383792515</c:v>
                  </c:pt>
                  <c:pt idx="435">
                    <c:v>0.81649658092772603</c:v>
                  </c:pt>
                  <c:pt idx="436">
                    <c:v>1.2583057392117916</c:v>
                  </c:pt>
                  <c:pt idx="437">
                    <c:v>70.329581258528762</c:v>
                  </c:pt>
                  <c:pt idx="438">
                    <c:v>1.5</c:v>
                  </c:pt>
                  <c:pt idx="439">
                    <c:v>1.4142135623730951</c:v>
                  </c:pt>
                  <c:pt idx="440">
                    <c:v>2.3804761428476167</c:v>
                  </c:pt>
                  <c:pt idx="441">
                    <c:v>1.1547005383792515</c:v>
                  </c:pt>
                  <c:pt idx="442">
                    <c:v>1</c:v>
                  </c:pt>
                  <c:pt idx="443">
                    <c:v>0.9574271077563381</c:v>
                  </c:pt>
                  <c:pt idx="444">
                    <c:v>1.2583057392117916</c:v>
                  </c:pt>
                  <c:pt idx="445">
                    <c:v>2.4494897427831779</c:v>
                  </c:pt>
                  <c:pt idx="446">
                    <c:v>0.9574271077563381</c:v>
                  </c:pt>
                  <c:pt idx="447">
                    <c:v>0.5</c:v>
                  </c:pt>
                  <c:pt idx="448">
                    <c:v>0.57735026918962573</c:v>
                  </c:pt>
                  <c:pt idx="449">
                    <c:v>0.81649658092772603</c:v>
                  </c:pt>
                  <c:pt idx="450">
                    <c:v>0.57735026918962573</c:v>
                  </c:pt>
                  <c:pt idx="451">
                    <c:v>0.5</c:v>
                  </c:pt>
                  <c:pt idx="452">
                    <c:v>0.5</c:v>
                  </c:pt>
                  <c:pt idx="453">
                    <c:v>0.5</c:v>
                  </c:pt>
                  <c:pt idx="454">
                    <c:v>0.5</c:v>
                  </c:pt>
                  <c:pt idx="455">
                    <c:v>0.5</c:v>
                  </c:pt>
                  <c:pt idx="456">
                    <c:v>0.81649658092772603</c:v>
                  </c:pt>
                  <c:pt idx="457">
                    <c:v>0.57735026918962573</c:v>
                  </c:pt>
                  <c:pt idx="458">
                    <c:v>0.5</c:v>
                  </c:pt>
                  <c:pt idx="459">
                    <c:v>0.57735026918962573</c:v>
                  </c:pt>
                  <c:pt idx="460">
                    <c:v>1.2909944487358056</c:v>
                  </c:pt>
                  <c:pt idx="461">
                    <c:v>0.5</c:v>
                  </c:pt>
                  <c:pt idx="462">
                    <c:v>2.6299556396765835</c:v>
                  </c:pt>
                  <c:pt idx="463">
                    <c:v>0.9574271077563381</c:v>
                  </c:pt>
                  <c:pt idx="464">
                    <c:v>1</c:v>
                  </c:pt>
                  <c:pt idx="465">
                    <c:v>0.81649658092772603</c:v>
                  </c:pt>
                  <c:pt idx="466">
                    <c:v>0.57735026918962573</c:v>
                  </c:pt>
                  <c:pt idx="467">
                    <c:v>0.5</c:v>
                  </c:pt>
                  <c:pt idx="468">
                    <c:v>0.81649658092772603</c:v>
                  </c:pt>
                  <c:pt idx="469">
                    <c:v>5.5976185412488881</c:v>
                  </c:pt>
                  <c:pt idx="470">
                    <c:v>0.57735026918962573</c:v>
                  </c:pt>
                  <c:pt idx="471">
                    <c:v>1.7320508075688772</c:v>
                  </c:pt>
                  <c:pt idx="472">
                    <c:v>0.5</c:v>
                  </c:pt>
                  <c:pt idx="473">
                    <c:v>0.9574271077563381</c:v>
                  </c:pt>
                  <c:pt idx="474">
                    <c:v>0.5</c:v>
                  </c:pt>
                  <c:pt idx="475">
                    <c:v>0</c:v>
                  </c:pt>
                  <c:pt idx="476">
                    <c:v>7.3936910042729442</c:v>
                  </c:pt>
                  <c:pt idx="477">
                    <c:v>0.9574271077563381</c:v>
                  </c:pt>
                  <c:pt idx="478">
                    <c:v>1.4142135623730951</c:v>
                  </c:pt>
                  <c:pt idx="479">
                    <c:v>0.81649658092772603</c:v>
                  </c:pt>
                  <c:pt idx="480">
                    <c:v>0.81649658092772603</c:v>
                  </c:pt>
                  <c:pt idx="481">
                    <c:v>1.5</c:v>
                  </c:pt>
                  <c:pt idx="482">
                    <c:v>0.5</c:v>
                  </c:pt>
                  <c:pt idx="483">
                    <c:v>1.4142135623730951</c:v>
                  </c:pt>
                  <c:pt idx="484">
                    <c:v>8.3815273071201055</c:v>
                  </c:pt>
                  <c:pt idx="485">
                    <c:v>1.1547005383792515</c:v>
                  </c:pt>
                  <c:pt idx="486">
                    <c:v>1.5</c:v>
                  </c:pt>
                  <c:pt idx="487">
                    <c:v>0.9574271077563381</c:v>
                  </c:pt>
                  <c:pt idx="488">
                    <c:v>0.5</c:v>
                  </c:pt>
                  <c:pt idx="489">
                    <c:v>0.9574271077563381</c:v>
                  </c:pt>
                  <c:pt idx="490">
                    <c:v>1.5</c:v>
                  </c:pt>
                  <c:pt idx="491">
                    <c:v>1.9148542155126762</c:v>
                  </c:pt>
                  <c:pt idx="492">
                    <c:v>1.707825127659933</c:v>
                  </c:pt>
                  <c:pt idx="493">
                    <c:v>1.5</c:v>
                  </c:pt>
                  <c:pt idx="494">
                    <c:v>0.57735026918962573</c:v>
                  </c:pt>
                  <c:pt idx="495">
                    <c:v>0.57735026918962573</c:v>
                  </c:pt>
                  <c:pt idx="496">
                    <c:v>1.2909944487358056</c:v>
                  </c:pt>
                  <c:pt idx="497">
                    <c:v>4.7609522856952333</c:v>
                  </c:pt>
                  <c:pt idx="498">
                    <c:v>0.9574271077563381</c:v>
                  </c:pt>
                  <c:pt idx="499">
                    <c:v>0.57735026918962573</c:v>
                  </c:pt>
                  <c:pt idx="500">
                    <c:v>0.57735026918962573</c:v>
                  </c:pt>
                  <c:pt idx="501">
                    <c:v>0.5</c:v>
                  </c:pt>
                  <c:pt idx="502">
                    <c:v>2.1602468994692869</c:v>
                  </c:pt>
                  <c:pt idx="503">
                    <c:v>1</c:v>
                  </c:pt>
                  <c:pt idx="504">
                    <c:v>1</c:v>
                  </c:pt>
                  <c:pt idx="505">
                    <c:v>0.5</c:v>
                  </c:pt>
                  <c:pt idx="506">
                    <c:v>0.5</c:v>
                  </c:pt>
                  <c:pt idx="507">
                    <c:v>16.660832312142553</c:v>
                  </c:pt>
                  <c:pt idx="508">
                    <c:v>1.2583057392117916</c:v>
                  </c:pt>
                  <c:pt idx="509">
                    <c:v>0.9574271077563381</c:v>
                  </c:pt>
                  <c:pt idx="510">
                    <c:v>0.5</c:v>
                  </c:pt>
                  <c:pt idx="511">
                    <c:v>0.9574271077563381</c:v>
                  </c:pt>
                  <c:pt idx="512">
                    <c:v>0.5</c:v>
                  </c:pt>
                  <c:pt idx="513">
                    <c:v>0.5</c:v>
                  </c:pt>
                  <c:pt idx="514">
                    <c:v>0.9574271077563381</c:v>
                  </c:pt>
                  <c:pt idx="515">
                    <c:v>0.5</c:v>
                  </c:pt>
                  <c:pt idx="516">
                    <c:v>0.57735026918962573</c:v>
                  </c:pt>
                  <c:pt idx="517">
                    <c:v>0.5</c:v>
                  </c:pt>
                  <c:pt idx="518">
                    <c:v>0.81649658092772603</c:v>
                  </c:pt>
                  <c:pt idx="519">
                    <c:v>0.5</c:v>
                  </c:pt>
                  <c:pt idx="520">
                    <c:v>0.5</c:v>
                  </c:pt>
                  <c:pt idx="521">
                    <c:v>0.5</c:v>
                  </c:pt>
                  <c:pt idx="522">
                    <c:v>0.57735026918962573</c:v>
                  </c:pt>
                  <c:pt idx="523">
                    <c:v>0.9574271077563381</c:v>
                  </c:pt>
                  <c:pt idx="524">
                    <c:v>1.2909944487358056</c:v>
                  </c:pt>
                  <c:pt idx="525">
                    <c:v>13.711309200802088</c:v>
                  </c:pt>
                  <c:pt idx="526">
                    <c:v>1.707825127659933</c:v>
                  </c:pt>
                  <c:pt idx="527">
                    <c:v>0.5</c:v>
                  </c:pt>
                  <c:pt idx="528">
                    <c:v>0.57735026918962573</c:v>
                  </c:pt>
                  <c:pt idx="529">
                    <c:v>4.7958315233127191</c:v>
                  </c:pt>
                  <c:pt idx="530">
                    <c:v>4.9916597106239795</c:v>
                  </c:pt>
                  <c:pt idx="531">
                    <c:v>0.9574271077563381</c:v>
                  </c:pt>
                  <c:pt idx="532">
                    <c:v>0.57735026918962573</c:v>
                  </c:pt>
                  <c:pt idx="533">
                    <c:v>0.5</c:v>
                  </c:pt>
                  <c:pt idx="534">
                    <c:v>2</c:v>
                  </c:pt>
                  <c:pt idx="535">
                    <c:v>1.2909944487358056</c:v>
                  </c:pt>
                  <c:pt idx="536">
                    <c:v>2.5</c:v>
                  </c:pt>
                  <c:pt idx="537">
                    <c:v>0.81649658092772603</c:v>
                  </c:pt>
                  <c:pt idx="538">
                    <c:v>0.57735026918962573</c:v>
                  </c:pt>
                  <c:pt idx="539">
                    <c:v>0.9574271077563381</c:v>
                  </c:pt>
                  <c:pt idx="540">
                    <c:v>1</c:v>
                  </c:pt>
                  <c:pt idx="541">
                    <c:v>1.2909944487358056</c:v>
                  </c:pt>
                  <c:pt idx="542">
                    <c:v>0.81649658092772603</c:v>
                  </c:pt>
                  <c:pt idx="543">
                    <c:v>0</c:v>
                  </c:pt>
                  <c:pt idx="544">
                    <c:v>1.707825127659933</c:v>
                  </c:pt>
                  <c:pt idx="545">
                    <c:v>2.8867513459481291</c:v>
                  </c:pt>
                  <c:pt idx="546">
                    <c:v>0.9574271077563381</c:v>
                  </c:pt>
                  <c:pt idx="547">
                    <c:v>0</c:v>
                  </c:pt>
                  <c:pt idx="548">
                    <c:v>0.81649658092772603</c:v>
                  </c:pt>
                  <c:pt idx="549">
                    <c:v>0.9574271077563381</c:v>
                  </c:pt>
                  <c:pt idx="550">
                    <c:v>1.2909944487358056</c:v>
                  </c:pt>
                  <c:pt idx="551">
                    <c:v>3.1622776601683795</c:v>
                  </c:pt>
                  <c:pt idx="552">
                    <c:v>0</c:v>
                  </c:pt>
                  <c:pt idx="553">
                    <c:v>1.5</c:v>
                  </c:pt>
                  <c:pt idx="554">
                    <c:v>0.81649658092772603</c:v>
                  </c:pt>
                  <c:pt idx="555">
                    <c:v>0.5</c:v>
                  </c:pt>
                  <c:pt idx="556">
                    <c:v>1</c:v>
                  </c:pt>
                  <c:pt idx="557">
                    <c:v>5.0579969684978394</c:v>
                  </c:pt>
                  <c:pt idx="558">
                    <c:v>0.9574271077563381</c:v>
                  </c:pt>
                  <c:pt idx="559">
                    <c:v>0.5</c:v>
                  </c:pt>
                  <c:pt idx="560">
                    <c:v>1.2583057392117916</c:v>
                  </c:pt>
                  <c:pt idx="561">
                    <c:v>0</c:v>
                  </c:pt>
                  <c:pt idx="562">
                    <c:v>2.6299556396765835</c:v>
                  </c:pt>
                  <c:pt idx="563">
                    <c:v>2.3629078131263039</c:v>
                  </c:pt>
                  <c:pt idx="564">
                    <c:v>0.5</c:v>
                  </c:pt>
                  <c:pt idx="565">
                    <c:v>17.8232058470598</c:v>
                  </c:pt>
                  <c:pt idx="566">
                    <c:v>0.57735026918962573</c:v>
                  </c:pt>
                  <c:pt idx="567">
                    <c:v>0.57735026918962573</c:v>
                  </c:pt>
                  <c:pt idx="568">
                    <c:v>0</c:v>
                  </c:pt>
                  <c:pt idx="569">
                    <c:v>8.981462390204987</c:v>
                  </c:pt>
                  <c:pt idx="570">
                    <c:v>0.9574271077563381</c:v>
                  </c:pt>
                  <c:pt idx="571">
                    <c:v>0.81649658092772603</c:v>
                  </c:pt>
                  <c:pt idx="572">
                    <c:v>0.57735026918962573</c:v>
                  </c:pt>
                  <c:pt idx="573">
                    <c:v>0.57735026918962573</c:v>
                  </c:pt>
                  <c:pt idx="574">
                    <c:v>0.9574271077563381</c:v>
                  </c:pt>
                  <c:pt idx="575">
                    <c:v>1.1547005383792515</c:v>
                  </c:pt>
                  <c:pt idx="576">
                    <c:v>0.57735026918962573</c:v>
                  </c:pt>
                  <c:pt idx="577">
                    <c:v>0.5</c:v>
                  </c:pt>
                  <c:pt idx="578">
                    <c:v>0</c:v>
                  </c:pt>
                  <c:pt idx="579">
                    <c:v>0.5</c:v>
                  </c:pt>
                  <c:pt idx="580">
                    <c:v>5.259911279353167</c:v>
                  </c:pt>
                  <c:pt idx="581">
                    <c:v>1.2583057392117916</c:v>
                  </c:pt>
                  <c:pt idx="582">
                    <c:v>0.9574271077563381</c:v>
                  </c:pt>
                  <c:pt idx="583">
                    <c:v>8.6168439698070429</c:v>
                  </c:pt>
                  <c:pt idx="584">
                    <c:v>1.5</c:v>
                  </c:pt>
                </c:numCache>
              </c:numRef>
            </c:plus>
            <c:minus>
              <c:numRef>
                <c:f>'10127D221A 200ug'!$D$2:$D$586</c:f>
                <c:numCache>
                  <c:formatCode>General</c:formatCode>
                  <c:ptCount val="585"/>
                  <c:pt idx="0">
                    <c:v>0.9574271077563381</c:v>
                  </c:pt>
                  <c:pt idx="1">
                    <c:v>1.7320508075688772</c:v>
                  </c:pt>
                  <c:pt idx="2">
                    <c:v>1.707825127659933</c:v>
                  </c:pt>
                  <c:pt idx="3">
                    <c:v>2.3629078131263039</c:v>
                  </c:pt>
                  <c:pt idx="4">
                    <c:v>2.6299556396765835</c:v>
                  </c:pt>
                  <c:pt idx="5">
                    <c:v>2.2173557826083452</c:v>
                  </c:pt>
                  <c:pt idx="6">
                    <c:v>2.6299556396765835</c:v>
                  </c:pt>
                  <c:pt idx="7">
                    <c:v>2.2173557826083452</c:v>
                  </c:pt>
                  <c:pt idx="8">
                    <c:v>1.2583057392117916</c:v>
                  </c:pt>
                  <c:pt idx="9">
                    <c:v>0.57735026918962573</c:v>
                  </c:pt>
                  <c:pt idx="10">
                    <c:v>1.2909944487358056</c:v>
                  </c:pt>
                  <c:pt idx="11">
                    <c:v>2.5819888974716112</c:v>
                  </c:pt>
                  <c:pt idx="12">
                    <c:v>1.4142135623730951</c:v>
                  </c:pt>
                  <c:pt idx="13">
                    <c:v>0.9574271077563381</c:v>
                  </c:pt>
                  <c:pt idx="14">
                    <c:v>0.9574271077563381</c:v>
                  </c:pt>
                  <c:pt idx="15">
                    <c:v>1.5</c:v>
                  </c:pt>
                  <c:pt idx="16">
                    <c:v>0.9574271077563381</c:v>
                  </c:pt>
                  <c:pt idx="17">
                    <c:v>0.57735026918962573</c:v>
                  </c:pt>
                  <c:pt idx="18">
                    <c:v>0.5</c:v>
                  </c:pt>
                  <c:pt idx="19">
                    <c:v>0.9574271077563381</c:v>
                  </c:pt>
                  <c:pt idx="20">
                    <c:v>1.2583057392117916</c:v>
                  </c:pt>
                  <c:pt idx="21">
                    <c:v>2.0615528128088303</c:v>
                  </c:pt>
                  <c:pt idx="22">
                    <c:v>2.9439202887759488</c:v>
                  </c:pt>
                  <c:pt idx="23">
                    <c:v>5.715476066494082</c:v>
                  </c:pt>
                  <c:pt idx="24">
                    <c:v>0.5</c:v>
                  </c:pt>
                  <c:pt idx="25">
                    <c:v>0.5</c:v>
                  </c:pt>
                  <c:pt idx="26">
                    <c:v>0.5</c:v>
                  </c:pt>
                  <c:pt idx="27">
                    <c:v>2.6457513110645907</c:v>
                  </c:pt>
                  <c:pt idx="28">
                    <c:v>1.5</c:v>
                  </c:pt>
                  <c:pt idx="29">
                    <c:v>1.4142135623730951</c:v>
                  </c:pt>
                  <c:pt idx="30">
                    <c:v>12.120918557051139</c:v>
                  </c:pt>
                  <c:pt idx="31">
                    <c:v>1.5</c:v>
                  </c:pt>
                  <c:pt idx="32">
                    <c:v>8.0156097709406993</c:v>
                  </c:pt>
                  <c:pt idx="33">
                    <c:v>2.3804761428476167</c:v>
                  </c:pt>
                  <c:pt idx="34">
                    <c:v>1.707825127659933</c:v>
                  </c:pt>
                  <c:pt idx="35">
                    <c:v>0.5</c:v>
                  </c:pt>
                  <c:pt idx="36">
                    <c:v>0.81649658092772603</c:v>
                  </c:pt>
                  <c:pt idx="37">
                    <c:v>0.9574271077563381</c:v>
                  </c:pt>
                  <c:pt idx="38">
                    <c:v>0.9574271077563381</c:v>
                  </c:pt>
                  <c:pt idx="39">
                    <c:v>0.9574271077563381</c:v>
                  </c:pt>
                  <c:pt idx="40">
                    <c:v>0.9574271077563381</c:v>
                  </c:pt>
                  <c:pt idx="41">
                    <c:v>0.9574271077563381</c:v>
                  </c:pt>
                  <c:pt idx="42">
                    <c:v>2.753785273643051</c:v>
                  </c:pt>
                  <c:pt idx="43">
                    <c:v>0.81649658092772603</c:v>
                  </c:pt>
                  <c:pt idx="44">
                    <c:v>1.2909944487358056</c:v>
                  </c:pt>
                  <c:pt idx="45">
                    <c:v>1.2583057392117916</c:v>
                  </c:pt>
                  <c:pt idx="46">
                    <c:v>1</c:v>
                  </c:pt>
                  <c:pt idx="47">
                    <c:v>1</c:v>
                  </c:pt>
                  <c:pt idx="48">
                    <c:v>2.4494897427831779</c:v>
                  </c:pt>
                  <c:pt idx="49">
                    <c:v>0.5</c:v>
                  </c:pt>
                  <c:pt idx="50">
                    <c:v>0</c:v>
                  </c:pt>
                  <c:pt idx="51">
                    <c:v>0.5</c:v>
                  </c:pt>
                  <c:pt idx="52">
                    <c:v>1</c:v>
                  </c:pt>
                  <c:pt idx="53">
                    <c:v>1</c:v>
                  </c:pt>
                  <c:pt idx="54">
                    <c:v>1.2909944487358056</c:v>
                  </c:pt>
                  <c:pt idx="55">
                    <c:v>2.2173557826083452</c:v>
                  </c:pt>
                  <c:pt idx="56">
                    <c:v>0.5</c:v>
                  </c:pt>
                  <c:pt idx="57">
                    <c:v>1.707825127659933</c:v>
                  </c:pt>
                  <c:pt idx="58">
                    <c:v>0.57735026918962573</c:v>
                  </c:pt>
                  <c:pt idx="59">
                    <c:v>2.2173557826083452</c:v>
                  </c:pt>
                  <c:pt idx="60">
                    <c:v>0.57735026918962573</c:v>
                  </c:pt>
                  <c:pt idx="61">
                    <c:v>0.57735026918962573</c:v>
                  </c:pt>
                  <c:pt idx="62">
                    <c:v>0.81649658092772603</c:v>
                  </c:pt>
                  <c:pt idx="63">
                    <c:v>0.9574271077563381</c:v>
                  </c:pt>
                  <c:pt idx="64">
                    <c:v>0.5</c:v>
                  </c:pt>
                  <c:pt idx="65">
                    <c:v>1.707825127659933</c:v>
                  </c:pt>
                  <c:pt idx="66">
                    <c:v>0.81649658092772603</c:v>
                  </c:pt>
                  <c:pt idx="67">
                    <c:v>0.5</c:v>
                  </c:pt>
                  <c:pt idx="68">
                    <c:v>2.2173557826083452</c:v>
                  </c:pt>
                  <c:pt idx="69">
                    <c:v>2.4494897427831779</c:v>
                  </c:pt>
                  <c:pt idx="70">
                    <c:v>1.5</c:v>
                  </c:pt>
                  <c:pt idx="71">
                    <c:v>13.889444433333777</c:v>
                  </c:pt>
                  <c:pt idx="72">
                    <c:v>0.57735026918962573</c:v>
                  </c:pt>
                  <c:pt idx="73">
                    <c:v>0.5</c:v>
                  </c:pt>
                  <c:pt idx="74">
                    <c:v>2.0615528128088303</c:v>
                  </c:pt>
                  <c:pt idx="75">
                    <c:v>1</c:v>
                  </c:pt>
                  <c:pt idx="76">
                    <c:v>0.5</c:v>
                  </c:pt>
                  <c:pt idx="77">
                    <c:v>1.1547005383792515</c:v>
                  </c:pt>
                  <c:pt idx="78">
                    <c:v>1.4142135623730951</c:v>
                  </c:pt>
                  <c:pt idx="79">
                    <c:v>0.57735026918962573</c:v>
                  </c:pt>
                  <c:pt idx="80">
                    <c:v>1.1547005383792515</c:v>
                  </c:pt>
                  <c:pt idx="81">
                    <c:v>1</c:v>
                  </c:pt>
                  <c:pt idx="82">
                    <c:v>1.5</c:v>
                  </c:pt>
                  <c:pt idx="83">
                    <c:v>0.81649658092772603</c:v>
                  </c:pt>
                  <c:pt idx="84">
                    <c:v>0.5</c:v>
                  </c:pt>
                  <c:pt idx="85">
                    <c:v>0.5</c:v>
                  </c:pt>
                  <c:pt idx="86">
                    <c:v>21.546461426415242</c:v>
                  </c:pt>
                  <c:pt idx="87">
                    <c:v>0.81649658092772603</c:v>
                  </c:pt>
                  <c:pt idx="88">
                    <c:v>0.5</c:v>
                  </c:pt>
                  <c:pt idx="89">
                    <c:v>1.6329931618554521</c:v>
                  </c:pt>
                  <c:pt idx="90">
                    <c:v>0</c:v>
                  </c:pt>
                  <c:pt idx="91">
                    <c:v>0.81649658092772603</c:v>
                  </c:pt>
                  <c:pt idx="92">
                    <c:v>0.5</c:v>
                  </c:pt>
                  <c:pt idx="93">
                    <c:v>0.57735026918962573</c:v>
                  </c:pt>
                  <c:pt idx="94">
                    <c:v>0.57735026918962573</c:v>
                  </c:pt>
                  <c:pt idx="95">
                    <c:v>0.9574271077563381</c:v>
                  </c:pt>
                  <c:pt idx="96">
                    <c:v>1.4142135623730951</c:v>
                  </c:pt>
                  <c:pt idx="97">
                    <c:v>0.57735026918962573</c:v>
                  </c:pt>
                  <c:pt idx="98">
                    <c:v>0.9574271077563381</c:v>
                  </c:pt>
                  <c:pt idx="99">
                    <c:v>1.5</c:v>
                  </c:pt>
                  <c:pt idx="100">
                    <c:v>0.81649658092772603</c:v>
                  </c:pt>
                  <c:pt idx="101">
                    <c:v>0.9574271077563381</c:v>
                  </c:pt>
                  <c:pt idx="102">
                    <c:v>0.57735026918962573</c:v>
                  </c:pt>
                  <c:pt idx="103">
                    <c:v>1.7320508075688772</c:v>
                  </c:pt>
                  <c:pt idx="104">
                    <c:v>1.707825127659933</c:v>
                  </c:pt>
                  <c:pt idx="105">
                    <c:v>0.57735026918962573</c:v>
                  </c:pt>
                  <c:pt idx="106">
                    <c:v>0.5</c:v>
                  </c:pt>
                  <c:pt idx="107">
                    <c:v>1.2583057392117916</c:v>
                  </c:pt>
                  <c:pt idx="108">
                    <c:v>0.9574271077563381</c:v>
                  </c:pt>
                  <c:pt idx="109">
                    <c:v>1.2909944487358056</c:v>
                  </c:pt>
                  <c:pt idx="110">
                    <c:v>0.5</c:v>
                  </c:pt>
                  <c:pt idx="111">
                    <c:v>1.2583057392117916</c:v>
                  </c:pt>
                  <c:pt idx="112">
                    <c:v>1.5</c:v>
                  </c:pt>
                  <c:pt idx="113">
                    <c:v>1.6329931618554521</c:v>
                  </c:pt>
                  <c:pt idx="114">
                    <c:v>0.9574271077563381</c:v>
                  </c:pt>
                  <c:pt idx="115">
                    <c:v>0.81649658092772603</c:v>
                  </c:pt>
                  <c:pt idx="116">
                    <c:v>0.9574271077563381</c:v>
                  </c:pt>
                  <c:pt idx="117">
                    <c:v>1.8929694486000912</c:v>
                  </c:pt>
                  <c:pt idx="118">
                    <c:v>0.9574271077563381</c:v>
                  </c:pt>
                  <c:pt idx="119">
                    <c:v>0.5</c:v>
                  </c:pt>
                  <c:pt idx="120">
                    <c:v>0.9574271077563381</c:v>
                  </c:pt>
                  <c:pt idx="121">
                    <c:v>1.5</c:v>
                  </c:pt>
                  <c:pt idx="122">
                    <c:v>4.0311288741492746</c:v>
                  </c:pt>
                  <c:pt idx="123">
                    <c:v>0.5</c:v>
                  </c:pt>
                  <c:pt idx="124">
                    <c:v>1.8929694486000912</c:v>
                  </c:pt>
                  <c:pt idx="125">
                    <c:v>1.1547005383792515</c:v>
                  </c:pt>
                  <c:pt idx="126">
                    <c:v>0.9574271077563381</c:v>
                  </c:pt>
                  <c:pt idx="127">
                    <c:v>1</c:v>
                  </c:pt>
                  <c:pt idx="128">
                    <c:v>0.9574271077563381</c:v>
                  </c:pt>
                  <c:pt idx="129">
                    <c:v>0.81649658092772603</c:v>
                  </c:pt>
                  <c:pt idx="130">
                    <c:v>1.5</c:v>
                  </c:pt>
                  <c:pt idx="131">
                    <c:v>0.57735026918962573</c:v>
                  </c:pt>
                  <c:pt idx="132">
                    <c:v>0.57735026918962573</c:v>
                  </c:pt>
                  <c:pt idx="133">
                    <c:v>0.57735026918962573</c:v>
                  </c:pt>
                  <c:pt idx="134">
                    <c:v>1.2583057392117916</c:v>
                  </c:pt>
                  <c:pt idx="135">
                    <c:v>0.57735026918962573</c:v>
                  </c:pt>
                  <c:pt idx="136">
                    <c:v>0.5</c:v>
                  </c:pt>
                  <c:pt idx="137">
                    <c:v>1.2909944487358056</c:v>
                  </c:pt>
                  <c:pt idx="138">
                    <c:v>0.9574271077563381</c:v>
                  </c:pt>
                  <c:pt idx="139">
                    <c:v>0.5</c:v>
                  </c:pt>
                  <c:pt idx="140">
                    <c:v>2.2173557826083452</c:v>
                  </c:pt>
                  <c:pt idx="141">
                    <c:v>0.5</c:v>
                  </c:pt>
                  <c:pt idx="142">
                    <c:v>0.5</c:v>
                  </c:pt>
                  <c:pt idx="143">
                    <c:v>0.81649658092772603</c:v>
                  </c:pt>
                  <c:pt idx="144">
                    <c:v>0.9574271077563381</c:v>
                  </c:pt>
                  <c:pt idx="145">
                    <c:v>1.707825127659933</c:v>
                  </c:pt>
                  <c:pt idx="146">
                    <c:v>0.57735026918962573</c:v>
                  </c:pt>
                  <c:pt idx="147">
                    <c:v>0</c:v>
                  </c:pt>
                  <c:pt idx="148">
                    <c:v>0.81649658092772603</c:v>
                  </c:pt>
                  <c:pt idx="149">
                    <c:v>0.57735026918962573</c:v>
                  </c:pt>
                  <c:pt idx="150">
                    <c:v>0.57735026918962573</c:v>
                  </c:pt>
                  <c:pt idx="151">
                    <c:v>0.57735026918962573</c:v>
                  </c:pt>
                  <c:pt idx="152">
                    <c:v>2.753785273643051</c:v>
                  </c:pt>
                  <c:pt idx="153">
                    <c:v>3.0956959368344519</c:v>
                  </c:pt>
                  <c:pt idx="154">
                    <c:v>1.2583057392117916</c:v>
                  </c:pt>
                  <c:pt idx="155">
                    <c:v>1.2909944487358056</c:v>
                  </c:pt>
                  <c:pt idx="156">
                    <c:v>0.5</c:v>
                  </c:pt>
                  <c:pt idx="157">
                    <c:v>0.5</c:v>
                  </c:pt>
                  <c:pt idx="158">
                    <c:v>1.2909944487358056</c:v>
                  </c:pt>
                  <c:pt idx="159">
                    <c:v>0</c:v>
                  </c:pt>
                  <c:pt idx="160">
                    <c:v>0.5</c:v>
                  </c:pt>
                  <c:pt idx="161">
                    <c:v>0</c:v>
                  </c:pt>
                  <c:pt idx="162">
                    <c:v>1.4142135623730951</c:v>
                  </c:pt>
                  <c:pt idx="163">
                    <c:v>0</c:v>
                  </c:pt>
                  <c:pt idx="164">
                    <c:v>0.5</c:v>
                  </c:pt>
                  <c:pt idx="165">
                    <c:v>0</c:v>
                  </c:pt>
                  <c:pt idx="166">
                    <c:v>4</c:v>
                  </c:pt>
                  <c:pt idx="167">
                    <c:v>0.5</c:v>
                  </c:pt>
                  <c:pt idx="168">
                    <c:v>1</c:v>
                  </c:pt>
                  <c:pt idx="169">
                    <c:v>0.81649658092772603</c:v>
                  </c:pt>
                  <c:pt idx="170">
                    <c:v>1.7320508075688772</c:v>
                  </c:pt>
                  <c:pt idx="171">
                    <c:v>1.7320508075688772</c:v>
                  </c:pt>
                  <c:pt idx="172">
                    <c:v>0.9574271077563381</c:v>
                  </c:pt>
                  <c:pt idx="173">
                    <c:v>1</c:v>
                  </c:pt>
                  <c:pt idx="174">
                    <c:v>0.81649658092772603</c:v>
                  </c:pt>
                  <c:pt idx="175">
                    <c:v>0.5</c:v>
                  </c:pt>
                  <c:pt idx="176">
                    <c:v>0.57735026918962573</c:v>
                  </c:pt>
                  <c:pt idx="177">
                    <c:v>0.5</c:v>
                  </c:pt>
                  <c:pt idx="178">
                    <c:v>0.9574271077563381</c:v>
                  </c:pt>
                  <c:pt idx="179">
                    <c:v>0.9574271077563381</c:v>
                  </c:pt>
                  <c:pt idx="180">
                    <c:v>0</c:v>
                  </c:pt>
                  <c:pt idx="181">
                    <c:v>0.57735026918962573</c:v>
                  </c:pt>
                  <c:pt idx="182">
                    <c:v>0.5</c:v>
                  </c:pt>
                  <c:pt idx="183">
                    <c:v>1.1547005383792515</c:v>
                  </c:pt>
                  <c:pt idx="184">
                    <c:v>0.5</c:v>
                  </c:pt>
                  <c:pt idx="185">
                    <c:v>1.2583057392117916</c:v>
                  </c:pt>
                  <c:pt idx="186">
                    <c:v>6.757711644237764</c:v>
                  </c:pt>
                  <c:pt idx="187">
                    <c:v>1.4142135623730951</c:v>
                  </c:pt>
                  <c:pt idx="188">
                    <c:v>1.2583057392117916</c:v>
                  </c:pt>
                  <c:pt idx="189">
                    <c:v>2.3629078131263039</c:v>
                  </c:pt>
                  <c:pt idx="190">
                    <c:v>1.2909944487358056</c:v>
                  </c:pt>
                  <c:pt idx="191">
                    <c:v>0.9574271077563381</c:v>
                  </c:pt>
                  <c:pt idx="192">
                    <c:v>0.9574271077563381</c:v>
                  </c:pt>
                  <c:pt idx="193">
                    <c:v>3.0956959368344519</c:v>
                  </c:pt>
                  <c:pt idx="194">
                    <c:v>0.9574271077563381</c:v>
                  </c:pt>
                  <c:pt idx="195">
                    <c:v>0.5</c:v>
                  </c:pt>
                  <c:pt idx="196">
                    <c:v>1.6329931618554521</c:v>
                  </c:pt>
                  <c:pt idx="197">
                    <c:v>1.2909944487358056</c:v>
                  </c:pt>
                  <c:pt idx="198">
                    <c:v>1.9148542155126762</c:v>
                  </c:pt>
                  <c:pt idx="199">
                    <c:v>1.9148542155126762</c:v>
                  </c:pt>
                  <c:pt idx="200">
                    <c:v>0.9574271077563381</c:v>
                  </c:pt>
                  <c:pt idx="201">
                    <c:v>3.7749172176353749</c:v>
                  </c:pt>
                  <c:pt idx="202">
                    <c:v>2.0816659994661326</c:v>
                  </c:pt>
                  <c:pt idx="203">
                    <c:v>1.2583057392117916</c:v>
                  </c:pt>
                  <c:pt idx="204">
                    <c:v>1.4142135623730951</c:v>
                  </c:pt>
                  <c:pt idx="205">
                    <c:v>0</c:v>
                  </c:pt>
                  <c:pt idx="206">
                    <c:v>1.4142135623730951</c:v>
                  </c:pt>
                  <c:pt idx="207">
                    <c:v>1.2909944487358056</c:v>
                  </c:pt>
                  <c:pt idx="208">
                    <c:v>0.81649658092772603</c:v>
                  </c:pt>
                  <c:pt idx="209">
                    <c:v>0.81649658092772603</c:v>
                  </c:pt>
                  <c:pt idx="210">
                    <c:v>1.4142135623730951</c:v>
                  </c:pt>
                  <c:pt idx="211">
                    <c:v>0.5</c:v>
                  </c:pt>
                  <c:pt idx="212">
                    <c:v>0.5</c:v>
                  </c:pt>
                  <c:pt idx="213">
                    <c:v>0.5</c:v>
                  </c:pt>
                  <c:pt idx="214">
                    <c:v>0.9574271077563381</c:v>
                  </c:pt>
                  <c:pt idx="215">
                    <c:v>0.5</c:v>
                  </c:pt>
                  <c:pt idx="216">
                    <c:v>2.6299556396765835</c:v>
                  </c:pt>
                  <c:pt idx="217">
                    <c:v>0.9574271077563381</c:v>
                  </c:pt>
                  <c:pt idx="218">
                    <c:v>0.57735026918962573</c:v>
                  </c:pt>
                  <c:pt idx="219">
                    <c:v>0.5</c:v>
                  </c:pt>
                  <c:pt idx="220">
                    <c:v>1.4142135623730951</c:v>
                  </c:pt>
                  <c:pt idx="221">
                    <c:v>1</c:v>
                  </c:pt>
                  <c:pt idx="222">
                    <c:v>0.9574271077563381</c:v>
                  </c:pt>
                  <c:pt idx="223">
                    <c:v>1.8257418583505538</c:v>
                  </c:pt>
                  <c:pt idx="224">
                    <c:v>1.2909944487358056</c:v>
                  </c:pt>
                  <c:pt idx="225">
                    <c:v>0.5</c:v>
                  </c:pt>
                  <c:pt idx="226">
                    <c:v>0.5</c:v>
                  </c:pt>
                  <c:pt idx="227">
                    <c:v>0.5</c:v>
                  </c:pt>
                  <c:pt idx="228">
                    <c:v>1.2583057392117916</c:v>
                  </c:pt>
                  <c:pt idx="229">
                    <c:v>0.9574271077563381</c:v>
                  </c:pt>
                  <c:pt idx="230">
                    <c:v>0.5</c:v>
                  </c:pt>
                  <c:pt idx="231">
                    <c:v>0.81649658092772603</c:v>
                  </c:pt>
                  <c:pt idx="232">
                    <c:v>0.81649658092772603</c:v>
                  </c:pt>
                  <c:pt idx="233">
                    <c:v>0.81649658092772603</c:v>
                  </c:pt>
                  <c:pt idx="234">
                    <c:v>1.4142135623730951</c:v>
                  </c:pt>
                  <c:pt idx="235">
                    <c:v>0.9574271077563381</c:v>
                  </c:pt>
                  <c:pt idx="236">
                    <c:v>0.5</c:v>
                  </c:pt>
                  <c:pt idx="237">
                    <c:v>0.81649658092772603</c:v>
                  </c:pt>
                  <c:pt idx="238">
                    <c:v>1.5</c:v>
                  </c:pt>
                  <c:pt idx="239">
                    <c:v>0.57735026918962573</c:v>
                  </c:pt>
                  <c:pt idx="240">
                    <c:v>2.3804761428476167</c:v>
                  </c:pt>
                  <c:pt idx="241">
                    <c:v>1.707825127659933</c:v>
                  </c:pt>
                  <c:pt idx="242">
                    <c:v>1.707825127659933</c:v>
                  </c:pt>
                  <c:pt idx="243">
                    <c:v>0</c:v>
                  </c:pt>
                  <c:pt idx="244">
                    <c:v>0.9574271077563381</c:v>
                  </c:pt>
                  <c:pt idx="245">
                    <c:v>0.81649658092772603</c:v>
                  </c:pt>
                  <c:pt idx="246">
                    <c:v>0.5</c:v>
                  </c:pt>
                  <c:pt idx="247">
                    <c:v>0.9574271077563381</c:v>
                  </c:pt>
                  <c:pt idx="248">
                    <c:v>228.07162617622268</c:v>
                  </c:pt>
                  <c:pt idx="249">
                    <c:v>1.2909944487358056</c:v>
                  </c:pt>
                  <c:pt idx="250">
                    <c:v>1.707825127659933</c:v>
                  </c:pt>
                  <c:pt idx="251">
                    <c:v>11.870832602082579</c:v>
                  </c:pt>
                  <c:pt idx="252">
                    <c:v>34.200389861325654</c:v>
                  </c:pt>
                  <c:pt idx="253">
                    <c:v>1.2583057392117916</c:v>
                  </c:pt>
                  <c:pt idx="254">
                    <c:v>1</c:v>
                  </c:pt>
                  <c:pt idx="255">
                    <c:v>0.5</c:v>
                  </c:pt>
                  <c:pt idx="256">
                    <c:v>0.5</c:v>
                  </c:pt>
                  <c:pt idx="257">
                    <c:v>0.57735026918962573</c:v>
                  </c:pt>
                  <c:pt idx="258">
                    <c:v>0.5</c:v>
                  </c:pt>
                  <c:pt idx="259">
                    <c:v>1</c:v>
                  </c:pt>
                  <c:pt idx="260">
                    <c:v>10.801234497346433</c:v>
                  </c:pt>
                  <c:pt idx="261">
                    <c:v>0.5</c:v>
                  </c:pt>
                  <c:pt idx="262">
                    <c:v>0.81649658092772603</c:v>
                  </c:pt>
                  <c:pt idx="263">
                    <c:v>0.9574271077563381</c:v>
                  </c:pt>
                  <c:pt idx="264">
                    <c:v>0.81649658092772603</c:v>
                  </c:pt>
                  <c:pt idx="265">
                    <c:v>0.57735026918962573</c:v>
                  </c:pt>
                  <c:pt idx="266">
                    <c:v>0.5</c:v>
                  </c:pt>
                  <c:pt idx="267">
                    <c:v>0.81649658092772603</c:v>
                  </c:pt>
                  <c:pt idx="268">
                    <c:v>1</c:v>
                  </c:pt>
                  <c:pt idx="269">
                    <c:v>0.9574271077563381</c:v>
                  </c:pt>
                  <c:pt idx="270">
                    <c:v>0.5</c:v>
                  </c:pt>
                  <c:pt idx="271">
                    <c:v>0.9574271077563381</c:v>
                  </c:pt>
                  <c:pt idx="272">
                    <c:v>0.5</c:v>
                  </c:pt>
                  <c:pt idx="273">
                    <c:v>0.5</c:v>
                  </c:pt>
                  <c:pt idx="274">
                    <c:v>0.57735026918962573</c:v>
                  </c:pt>
                  <c:pt idx="275">
                    <c:v>0.5</c:v>
                  </c:pt>
                  <c:pt idx="276">
                    <c:v>1</c:v>
                  </c:pt>
                  <c:pt idx="277">
                    <c:v>4.7169905660283016</c:v>
                  </c:pt>
                  <c:pt idx="278">
                    <c:v>0.5</c:v>
                  </c:pt>
                  <c:pt idx="279">
                    <c:v>2.2173557826083452</c:v>
                  </c:pt>
                  <c:pt idx="280">
                    <c:v>0.5</c:v>
                  </c:pt>
                  <c:pt idx="281">
                    <c:v>0.57735026918962573</c:v>
                  </c:pt>
                  <c:pt idx="282">
                    <c:v>0.57735026918962573</c:v>
                  </c:pt>
                  <c:pt idx="283">
                    <c:v>0.81649658092772603</c:v>
                  </c:pt>
                  <c:pt idx="284">
                    <c:v>0.5</c:v>
                  </c:pt>
                  <c:pt idx="285">
                    <c:v>0.5</c:v>
                  </c:pt>
                  <c:pt idx="286">
                    <c:v>0.57735026918962573</c:v>
                  </c:pt>
                  <c:pt idx="287">
                    <c:v>1.7320508075688772</c:v>
                  </c:pt>
                  <c:pt idx="288">
                    <c:v>0.5</c:v>
                  </c:pt>
                  <c:pt idx="289">
                    <c:v>0.9574271077563381</c:v>
                  </c:pt>
                  <c:pt idx="290">
                    <c:v>0.81649658092772603</c:v>
                  </c:pt>
                  <c:pt idx="291">
                    <c:v>0.5</c:v>
                  </c:pt>
                  <c:pt idx="292">
                    <c:v>2.5</c:v>
                  </c:pt>
                  <c:pt idx="293">
                    <c:v>0.9574271077563381</c:v>
                  </c:pt>
                  <c:pt idx="294">
                    <c:v>3.6968455021364721</c:v>
                  </c:pt>
                  <c:pt idx="295">
                    <c:v>0.5</c:v>
                  </c:pt>
                  <c:pt idx="296">
                    <c:v>0.81649658092772603</c:v>
                  </c:pt>
                  <c:pt idx="297">
                    <c:v>0.57735026918962573</c:v>
                  </c:pt>
                  <c:pt idx="298">
                    <c:v>0.5</c:v>
                  </c:pt>
                  <c:pt idx="299">
                    <c:v>1.1547005383792515</c:v>
                  </c:pt>
                  <c:pt idx="300">
                    <c:v>2.0615528128088303</c:v>
                  </c:pt>
                  <c:pt idx="301">
                    <c:v>1.4142135623730951</c:v>
                  </c:pt>
                  <c:pt idx="302">
                    <c:v>0.5</c:v>
                  </c:pt>
                  <c:pt idx="303">
                    <c:v>4.0311288741492746</c:v>
                  </c:pt>
                  <c:pt idx="304">
                    <c:v>0.5</c:v>
                  </c:pt>
                  <c:pt idx="305">
                    <c:v>0.9574271077563381</c:v>
                  </c:pt>
                  <c:pt idx="306">
                    <c:v>0.81649658092772603</c:v>
                  </c:pt>
                  <c:pt idx="307">
                    <c:v>1</c:v>
                  </c:pt>
                  <c:pt idx="308">
                    <c:v>7.2743842809317316</c:v>
                  </c:pt>
                  <c:pt idx="309">
                    <c:v>0.5</c:v>
                  </c:pt>
                  <c:pt idx="310">
                    <c:v>0</c:v>
                  </c:pt>
                  <c:pt idx="311">
                    <c:v>0.9574271077563381</c:v>
                  </c:pt>
                  <c:pt idx="312">
                    <c:v>0.57735026918962573</c:v>
                  </c:pt>
                  <c:pt idx="313">
                    <c:v>0.5</c:v>
                  </c:pt>
                  <c:pt idx="314">
                    <c:v>0.57735026918962573</c:v>
                  </c:pt>
                  <c:pt idx="315">
                    <c:v>1.7320508075688772</c:v>
                  </c:pt>
                  <c:pt idx="316">
                    <c:v>0.5</c:v>
                  </c:pt>
                  <c:pt idx="317">
                    <c:v>0.57735026918962573</c:v>
                  </c:pt>
                  <c:pt idx="318">
                    <c:v>1.707825127659933</c:v>
                  </c:pt>
                  <c:pt idx="319">
                    <c:v>0.5</c:v>
                  </c:pt>
                  <c:pt idx="320">
                    <c:v>0.57735026918962573</c:v>
                  </c:pt>
                  <c:pt idx="321">
                    <c:v>1.7320508075688772</c:v>
                  </c:pt>
                  <c:pt idx="322">
                    <c:v>0.9574271077563381</c:v>
                  </c:pt>
                  <c:pt idx="323">
                    <c:v>0.57735026918962573</c:v>
                  </c:pt>
                  <c:pt idx="324">
                    <c:v>0.5</c:v>
                  </c:pt>
                  <c:pt idx="325">
                    <c:v>0.9574271077563381</c:v>
                  </c:pt>
                  <c:pt idx="326">
                    <c:v>0.5</c:v>
                  </c:pt>
                  <c:pt idx="327">
                    <c:v>0</c:v>
                  </c:pt>
                  <c:pt idx="328">
                    <c:v>0.5</c:v>
                  </c:pt>
                  <c:pt idx="329">
                    <c:v>0.81649658092772603</c:v>
                  </c:pt>
                  <c:pt idx="330">
                    <c:v>0.5</c:v>
                  </c:pt>
                  <c:pt idx="331">
                    <c:v>0</c:v>
                  </c:pt>
                  <c:pt idx="332">
                    <c:v>0.57735026918962573</c:v>
                  </c:pt>
                  <c:pt idx="333">
                    <c:v>1</c:v>
                  </c:pt>
                  <c:pt idx="334">
                    <c:v>0.9574271077563381</c:v>
                  </c:pt>
                  <c:pt idx="335">
                    <c:v>8.5244745683629475</c:v>
                  </c:pt>
                  <c:pt idx="336">
                    <c:v>1.2583057392117916</c:v>
                  </c:pt>
                  <c:pt idx="337">
                    <c:v>1.707825127659933</c:v>
                  </c:pt>
                  <c:pt idx="338">
                    <c:v>0.5</c:v>
                  </c:pt>
                  <c:pt idx="339">
                    <c:v>1.2583057392117916</c:v>
                  </c:pt>
                  <c:pt idx="340">
                    <c:v>1.2909944487358056</c:v>
                  </c:pt>
                  <c:pt idx="341">
                    <c:v>0.57735026918962573</c:v>
                  </c:pt>
                  <c:pt idx="342">
                    <c:v>0.5</c:v>
                  </c:pt>
                  <c:pt idx="343">
                    <c:v>0.81649658092772603</c:v>
                  </c:pt>
                  <c:pt idx="344">
                    <c:v>0.57735026918962573</c:v>
                  </c:pt>
                  <c:pt idx="345">
                    <c:v>0.9574271077563381</c:v>
                  </c:pt>
                  <c:pt idx="346">
                    <c:v>0</c:v>
                  </c:pt>
                  <c:pt idx="347">
                    <c:v>1.8257418583505538</c:v>
                  </c:pt>
                  <c:pt idx="348">
                    <c:v>1.6329931618554521</c:v>
                  </c:pt>
                  <c:pt idx="349">
                    <c:v>3.7749172176353749</c:v>
                  </c:pt>
                  <c:pt idx="350">
                    <c:v>1.1547005383792515</c:v>
                  </c:pt>
                  <c:pt idx="351">
                    <c:v>1.4142135623730951</c:v>
                  </c:pt>
                  <c:pt idx="352">
                    <c:v>0</c:v>
                  </c:pt>
                  <c:pt idx="353">
                    <c:v>24.513601666557825</c:v>
                  </c:pt>
                  <c:pt idx="354">
                    <c:v>37.579914848227105</c:v>
                  </c:pt>
                  <c:pt idx="355">
                    <c:v>1.2583057392117916</c:v>
                  </c:pt>
                  <c:pt idx="356">
                    <c:v>0.9574271077563381</c:v>
                  </c:pt>
                  <c:pt idx="357">
                    <c:v>1.707825127659933</c:v>
                  </c:pt>
                  <c:pt idx="358">
                    <c:v>31.255666152982034</c:v>
                  </c:pt>
                  <c:pt idx="359">
                    <c:v>0.57735026918962573</c:v>
                  </c:pt>
                  <c:pt idx="360">
                    <c:v>1.5</c:v>
                  </c:pt>
                  <c:pt idx="361">
                    <c:v>0.81649658092772603</c:v>
                  </c:pt>
                  <c:pt idx="362">
                    <c:v>1.2583057392117916</c:v>
                  </c:pt>
                  <c:pt idx="363">
                    <c:v>0.57735026918962573</c:v>
                  </c:pt>
                  <c:pt idx="364">
                    <c:v>0.57735026918962573</c:v>
                  </c:pt>
                  <c:pt idx="365">
                    <c:v>0</c:v>
                  </c:pt>
                  <c:pt idx="366">
                    <c:v>1.4142135623730951</c:v>
                  </c:pt>
                  <c:pt idx="367">
                    <c:v>1</c:v>
                  </c:pt>
                  <c:pt idx="368">
                    <c:v>3.1622776601683795</c:v>
                  </c:pt>
                  <c:pt idx="369">
                    <c:v>0</c:v>
                  </c:pt>
                  <c:pt idx="370">
                    <c:v>0.5</c:v>
                  </c:pt>
                  <c:pt idx="371">
                    <c:v>2.6299556396765835</c:v>
                  </c:pt>
                  <c:pt idx="372">
                    <c:v>15.779733838059499</c:v>
                  </c:pt>
                  <c:pt idx="373">
                    <c:v>0.57735026918962573</c:v>
                  </c:pt>
                  <c:pt idx="374">
                    <c:v>0.5</c:v>
                  </c:pt>
                  <c:pt idx="375">
                    <c:v>0.5</c:v>
                  </c:pt>
                  <c:pt idx="376">
                    <c:v>0.5</c:v>
                  </c:pt>
                  <c:pt idx="377">
                    <c:v>0.57735026918962573</c:v>
                  </c:pt>
                  <c:pt idx="378">
                    <c:v>0.57735026918962573</c:v>
                  </c:pt>
                  <c:pt idx="379">
                    <c:v>1.5</c:v>
                  </c:pt>
                  <c:pt idx="380">
                    <c:v>0.5</c:v>
                  </c:pt>
                  <c:pt idx="381">
                    <c:v>0.5</c:v>
                  </c:pt>
                  <c:pt idx="382">
                    <c:v>0.5</c:v>
                  </c:pt>
                  <c:pt idx="383">
                    <c:v>0.9574271077563381</c:v>
                  </c:pt>
                  <c:pt idx="384">
                    <c:v>1.8929694486000912</c:v>
                  </c:pt>
                  <c:pt idx="385">
                    <c:v>1.2909944487358056</c:v>
                  </c:pt>
                  <c:pt idx="386">
                    <c:v>1.2583057392117916</c:v>
                  </c:pt>
                  <c:pt idx="387">
                    <c:v>0.9574271077563381</c:v>
                  </c:pt>
                  <c:pt idx="388">
                    <c:v>46.514334708058904</c:v>
                  </c:pt>
                  <c:pt idx="389">
                    <c:v>0.5</c:v>
                  </c:pt>
                  <c:pt idx="390">
                    <c:v>1.8929694486000912</c:v>
                  </c:pt>
                  <c:pt idx="391">
                    <c:v>0.5</c:v>
                  </c:pt>
                  <c:pt idx="392">
                    <c:v>0.5</c:v>
                  </c:pt>
                  <c:pt idx="393">
                    <c:v>0.81649658092772603</c:v>
                  </c:pt>
                  <c:pt idx="394">
                    <c:v>0.81649658092772603</c:v>
                  </c:pt>
                  <c:pt idx="395">
                    <c:v>1.8929694486000912</c:v>
                  </c:pt>
                  <c:pt idx="396">
                    <c:v>5.9721576223896387</c:v>
                  </c:pt>
                  <c:pt idx="397">
                    <c:v>1.2583057392117916</c:v>
                  </c:pt>
                  <c:pt idx="398">
                    <c:v>1.2583057392117916</c:v>
                  </c:pt>
                  <c:pt idx="399">
                    <c:v>0.57735026918962573</c:v>
                  </c:pt>
                  <c:pt idx="400">
                    <c:v>0.5</c:v>
                  </c:pt>
                  <c:pt idx="401">
                    <c:v>1</c:v>
                  </c:pt>
                  <c:pt idx="402">
                    <c:v>0.57735026918962573</c:v>
                  </c:pt>
                  <c:pt idx="403">
                    <c:v>4.2426406871192848</c:v>
                  </c:pt>
                  <c:pt idx="404">
                    <c:v>1.2583057392117916</c:v>
                  </c:pt>
                  <c:pt idx="405">
                    <c:v>0.57735026918962573</c:v>
                  </c:pt>
                  <c:pt idx="406">
                    <c:v>0.81649658092772603</c:v>
                  </c:pt>
                  <c:pt idx="407">
                    <c:v>0.5</c:v>
                  </c:pt>
                  <c:pt idx="408">
                    <c:v>2.0816659994661326</c:v>
                  </c:pt>
                  <c:pt idx="409">
                    <c:v>1.8257418583505538</c:v>
                  </c:pt>
                  <c:pt idx="410">
                    <c:v>1.4142135623730951</c:v>
                  </c:pt>
                  <c:pt idx="411">
                    <c:v>0.57735026918962573</c:v>
                  </c:pt>
                  <c:pt idx="412">
                    <c:v>4.358898943540674</c:v>
                  </c:pt>
                  <c:pt idx="413">
                    <c:v>0.9574271077563381</c:v>
                  </c:pt>
                  <c:pt idx="414">
                    <c:v>1</c:v>
                  </c:pt>
                  <c:pt idx="415">
                    <c:v>0.5</c:v>
                  </c:pt>
                  <c:pt idx="416">
                    <c:v>0.81649658092772603</c:v>
                  </c:pt>
                  <c:pt idx="417">
                    <c:v>0.57735026918962573</c:v>
                  </c:pt>
                  <c:pt idx="418">
                    <c:v>42.200908363051461</c:v>
                  </c:pt>
                  <c:pt idx="419">
                    <c:v>0.9574271077563381</c:v>
                  </c:pt>
                  <c:pt idx="420">
                    <c:v>2.0816659994661326</c:v>
                  </c:pt>
                  <c:pt idx="421">
                    <c:v>1.1547005383792515</c:v>
                  </c:pt>
                  <c:pt idx="422">
                    <c:v>1.8929694486000912</c:v>
                  </c:pt>
                  <c:pt idx="423">
                    <c:v>0</c:v>
                  </c:pt>
                  <c:pt idx="424">
                    <c:v>0.5</c:v>
                  </c:pt>
                  <c:pt idx="425">
                    <c:v>0.57735026918962573</c:v>
                  </c:pt>
                  <c:pt idx="426">
                    <c:v>0.5</c:v>
                  </c:pt>
                  <c:pt idx="427">
                    <c:v>0.5</c:v>
                  </c:pt>
                  <c:pt idx="428">
                    <c:v>0.9574271077563381</c:v>
                  </c:pt>
                  <c:pt idx="429">
                    <c:v>0.57735026918962573</c:v>
                  </c:pt>
                  <c:pt idx="430">
                    <c:v>1.1547005383792515</c:v>
                  </c:pt>
                  <c:pt idx="431">
                    <c:v>1.5</c:v>
                  </c:pt>
                  <c:pt idx="432">
                    <c:v>1.8257418583505538</c:v>
                  </c:pt>
                  <c:pt idx="433">
                    <c:v>1.7320508075688772</c:v>
                  </c:pt>
                  <c:pt idx="434">
                    <c:v>1.1547005383792515</c:v>
                  </c:pt>
                  <c:pt idx="435">
                    <c:v>0.81649658092772603</c:v>
                  </c:pt>
                  <c:pt idx="436">
                    <c:v>1.2583057392117916</c:v>
                  </c:pt>
                  <c:pt idx="437">
                    <c:v>70.329581258528762</c:v>
                  </c:pt>
                  <c:pt idx="438">
                    <c:v>1.5</c:v>
                  </c:pt>
                  <c:pt idx="439">
                    <c:v>1.4142135623730951</c:v>
                  </c:pt>
                  <c:pt idx="440">
                    <c:v>2.3804761428476167</c:v>
                  </c:pt>
                  <c:pt idx="441">
                    <c:v>1.1547005383792515</c:v>
                  </c:pt>
                  <c:pt idx="442">
                    <c:v>1</c:v>
                  </c:pt>
                  <c:pt idx="443">
                    <c:v>0.9574271077563381</c:v>
                  </c:pt>
                  <c:pt idx="444">
                    <c:v>1.2583057392117916</c:v>
                  </c:pt>
                  <c:pt idx="445">
                    <c:v>2.4494897427831779</c:v>
                  </c:pt>
                  <c:pt idx="446">
                    <c:v>0.9574271077563381</c:v>
                  </c:pt>
                  <c:pt idx="447">
                    <c:v>0.5</c:v>
                  </c:pt>
                  <c:pt idx="448">
                    <c:v>0.57735026918962573</c:v>
                  </c:pt>
                  <c:pt idx="449">
                    <c:v>0.81649658092772603</c:v>
                  </c:pt>
                  <c:pt idx="450">
                    <c:v>0.57735026918962573</c:v>
                  </c:pt>
                  <c:pt idx="451">
                    <c:v>0.5</c:v>
                  </c:pt>
                  <c:pt idx="452">
                    <c:v>0.5</c:v>
                  </c:pt>
                  <c:pt idx="453">
                    <c:v>0.5</c:v>
                  </c:pt>
                  <c:pt idx="454">
                    <c:v>0.5</c:v>
                  </c:pt>
                  <c:pt idx="455">
                    <c:v>0.5</c:v>
                  </c:pt>
                  <c:pt idx="456">
                    <c:v>0.81649658092772603</c:v>
                  </c:pt>
                  <c:pt idx="457">
                    <c:v>0.57735026918962573</c:v>
                  </c:pt>
                  <c:pt idx="458">
                    <c:v>0.5</c:v>
                  </c:pt>
                  <c:pt idx="459">
                    <c:v>0.57735026918962573</c:v>
                  </c:pt>
                  <c:pt idx="460">
                    <c:v>1.2909944487358056</c:v>
                  </c:pt>
                  <c:pt idx="461">
                    <c:v>0.5</c:v>
                  </c:pt>
                  <c:pt idx="462">
                    <c:v>2.6299556396765835</c:v>
                  </c:pt>
                  <c:pt idx="463">
                    <c:v>0.9574271077563381</c:v>
                  </c:pt>
                  <c:pt idx="464">
                    <c:v>1</c:v>
                  </c:pt>
                  <c:pt idx="465">
                    <c:v>0.81649658092772603</c:v>
                  </c:pt>
                  <c:pt idx="466">
                    <c:v>0.57735026918962573</c:v>
                  </c:pt>
                  <c:pt idx="467">
                    <c:v>0.5</c:v>
                  </c:pt>
                  <c:pt idx="468">
                    <c:v>0.81649658092772603</c:v>
                  </c:pt>
                  <c:pt idx="469">
                    <c:v>5.5976185412488881</c:v>
                  </c:pt>
                  <c:pt idx="470">
                    <c:v>0.57735026918962573</c:v>
                  </c:pt>
                  <c:pt idx="471">
                    <c:v>1.7320508075688772</c:v>
                  </c:pt>
                  <c:pt idx="472">
                    <c:v>0.5</c:v>
                  </c:pt>
                  <c:pt idx="473">
                    <c:v>0.9574271077563381</c:v>
                  </c:pt>
                  <c:pt idx="474">
                    <c:v>0.5</c:v>
                  </c:pt>
                  <c:pt idx="475">
                    <c:v>0</c:v>
                  </c:pt>
                  <c:pt idx="476">
                    <c:v>7.3936910042729442</c:v>
                  </c:pt>
                  <c:pt idx="477">
                    <c:v>0.9574271077563381</c:v>
                  </c:pt>
                  <c:pt idx="478">
                    <c:v>1.4142135623730951</c:v>
                  </c:pt>
                  <c:pt idx="479">
                    <c:v>0.81649658092772603</c:v>
                  </c:pt>
                  <c:pt idx="480">
                    <c:v>0.81649658092772603</c:v>
                  </c:pt>
                  <c:pt idx="481">
                    <c:v>1.5</c:v>
                  </c:pt>
                  <c:pt idx="482">
                    <c:v>0.5</c:v>
                  </c:pt>
                  <c:pt idx="483">
                    <c:v>1.4142135623730951</c:v>
                  </c:pt>
                  <c:pt idx="484">
                    <c:v>8.3815273071201055</c:v>
                  </c:pt>
                  <c:pt idx="485">
                    <c:v>1.1547005383792515</c:v>
                  </c:pt>
                  <c:pt idx="486">
                    <c:v>1.5</c:v>
                  </c:pt>
                  <c:pt idx="487">
                    <c:v>0.9574271077563381</c:v>
                  </c:pt>
                  <c:pt idx="488">
                    <c:v>0.5</c:v>
                  </c:pt>
                  <c:pt idx="489">
                    <c:v>0.9574271077563381</c:v>
                  </c:pt>
                  <c:pt idx="490">
                    <c:v>1.5</c:v>
                  </c:pt>
                  <c:pt idx="491">
                    <c:v>1.9148542155126762</c:v>
                  </c:pt>
                  <c:pt idx="492">
                    <c:v>1.707825127659933</c:v>
                  </c:pt>
                  <c:pt idx="493">
                    <c:v>1.5</c:v>
                  </c:pt>
                  <c:pt idx="494">
                    <c:v>0.57735026918962573</c:v>
                  </c:pt>
                  <c:pt idx="495">
                    <c:v>0.57735026918962573</c:v>
                  </c:pt>
                  <c:pt idx="496">
                    <c:v>1.2909944487358056</c:v>
                  </c:pt>
                  <c:pt idx="497">
                    <c:v>4.7609522856952333</c:v>
                  </c:pt>
                  <c:pt idx="498">
                    <c:v>0.9574271077563381</c:v>
                  </c:pt>
                  <c:pt idx="499">
                    <c:v>0.57735026918962573</c:v>
                  </c:pt>
                  <c:pt idx="500">
                    <c:v>0.57735026918962573</c:v>
                  </c:pt>
                  <c:pt idx="501">
                    <c:v>0.5</c:v>
                  </c:pt>
                  <c:pt idx="502">
                    <c:v>2.1602468994692869</c:v>
                  </c:pt>
                  <c:pt idx="503">
                    <c:v>1</c:v>
                  </c:pt>
                  <c:pt idx="504">
                    <c:v>1</c:v>
                  </c:pt>
                  <c:pt idx="505">
                    <c:v>0.5</c:v>
                  </c:pt>
                  <c:pt idx="506">
                    <c:v>0.5</c:v>
                  </c:pt>
                  <c:pt idx="507">
                    <c:v>16.660832312142553</c:v>
                  </c:pt>
                  <c:pt idx="508">
                    <c:v>1.2583057392117916</c:v>
                  </c:pt>
                  <c:pt idx="509">
                    <c:v>0.9574271077563381</c:v>
                  </c:pt>
                  <c:pt idx="510">
                    <c:v>0.5</c:v>
                  </c:pt>
                  <c:pt idx="511">
                    <c:v>0.9574271077563381</c:v>
                  </c:pt>
                  <c:pt idx="512">
                    <c:v>0.5</c:v>
                  </c:pt>
                  <c:pt idx="513">
                    <c:v>0.5</c:v>
                  </c:pt>
                  <c:pt idx="514">
                    <c:v>0.9574271077563381</c:v>
                  </c:pt>
                  <c:pt idx="515">
                    <c:v>0.5</c:v>
                  </c:pt>
                  <c:pt idx="516">
                    <c:v>0.57735026918962573</c:v>
                  </c:pt>
                  <c:pt idx="517">
                    <c:v>0.5</c:v>
                  </c:pt>
                  <c:pt idx="518">
                    <c:v>0.81649658092772603</c:v>
                  </c:pt>
                  <c:pt idx="519">
                    <c:v>0.5</c:v>
                  </c:pt>
                  <c:pt idx="520">
                    <c:v>0.5</c:v>
                  </c:pt>
                  <c:pt idx="521">
                    <c:v>0.5</c:v>
                  </c:pt>
                  <c:pt idx="522">
                    <c:v>0.57735026918962573</c:v>
                  </c:pt>
                  <c:pt idx="523">
                    <c:v>0.9574271077563381</c:v>
                  </c:pt>
                  <c:pt idx="524">
                    <c:v>1.2909944487358056</c:v>
                  </c:pt>
                  <c:pt idx="525">
                    <c:v>13.711309200802088</c:v>
                  </c:pt>
                  <c:pt idx="526">
                    <c:v>1.707825127659933</c:v>
                  </c:pt>
                  <c:pt idx="527">
                    <c:v>0.5</c:v>
                  </c:pt>
                  <c:pt idx="528">
                    <c:v>0.57735026918962573</c:v>
                  </c:pt>
                  <c:pt idx="529">
                    <c:v>4.7958315233127191</c:v>
                  </c:pt>
                  <c:pt idx="530">
                    <c:v>4.9916597106239795</c:v>
                  </c:pt>
                  <c:pt idx="531">
                    <c:v>0.9574271077563381</c:v>
                  </c:pt>
                  <c:pt idx="532">
                    <c:v>0.57735026918962573</c:v>
                  </c:pt>
                  <c:pt idx="533">
                    <c:v>0.5</c:v>
                  </c:pt>
                  <c:pt idx="534">
                    <c:v>2</c:v>
                  </c:pt>
                  <c:pt idx="535">
                    <c:v>1.2909944487358056</c:v>
                  </c:pt>
                  <c:pt idx="536">
                    <c:v>2.5</c:v>
                  </c:pt>
                  <c:pt idx="537">
                    <c:v>0.81649658092772603</c:v>
                  </c:pt>
                  <c:pt idx="538">
                    <c:v>0.57735026918962573</c:v>
                  </c:pt>
                  <c:pt idx="539">
                    <c:v>0.9574271077563381</c:v>
                  </c:pt>
                  <c:pt idx="540">
                    <c:v>1</c:v>
                  </c:pt>
                  <c:pt idx="541">
                    <c:v>1.2909944487358056</c:v>
                  </c:pt>
                  <c:pt idx="542">
                    <c:v>0.81649658092772603</c:v>
                  </c:pt>
                  <c:pt idx="543">
                    <c:v>0</c:v>
                  </c:pt>
                  <c:pt idx="544">
                    <c:v>1.707825127659933</c:v>
                  </c:pt>
                  <c:pt idx="545">
                    <c:v>2.8867513459481291</c:v>
                  </c:pt>
                  <c:pt idx="546">
                    <c:v>0.9574271077563381</c:v>
                  </c:pt>
                  <c:pt idx="547">
                    <c:v>0</c:v>
                  </c:pt>
                  <c:pt idx="548">
                    <c:v>0.81649658092772603</c:v>
                  </c:pt>
                  <c:pt idx="549">
                    <c:v>0.9574271077563381</c:v>
                  </c:pt>
                  <c:pt idx="550">
                    <c:v>1.2909944487358056</c:v>
                  </c:pt>
                  <c:pt idx="551">
                    <c:v>3.1622776601683795</c:v>
                  </c:pt>
                  <c:pt idx="552">
                    <c:v>0</c:v>
                  </c:pt>
                  <c:pt idx="553">
                    <c:v>1.5</c:v>
                  </c:pt>
                  <c:pt idx="554">
                    <c:v>0.81649658092772603</c:v>
                  </c:pt>
                  <c:pt idx="555">
                    <c:v>0.5</c:v>
                  </c:pt>
                  <c:pt idx="556">
                    <c:v>1</c:v>
                  </c:pt>
                  <c:pt idx="557">
                    <c:v>5.0579969684978394</c:v>
                  </c:pt>
                  <c:pt idx="558">
                    <c:v>0.9574271077563381</c:v>
                  </c:pt>
                  <c:pt idx="559">
                    <c:v>0.5</c:v>
                  </c:pt>
                  <c:pt idx="560">
                    <c:v>1.2583057392117916</c:v>
                  </c:pt>
                  <c:pt idx="561">
                    <c:v>0</c:v>
                  </c:pt>
                  <c:pt idx="562">
                    <c:v>2.6299556396765835</c:v>
                  </c:pt>
                  <c:pt idx="563">
                    <c:v>2.3629078131263039</c:v>
                  </c:pt>
                  <c:pt idx="564">
                    <c:v>0.5</c:v>
                  </c:pt>
                  <c:pt idx="565">
                    <c:v>17.8232058470598</c:v>
                  </c:pt>
                  <c:pt idx="566">
                    <c:v>0.57735026918962573</c:v>
                  </c:pt>
                  <c:pt idx="567">
                    <c:v>0.57735026918962573</c:v>
                  </c:pt>
                  <c:pt idx="568">
                    <c:v>0</c:v>
                  </c:pt>
                  <c:pt idx="569">
                    <c:v>8.981462390204987</c:v>
                  </c:pt>
                  <c:pt idx="570">
                    <c:v>0.9574271077563381</c:v>
                  </c:pt>
                  <c:pt idx="571">
                    <c:v>0.81649658092772603</c:v>
                  </c:pt>
                  <c:pt idx="572">
                    <c:v>0.57735026918962573</c:v>
                  </c:pt>
                  <c:pt idx="573">
                    <c:v>0.57735026918962573</c:v>
                  </c:pt>
                  <c:pt idx="574">
                    <c:v>0.9574271077563381</c:v>
                  </c:pt>
                  <c:pt idx="575">
                    <c:v>1.1547005383792515</c:v>
                  </c:pt>
                  <c:pt idx="576">
                    <c:v>0.57735026918962573</c:v>
                  </c:pt>
                  <c:pt idx="577">
                    <c:v>0.5</c:v>
                  </c:pt>
                  <c:pt idx="578">
                    <c:v>0</c:v>
                  </c:pt>
                  <c:pt idx="579">
                    <c:v>0.5</c:v>
                  </c:pt>
                  <c:pt idx="580">
                    <c:v>5.259911279353167</c:v>
                  </c:pt>
                  <c:pt idx="581">
                    <c:v>1.2583057392117916</c:v>
                  </c:pt>
                  <c:pt idx="582">
                    <c:v>0.9574271077563381</c:v>
                  </c:pt>
                  <c:pt idx="583">
                    <c:v>8.6168439698070429</c:v>
                  </c:pt>
                  <c:pt idx="584">
                    <c:v>1.5</c:v>
                  </c:pt>
                </c:numCache>
              </c:numRef>
            </c:minus>
            <c:spPr>
              <a:ln w="12700">
                <a:solidFill>
                  <a:srgbClr val="C0C0C0"/>
                </a:solidFill>
                <a:prstDash val="solid"/>
              </a:ln>
            </c:spPr>
          </c:errBars>
          <c:cat>
            <c:numRef>
              <c:f>'10127D221A 200ug'!$A$2:$A$586</c:f>
              <c:numCache>
                <c:formatCode>General</c:formatCode>
                <c:ptCount val="585"/>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pt idx="105">
                  <c:v>106</c:v>
                </c:pt>
                <c:pt idx="106">
                  <c:v>107</c:v>
                </c:pt>
                <c:pt idx="107">
                  <c:v>108</c:v>
                </c:pt>
                <c:pt idx="108">
                  <c:v>109</c:v>
                </c:pt>
                <c:pt idx="109">
                  <c:v>110</c:v>
                </c:pt>
                <c:pt idx="110">
                  <c:v>111</c:v>
                </c:pt>
                <c:pt idx="111">
                  <c:v>112</c:v>
                </c:pt>
                <c:pt idx="112">
                  <c:v>113</c:v>
                </c:pt>
                <c:pt idx="113">
                  <c:v>114</c:v>
                </c:pt>
                <c:pt idx="114">
                  <c:v>115</c:v>
                </c:pt>
                <c:pt idx="115">
                  <c:v>116</c:v>
                </c:pt>
                <c:pt idx="116">
                  <c:v>117</c:v>
                </c:pt>
                <c:pt idx="117">
                  <c:v>118</c:v>
                </c:pt>
                <c:pt idx="118">
                  <c:v>119</c:v>
                </c:pt>
                <c:pt idx="119">
                  <c:v>120</c:v>
                </c:pt>
                <c:pt idx="120">
                  <c:v>121</c:v>
                </c:pt>
                <c:pt idx="121">
                  <c:v>122</c:v>
                </c:pt>
                <c:pt idx="122">
                  <c:v>123</c:v>
                </c:pt>
                <c:pt idx="123">
                  <c:v>124</c:v>
                </c:pt>
                <c:pt idx="124">
                  <c:v>125</c:v>
                </c:pt>
                <c:pt idx="125">
                  <c:v>126</c:v>
                </c:pt>
                <c:pt idx="126">
                  <c:v>127</c:v>
                </c:pt>
                <c:pt idx="127">
                  <c:v>128</c:v>
                </c:pt>
                <c:pt idx="128">
                  <c:v>129</c:v>
                </c:pt>
                <c:pt idx="129">
                  <c:v>130</c:v>
                </c:pt>
                <c:pt idx="130">
                  <c:v>131</c:v>
                </c:pt>
                <c:pt idx="131">
                  <c:v>132</c:v>
                </c:pt>
                <c:pt idx="132">
                  <c:v>133</c:v>
                </c:pt>
                <c:pt idx="133">
                  <c:v>134</c:v>
                </c:pt>
                <c:pt idx="134">
                  <c:v>135</c:v>
                </c:pt>
                <c:pt idx="135">
                  <c:v>136</c:v>
                </c:pt>
                <c:pt idx="136">
                  <c:v>137</c:v>
                </c:pt>
                <c:pt idx="137">
                  <c:v>138</c:v>
                </c:pt>
                <c:pt idx="138">
                  <c:v>139</c:v>
                </c:pt>
                <c:pt idx="139">
                  <c:v>140</c:v>
                </c:pt>
                <c:pt idx="140">
                  <c:v>141</c:v>
                </c:pt>
                <c:pt idx="141">
                  <c:v>142</c:v>
                </c:pt>
                <c:pt idx="142">
                  <c:v>143</c:v>
                </c:pt>
                <c:pt idx="143">
                  <c:v>144</c:v>
                </c:pt>
                <c:pt idx="144">
                  <c:v>145</c:v>
                </c:pt>
                <c:pt idx="145">
                  <c:v>146</c:v>
                </c:pt>
                <c:pt idx="146">
                  <c:v>147</c:v>
                </c:pt>
                <c:pt idx="147">
                  <c:v>148</c:v>
                </c:pt>
                <c:pt idx="148">
                  <c:v>149</c:v>
                </c:pt>
                <c:pt idx="149">
                  <c:v>150</c:v>
                </c:pt>
                <c:pt idx="150">
                  <c:v>151</c:v>
                </c:pt>
                <c:pt idx="151">
                  <c:v>152</c:v>
                </c:pt>
                <c:pt idx="152">
                  <c:v>153</c:v>
                </c:pt>
                <c:pt idx="153">
                  <c:v>154</c:v>
                </c:pt>
                <c:pt idx="154">
                  <c:v>155</c:v>
                </c:pt>
                <c:pt idx="155">
                  <c:v>156</c:v>
                </c:pt>
                <c:pt idx="156">
                  <c:v>157</c:v>
                </c:pt>
                <c:pt idx="157">
                  <c:v>158</c:v>
                </c:pt>
                <c:pt idx="158">
                  <c:v>159</c:v>
                </c:pt>
                <c:pt idx="159">
                  <c:v>160</c:v>
                </c:pt>
                <c:pt idx="160">
                  <c:v>161</c:v>
                </c:pt>
                <c:pt idx="161">
                  <c:v>162</c:v>
                </c:pt>
                <c:pt idx="162">
                  <c:v>163</c:v>
                </c:pt>
                <c:pt idx="163">
                  <c:v>164</c:v>
                </c:pt>
                <c:pt idx="164">
                  <c:v>165</c:v>
                </c:pt>
                <c:pt idx="165">
                  <c:v>166</c:v>
                </c:pt>
                <c:pt idx="166">
                  <c:v>167</c:v>
                </c:pt>
                <c:pt idx="167">
                  <c:v>168</c:v>
                </c:pt>
                <c:pt idx="168">
                  <c:v>169</c:v>
                </c:pt>
                <c:pt idx="169">
                  <c:v>170</c:v>
                </c:pt>
                <c:pt idx="170">
                  <c:v>171</c:v>
                </c:pt>
                <c:pt idx="171">
                  <c:v>172</c:v>
                </c:pt>
                <c:pt idx="172">
                  <c:v>173</c:v>
                </c:pt>
                <c:pt idx="173">
                  <c:v>174</c:v>
                </c:pt>
                <c:pt idx="174">
                  <c:v>175</c:v>
                </c:pt>
                <c:pt idx="175">
                  <c:v>176</c:v>
                </c:pt>
                <c:pt idx="176">
                  <c:v>177</c:v>
                </c:pt>
                <c:pt idx="177">
                  <c:v>178</c:v>
                </c:pt>
                <c:pt idx="178">
                  <c:v>179</c:v>
                </c:pt>
                <c:pt idx="179">
                  <c:v>180</c:v>
                </c:pt>
                <c:pt idx="180">
                  <c:v>181</c:v>
                </c:pt>
                <c:pt idx="181">
                  <c:v>182</c:v>
                </c:pt>
                <c:pt idx="182">
                  <c:v>183</c:v>
                </c:pt>
                <c:pt idx="183">
                  <c:v>184</c:v>
                </c:pt>
                <c:pt idx="184">
                  <c:v>185</c:v>
                </c:pt>
                <c:pt idx="185">
                  <c:v>186</c:v>
                </c:pt>
                <c:pt idx="186">
                  <c:v>187</c:v>
                </c:pt>
                <c:pt idx="187">
                  <c:v>188</c:v>
                </c:pt>
                <c:pt idx="188">
                  <c:v>189</c:v>
                </c:pt>
                <c:pt idx="189">
                  <c:v>190</c:v>
                </c:pt>
                <c:pt idx="190">
                  <c:v>191</c:v>
                </c:pt>
                <c:pt idx="191">
                  <c:v>192</c:v>
                </c:pt>
                <c:pt idx="192">
                  <c:v>193</c:v>
                </c:pt>
                <c:pt idx="193">
                  <c:v>194</c:v>
                </c:pt>
                <c:pt idx="194">
                  <c:v>195</c:v>
                </c:pt>
                <c:pt idx="195">
                  <c:v>196</c:v>
                </c:pt>
                <c:pt idx="196">
                  <c:v>197</c:v>
                </c:pt>
                <c:pt idx="197">
                  <c:v>198</c:v>
                </c:pt>
                <c:pt idx="198">
                  <c:v>199</c:v>
                </c:pt>
                <c:pt idx="199">
                  <c:v>200</c:v>
                </c:pt>
                <c:pt idx="200">
                  <c:v>201</c:v>
                </c:pt>
                <c:pt idx="201">
                  <c:v>202</c:v>
                </c:pt>
                <c:pt idx="202">
                  <c:v>203</c:v>
                </c:pt>
                <c:pt idx="203">
                  <c:v>204</c:v>
                </c:pt>
                <c:pt idx="204">
                  <c:v>205</c:v>
                </c:pt>
                <c:pt idx="205">
                  <c:v>206</c:v>
                </c:pt>
                <c:pt idx="206">
                  <c:v>207</c:v>
                </c:pt>
                <c:pt idx="207">
                  <c:v>208</c:v>
                </c:pt>
                <c:pt idx="208">
                  <c:v>209</c:v>
                </c:pt>
                <c:pt idx="209">
                  <c:v>210</c:v>
                </c:pt>
                <c:pt idx="210">
                  <c:v>211</c:v>
                </c:pt>
                <c:pt idx="211">
                  <c:v>212</c:v>
                </c:pt>
                <c:pt idx="212">
                  <c:v>213</c:v>
                </c:pt>
                <c:pt idx="213">
                  <c:v>214</c:v>
                </c:pt>
                <c:pt idx="214">
                  <c:v>215</c:v>
                </c:pt>
                <c:pt idx="215">
                  <c:v>216</c:v>
                </c:pt>
                <c:pt idx="216">
                  <c:v>217</c:v>
                </c:pt>
                <c:pt idx="217">
                  <c:v>218</c:v>
                </c:pt>
                <c:pt idx="218">
                  <c:v>219</c:v>
                </c:pt>
                <c:pt idx="219">
                  <c:v>220</c:v>
                </c:pt>
                <c:pt idx="220">
                  <c:v>221</c:v>
                </c:pt>
                <c:pt idx="221">
                  <c:v>222</c:v>
                </c:pt>
                <c:pt idx="222">
                  <c:v>223</c:v>
                </c:pt>
                <c:pt idx="223">
                  <c:v>224</c:v>
                </c:pt>
                <c:pt idx="224">
                  <c:v>225</c:v>
                </c:pt>
                <c:pt idx="225">
                  <c:v>226</c:v>
                </c:pt>
                <c:pt idx="226">
                  <c:v>227</c:v>
                </c:pt>
                <c:pt idx="227">
                  <c:v>228</c:v>
                </c:pt>
                <c:pt idx="228">
                  <c:v>229</c:v>
                </c:pt>
                <c:pt idx="229">
                  <c:v>230</c:v>
                </c:pt>
                <c:pt idx="230">
                  <c:v>231</c:v>
                </c:pt>
                <c:pt idx="231">
                  <c:v>232</c:v>
                </c:pt>
                <c:pt idx="232">
                  <c:v>233</c:v>
                </c:pt>
                <c:pt idx="233">
                  <c:v>234</c:v>
                </c:pt>
                <c:pt idx="234">
                  <c:v>235</c:v>
                </c:pt>
                <c:pt idx="235">
                  <c:v>236</c:v>
                </c:pt>
                <c:pt idx="236">
                  <c:v>237</c:v>
                </c:pt>
                <c:pt idx="237">
                  <c:v>238</c:v>
                </c:pt>
                <c:pt idx="238">
                  <c:v>239</c:v>
                </c:pt>
                <c:pt idx="239">
                  <c:v>240</c:v>
                </c:pt>
                <c:pt idx="240">
                  <c:v>241</c:v>
                </c:pt>
                <c:pt idx="241">
                  <c:v>242</c:v>
                </c:pt>
                <c:pt idx="242">
                  <c:v>243</c:v>
                </c:pt>
                <c:pt idx="243">
                  <c:v>244</c:v>
                </c:pt>
                <c:pt idx="244">
                  <c:v>245</c:v>
                </c:pt>
                <c:pt idx="245">
                  <c:v>246</c:v>
                </c:pt>
                <c:pt idx="246">
                  <c:v>247</c:v>
                </c:pt>
                <c:pt idx="247">
                  <c:v>248</c:v>
                </c:pt>
                <c:pt idx="248">
                  <c:v>249</c:v>
                </c:pt>
                <c:pt idx="249">
                  <c:v>250</c:v>
                </c:pt>
                <c:pt idx="250">
                  <c:v>251</c:v>
                </c:pt>
                <c:pt idx="251">
                  <c:v>252</c:v>
                </c:pt>
                <c:pt idx="252">
                  <c:v>253</c:v>
                </c:pt>
                <c:pt idx="253">
                  <c:v>254</c:v>
                </c:pt>
                <c:pt idx="254">
                  <c:v>255</c:v>
                </c:pt>
                <c:pt idx="255">
                  <c:v>256</c:v>
                </c:pt>
                <c:pt idx="256">
                  <c:v>257</c:v>
                </c:pt>
                <c:pt idx="257">
                  <c:v>258</c:v>
                </c:pt>
                <c:pt idx="258">
                  <c:v>259</c:v>
                </c:pt>
                <c:pt idx="259">
                  <c:v>260</c:v>
                </c:pt>
                <c:pt idx="260">
                  <c:v>261</c:v>
                </c:pt>
                <c:pt idx="261">
                  <c:v>262</c:v>
                </c:pt>
                <c:pt idx="262">
                  <c:v>263</c:v>
                </c:pt>
                <c:pt idx="263">
                  <c:v>264</c:v>
                </c:pt>
                <c:pt idx="264">
                  <c:v>265</c:v>
                </c:pt>
                <c:pt idx="265">
                  <c:v>266</c:v>
                </c:pt>
                <c:pt idx="266">
                  <c:v>267</c:v>
                </c:pt>
                <c:pt idx="267">
                  <c:v>268</c:v>
                </c:pt>
                <c:pt idx="268">
                  <c:v>269</c:v>
                </c:pt>
                <c:pt idx="269">
                  <c:v>270</c:v>
                </c:pt>
                <c:pt idx="270">
                  <c:v>271</c:v>
                </c:pt>
                <c:pt idx="271">
                  <c:v>272</c:v>
                </c:pt>
                <c:pt idx="272">
                  <c:v>273</c:v>
                </c:pt>
                <c:pt idx="273">
                  <c:v>274</c:v>
                </c:pt>
                <c:pt idx="274">
                  <c:v>275</c:v>
                </c:pt>
                <c:pt idx="275">
                  <c:v>276</c:v>
                </c:pt>
                <c:pt idx="276">
                  <c:v>277</c:v>
                </c:pt>
                <c:pt idx="277">
                  <c:v>278</c:v>
                </c:pt>
                <c:pt idx="278">
                  <c:v>279</c:v>
                </c:pt>
                <c:pt idx="279">
                  <c:v>280</c:v>
                </c:pt>
                <c:pt idx="280">
                  <c:v>281</c:v>
                </c:pt>
                <c:pt idx="281">
                  <c:v>282</c:v>
                </c:pt>
                <c:pt idx="282">
                  <c:v>283</c:v>
                </c:pt>
                <c:pt idx="283">
                  <c:v>284</c:v>
                </c:pt>
                <c:pt idx="284">
                  <c:v>285</c:v>
                </c:pt>
                <c:pt idx="285">
                  <c:v>286</c:v>
                </c:pt>
                <c:pt idx="286">
                  <c:v>287</c:v>
                </c:pt>
                <c:pt idx="287">
                  <c:v>288</c:v>
                </c:pt>
                <c:pt idx="288">
                  <c:v>289</c:v>
                </c:pt>
                <c:pt idx="289">
                  <c:v>290</c:v>
                </c:pt>
                <c:pt idx="290">
                  <c:v>291</c:v>
                </c:pt>
                <c:pt idx="291">
                  <c:v>292</c:v>
                </c:pt>
                <c:pt idx="292">
                  <c:v>293</c:v>
                </c:pt>
                <c:pt idx="293">
                  <c:v>294</c:v>
                </c:pt>
                <c:pt idx="294">
                  <c:v>295</c:v>
                </c:pt>
                <c:pt idx="295">
                  <c:v>296</c:v>
                </c:pt>
                <c:pt idx="296">
                  <c:v>297</c:v>
                </c:pt>
                <c:pt idx="297">
                  <c:v>298</c:v>
                </c:pt>
                <c:pt idx="298">
                  <c:v>299</c:v>
                </c:pt>
                <c:pt idx="299">
                  <c:v>300</c:v>
                </c:pt>
                <c:pt idx="300">
                  <c:v>301</c:v>
                </c:pt>
                <c:pt idx="301">
                  <c:v>302</c:v>
                </c:pt>
                <c:pt idx="302">
                  <c:v>303</c:v>
                </c:pt>
                <c:pt idx="303">
                  <c:v>304</c:v>
                </c:pt>
                <c:pt idx="304">
                  <c:v>305</c:v>
                </c:pt>
                <c:pt idx="305">
                  <c:v>306</c:v>
                </c:pt>
                <c:pt idx="306">
                  <c:v>307</c:v>
                </c:pt>
                <c:pt idx="307">
                  <c:v>308</c:v>
                </c:pt>
                <c:pt idx="308">
                  <c:v>309</c:v>
                </c:pt>
                <c:pt idx="309">
                  <c:v>310</c:v>
                </c:pt>
                <c:pt idx="310">
                  <c:v>311</c:v>
                </c:pt>
                <c:pt idx="311">
                  <c:v>312</c:v>
                </c:pt>
                <c:pt idx="312">
                  <c:v>313</c:v>
                </c:pt>
                <c:pt idx="313">
                  <c:v>314</c:v>
                </c:pt>
                <c:pt idx="314">
                  <c:v>315</c:v>
                </c:pt>
                <c:pt idx="315">
                  <c:v>316</c:v>
                </c:pt>
                <c:pt idx="316">
                  <c:v>317</c:v>
                </c:pt>
                <c:pt idx="317">
                  <c:v>318</c:v>
                </c:pt>
                <c:pt idx="318">
                  <c:v>319</c:v>
                </c:pt>
                <c:pt idx="319">
                  <c:v>320</c:v>
                </c:pt>
                <c:pt idx="320">
                  <c:v>321</c:v>
                </c:pt>
                <c:pt idx="321">
                  <c:v>322</c:v>
                </c:pt>
                <c:pt idx="322">
                  <c:v>323</c:v>
                </c:pt>
                <c:pt idx="323">
                  <c:v>324</c:v>
                </c:pt>
                <c:pt idx="324">
                  <c:v>325</c:v>
                </c:pt>
                <c:pt idx="325">
                  <c:v>326</c:v>
                </c:pt>
                <c:pt idx="326">
                  <c:v>327</c:v>
                </c:pt>
                <c:pt idx="327">
                  <c:v>328</c:v>
                </c:pt>
                <c:pt idx="328">
                  <c:v>329</c:v>
                </c:pt>
                <c:pt idx="329">
                  <c:v>330</c:v>
                </c:pt>
                <c:pt idx="330">
                  <c:v>331</c:v>
                </c:pt>
                <c:pt idx="331">
                  <c:v>332</c:v>
                </c:pt>
                <c:pt idx="332">
                  <c:v>333</c:v>
                </c:pt>
                <c:pt idx="333">
                  <c:v>334</c:v>
                </c:pt>
                <c:pt idx="334">
                  <c:v>335</c:v>
                </c:pt>
                <c:pt idx="335">
                  <c:v>336</c:v>
                </c:pt>
                <c:pt idx="336">
                  <c:v>337</c:v>
                </c:pt>
                <c:pt idx="337">
                  <c:v>338</c:v>
                </c:pt>
                <c:pt idx="338">
                  <c:v>339</c:v>
                </c:pt>
                <c:pt idx="339">
                  <c:v>340</c:v>
                </c:pt>
                <c:pt idx="340">
                  <c:v>341</c:v>
                </c:pt>
                <c:pt idx="341">
                  <c:v>342</c:v>
                </c:pt>
                <c:pt idx="342">
                  <c:v>343</c:v>
                </c:pt>
                <c:pt idx="343">
                  <c:v>344</c:v>
                </c:pt>
                <c:pt idx="344">
                  <c:v>345</c:v>
                </c:pt>
                <c:pt idx="345">
                  <c:v>346</c:v>
                </c:pt>
                <c:pt idx="346">
                  <c:v>347</c:v>
                </c:pt>
                <c:pt idx="347">
                  <c:v>348</c:v>
                </c:pt>
                <c:pt idx="348">
                  <c:v>349</c:v>
                </c:pt>
                <c:pt idx="349">
                  <c:v>350</c:v>
                </c:pt>
                <c:pt idx="350">
                  <c:v>351</c:v>
                </c:pt>
                <c:pt idx="351">
                  <c:v>352</c:v>
                </c:pt>
                <c:pt idx="352">
                  <c:v>353</c:v>
                </c:pt>
                <c:pt idx="353">
                  <c:v>354</c:v>
                </c:pt>
                <c:pt idx="354">
                  <c:v>355</c:v>
                </c:pt>
                <c:pt idx="355">
                  <c:v>356</c:v>
                </c:pt>
                <c:pt idx="356">
                  <c:v>357</c:v>
                </c:pt>
                <c:pt idx="357">
                  <c:v>358</c:v>
                </c:pt>
                <c:pt idx="358">
                  <c:v>359</c:v>
                </c:pt>
                <c:pt idx="359">
                  <c:v>360</c:v>
                </c:pt>
                <c:pt idx="360">
                  <c:v>361</c:v>
                </c:pt>
                <c:pt idx="361">
                  <c:v>362</c:v>
                </c:pt>
                <c:pt idx="362">
                  <c:v>363</c:v>
                </c:pt>
                <c:pt idx="363">
                  <c:v>364</c:v>
                </c:pt>
                <c:pt idx="364">
                  <c:v>365</c:v>
                </c:pt>
                <c:pt idx="365">
                  <c:v>366</c:v>
                </c:pt>
                <c:pt idx="366">
                  <c:v>367</c:v>
                </c:pt>
                <c:pt idx="367">
                  <c:v>368</c:v>
                </c:pt>
                <c:pt idx="368">
                  <c:v>369</c:v>
                </c:pt>
                <c:pt idx="369">
                  <c:v>370</c:v>
                </c:pt>
                <c:pt idx="370">
                  <c:v>371</c:v>
                </c:pt>
                <c:pt idx="371">
                  <c:v>372</c:v>
                </c:pt>
                <c:pt idx="372">
                  <c:v>373</c:v>
                </c:pt>
                <c:pt idx="373">
                  <c:v>374</c:v>
                </c:pt>
                <c:pt idx="374">
                  <c:v>375</c:v>
                </c:pt>
                <c:pt idx="375">
                  <c:v>376</c:v>
                </c:pt>
                <c:pt idx="376">
                  <c:v>377</c:v>
                </c:pt>
                <c:pt idx="377">
                  <c:v>378</c:v>
                </c:pt>
                <c:pt idx="378">
                  <c:v>379</c:v>
                </c:pt>
                <c:pt idx="379">
                  <c:v>380</c:v>
                </c:pt>
                <c:pt idx="380">
                  <c:v>381</c:v>
                </c:pt>
                <c:pt idx="381">
                  <c:v>382</c:v>
                </c:pt>
                <c:pt idx="382">
                  <c:v>383</c:v>
                </c:pt>
                <c:pt idx="383">
                  <c:v>384</c:v>
                </c:pt>
                <c:pt idx="384">
                  <c:v>385</c:v>
                </c:pt>
                <c:pt idx="385">
                  <c:v>386</c:v>
                </c:pt>
                <c:pt idx="386">
                  <c:v>387</c:v>
                </c:pt>
                <c:pt idx="387">
                  <c:v>388</c:v>
                </c:pt>
                <c:pt idx="388">
                  <c:v>389</c:v>
                </c:pt>
                <c:pt idx="389">
                  <c:v>390</c:v>
                </c:pt>
                <c:pt idx="390">
                  <c:v>391</c:v>
                </c:pt>
                <c:pt idx="391">
                  <c:v>392</c:v>
                </c:pt>
                <c:pt idx="392">
                  <c:v>393</c:v>
                </c:pt>
                <c:pt idx="393">
                  <c:v>394</c:v>
                </c:pt>
                <c:pt idx="394">
                  <c:v>395</c:v>
                </c:pt>
                <c:pt idx="395">
                  <c:v>396</c:v>
                </c:pt>
                <c:pt idx="396">
                  <c:v>397</c:v>
                </c:pt>
                <c:pt idx="397">
                  <c:v>398</c:v>
                </c:pt>
                <c:pt idx="398">
                  <c:v>399</c:v>
                </c:pt>
                <c:pt idx="399">
                  <c:v>400</c:v>
                </c:pt>
                <c:pt idx="400">
                  <c:v>401</c:v>
                </c:pt>
                <c:pt idx="401">
                  <c:v>402</c:v>
                </c:pt>
                <c:pt idx="402">
                  <c:v>403</c:v>
                </c:pt>
                <c:pt idx="403">
                  <c:v>404</c:v>
                </c:pt>
                <c:pt idx="404">
                  <c:v>405</c:v>
                </c:pt>
                <c:pt idx="405">
                  <c:v>406</c:v>
                </c:pt>
                <c:pt idx="406">
                  <c:v>407</c:v>
                </c:pt>
                <c:pt idx="407">
                  <c:v>408</c:v>
                </c:pt>
                <c:pt idx="408">
                  <c:v>409</c:v>
                </c:pt>
                <c:pt idx="409">
                  <c:v>410</c:v>
                </c:pt>
                <c:pt idx="410">
                  <c:v>411</c:v>
                </c:pt>
                <c:pt idx="411">
                  <c:v>412</c:v>
                </c:pt>
                <c:pt idx="412">
                  <c:v>413</c:v>
                </c:pt>
                <c:pt idx="413">
                  <c:v>414</c:v>
                </c:pt>
                <c:pt idx="414">
                  <c:v>415</c:v>
                </c:pt>
                <c:pt idx="415">
                  <c:v>416</c:v>
                </c:pt>
                <c:pt idx="416">
                  <c:v>417</c:v>
                </c:pt>
                <c:pt idx="417">
                  <c:v>418</c:v>
                </c:pt>
                <c:pt idx="418">
                  <c:v>419</c:v>
                </c:pt>
                <c:pt idx="419">
                  <c:v>420</c:v>
                </c:pt>
                <c:pt idx="420">
                  <c:v>421</c:v>
                </c:pt>
                <c:pt idx="421">
                  <c:v>422</c:v>
                </c:pt>
                <c:pt idx="422">
                  <c:v>423</c:v>
                </c:pt>
                <c:pt idx="423">
                  <c:v>424</c:v>
                </c:pt>
                <c:pt idx="424">
                  <c:v>425</c:v>
                </c:pt>
                <c:pt idx="425">
                  <c:v>426</c:v>
                </c:pt>
                <c:pt idx="426">
                  <c:v>427</c:v>
                </c:pt>
                <c:pt idx="427">
                  <c:v>428</c:v>
                </c:pt>
                <c:pt idx="428">
                  <c:v>429</c:v>
                </c:pt>
                <c:pt idx="429">
                  <c:v>430</c:v>
                </c:pt>
                <c:pt idx="430">
                  <c:v>431</c:v>
                </c:pt>
                <c:pt idx="431">
                  <c:v>432</c:v>
                </c:pt>
                <c:pt idx="432">
                  <c:v>433</c:v>
                </c:pt>
                <c:pt idx="433">
                  <c:v>434</c:v>
                </c:pt>
                <c:pt idx="434">
                  <c:v>435</c:v>
                </c:pt>
                <c:pt idx="435">
                  <c:v>436</c:v>
                </c:pt>
                <c:pt idx="436">
                  <c:v>437</c:v>
                </c:pt>
                <c:pt idx="437">
                  <c:v>438</c:v>
                </c:pt>
                <c:pt idx="438">
                  <c:v>439</c:v>
                </c:pt>
                <c:pt idx="439">
                  <c:v>440</c:v>
                </c:pt>
                <c:pt idx="440">
                  <c:v>441</c:v>
                </c:pt>
                <c:pt idx="441">
                  <c:v>442</c:v>
                </c:pt>
                <c:pt idx="442">
                  <c:v>443</c:v>
                </c:pt>
                <c:pt idx="443">
                  <c:v>444</c:v>
                </c:pt>
                <c:pt idx="444">
                  <c:v>445</c:v>
                </c:pt>
                <c:pt idx="445">
                  <c:v>446</c:v>
                </c:pt>
                <c:pt idx="446">
                  <c:v>447</c:v>
                </c:pt>
                <c:pt idx="447">
                  <c:v>448</c:v>
                </c:pt>
                <c:pt idx="448">
                  <c:v>449</c:v>
                </c:pt>
                <c:pt idx="449">
                  <c:v>450</c:v>
                </c:pt>
                <c:pt idx="450">
                  <c:v>451</c:v>
                </c:pt>
                <c:pt idx="451">
                  <c:v>452</c:v>
                </c:pt>
                <c:pt idx="452">
                  <c:v>453</c:v>
                </c:pt>
                <c:pt idx="453">
                  <c:v>454</c:v>
                </c:pt>
                <c:pt idx="454">
                  <c:v>455</c:v>
                </c:pt>
                <c:pt idx="455">
                  <c:v>456</c:v>
                </c:pt>
                <c:pt idx="456">
                  <c:v>457</c:v>
                </c:pt>
                <c:pt idx="457">
                  <c:v>458</c:v>
                </c:pt>
                <c:pt idx="458">
                  <c:v>459</c:v>
                </c:pt>
                <c:pt idx="459">
                  <c:v>460</c:v>
                </c:pt>
                <c:pt idx="460">
                  <c:v>461</c:v>
                </c:pt>
                <c:pt idx="461">
                  <c:v>462</c:v>
                </c:pt>
                <c:pt idx="462">
                  <c:v>463</c:v>
                </c:pt>
                <c:pt idx="463">
                  <c:v>464</c:v>
                </c:pt>
                <c:pt idx="464">
                  <c:v>465</c:v>
                </c:pt>
                <c:pt idx="465">
                  <c:v>466</c:v>
                </c:pt>
                <c:pt idx="466">
                  <c:v>467</c:v>
                </c:pt>
                <c:pt idx="467">
                  <c:v>468</c:v>
                </c:pt>
                <c:pt idx="468">
                  <c:v>469</c:v>
                </c:pt>
                <c:pt idx="469">
                  <c:v>470</c:v>
                </c:pt>
                <c:pt idx="470">
                  <c:v>471</c:v>
                </c:pt>
                <c:pt idx="471">
                  <c:v>472</c:v>
                </c:pt>
                <c:pt idx="472">
                  <c:v>473</c:v>
                </c:pt>
                <c:pt idx="473">
                  <c:v>474</c:v>
                </c:pt>
                <c:pt idx="474">
                  <c:v>475</c:v>
                </c:pt>
                <c:pt idx="475">
                  <c:v>476</c:v>
                </c:pt>
                <c:pt idx="476">
                  <c:v>477</c:v>
                </c:pt>
                <c:pt idx="477">
                  <c:v>478</c:v>
                </c:pt>
                <c:pt idx="478">
                  <c:v>479</c:v>
                </c:pt>
                <c:pt idx="479">
                  <c:v>480</c:v>
                </c:pt>
                <c:pt idx="480">
                  <c:v>481</c:v>
                </c:pt>
                <c:pt idx="481">
                  <c:v>482</c:v>
                </c:pt>
                <c:pt idx="482">
                  <c:v>483</c:v>
                </c:pt>
                <c:pt idx="483">
                  <c:v>484</c:v>
                </c:pt>
                <c:pt idx="484">
                  <c:v>485</c:v>
                </c:pt>
                <c:pt idx="485">
                  <c:v>486</c:v>
                </c:pt>
                <c:pt idx="486">
                  <c:v>487</c:v>
                </c:pt>
                <c:pt idx="487">
                  <c:v>488</c:v>
                </c:pt>
                <c:pt idx="488">
                  <c:v>489</c:v>
                </c:pt>
                <c:pt idx="489">
                  <c:v>490</c:v>
                </c:pt>
                <c:pt idx="490">
                  <c:v>491</c:v>
                </c:pt>
                <c:pt idx="491">
                  <c:v>492</c:v>
                </c:pt>
                <c:pt idx="492">
                  <c:v>493</c:v>
                </c:pt>
                <c:pt idx="493">
                  <c:v>494</c:v>
                </c:pt>
                <c:pt idx="494">
                  <c:v>495</c:v>
                </c:pt>
                <c:pt idx="495">
                  <c:v>496</c:v>
                </c:pt>
                <c:pt idx="496">
                  <c:v>497</c:v>
                </c:pt>
                <c:pt idx="497">
                  <c:v>498</c:v>
                </c:pt>
                <c:pt idx="498">
                  <c:v>499</c:v>
                </c:pt>
                <c:pt idx="499">
                  <c:v>500</c:v>
                </c:pt>
                <c:pt idx="500">
                  <c:v>501</c:v>
                </c:pt>
                <c:pt idx="501">
                  <c:v>502</c:v>
                </c:pt>
                <c:pt idx="502">
                  <c:v>503</c:v>
                </c:pt>
                <c:pt idx="503">
                  <c:v>504</c:v>
                </c:pt>
                <c:pt idx="504">
                  <c:v>505</c:v>
                </c:pt>
                <c:pt idx="505">
                  <c:v>506</c:v>
                </c:pt>
                <c:pt idx="506">
                  <c:v>507</c:v>
                </c:pt>
                <c:pt idx="507">
                  <c:v>508</c:v>
                </c:pt>
                <c:pt idx="508">
                  <c:v>509</c:v>
                </c:pt>
                <c:pt idx="509">
                  <c:v>510</c:v>
                </c:pt>
                <c:pt idx="510">
                  <c:v>511</c:v>
                </c:pt>
                <c:pt idx="511">
                  <c:v>512</c:v>
                </c:pt>
                <c:pt idx="512">
                  <c:v>513</c:v>
                </c:pt>
                <c:pt idx="513">
                  <c:v>514</c:v>
                </c:pt>
                <c:pt idx="514">
                  <c:v>515</c:v>
                </c:pt>
                <c:pt idx="515">
                  <c:v>516</c:v>
                </c:pt>
                <c:pt idx="516">
                  <c:v>517</c:v>
                </c:pt>
                <c:pt idx="517">
                  <c:v>518</c:v>
                </c:pt>
                <c:pt idx="518">
                  <c:v>519</c:v>
                </c:pt>
                <c:pt idx="519">
                  <c:v>520</c:v>
                </c:pt>
                <c:pt idx="520">
                  <c:v>521</c:v>
                </c:pt>
                <c:pt idx="521">
                  <c:v>522</c:v>
                </c:pt>
                <c:pt idx="522">
                  <c:v>523</c:v>
                </c:pt>
                <c:pt idx="523">
                  <c:v>524</c:v>
                </c:pt>
                <c:pt idx="524">
                  <c:v>525</c:v>
                </c:pt>
                <c:pt idx="525">
                  <c:v>526</c:v>
                </c:pt>
                <c:pt idx="526">
                  <c:v>527</c:v>
                </c:pt>
                <c:pt idx="527">
                  <c:v>528</c:v>
                </c:pt>
                <c:pt idx="528">
                  <c:v>529</c:v>
                </c:pt>
                <c:pt idx="529">
                  <c:v>530</c:v>
                </c:pt>
                <c:pt idx="530">
                  <c:v>531</c:v>
                </c:pt>
                <c:pt idx="531">
                  <c:v>532</c:v>
                </c:pt>
                <c:pt idx="532">
                  <c:v>533</c:v>
                </c:pt>
                <c:pt idx="533">
                  <c:v>534</c:v>
                </c:pt>
                <c:pt idx="534">
                  <c:v>535</c:v>
                </c:pt>
                <c:pt idx="535">
                  <c:v>536</c:v>
                </c:pt>
                <c:pt idx="536">
                  <c:v>537</c:v>
                </c:pt>
                <c:pt idx="537">
                  <c:v>538</c:v>
                </c:pt>
                <c:pt idx="538">
                  <c:v>539</c:v>
                </c:pt>
                <c:pt idx="539">
                  <c:v>540</c:v>
                </c:pt>
                <c:pt idx="540">
                  <c:v>541</c:v>
                </c:pt>
                <c:pt idx="541">
                  <c:v>542</c:v>
                </c:pt>
                <c:pt idx="542">
                  <c:v>543</c:v>
                </c:pt>
                <c:pt idx="543">
                  <c:v>544</c:v>
                </c:pt>
                <c:pt idx="544">
                  <c:v>545</c:v>
                </c:pt>
                <c:pt idx="545">
                  <c:v>546</c:v>
                </c:pt>
                <c:pt idx="546">
                  <c:v>547</c:v>
                </c:pt>
                <c:pt idx="547">
                  <c:v>548</c:v>
                </c:pt>
                <c:pt idx="548">
                  <c:v>549</c:v>
                </c:pt>
                <c:pt idx="549">
                  <c:v>550</c:v>
                </c:pt>
                <c:pt idx="550">
                  <c:v>551</c:v>
                </c:pt>
                <c:pt idx="551">
                  <c:v>552</c:v>
                </c:pt>
                <c:pt idx="552">
                  <c:v>553</c:v>
                </c:pt>
                <c:pt idx="553">
                  <c:v>554</c:v>
                </c:pt>
                <c:pt idx="554">
                  <c:v>555</c:v>
                </c:pt>
                <c:pt idx="555">
                  <c:v>556</c:v>
                </c:pt>
                <c:pt idx="556">
                  <c:v>557</c:v>
                </c:pt>
                <c:pt idx="557">
                  <c:v>558</c:v>
                </c:pt>
                <c:pt idx="558">
                  <c:v>559</c:v>
                </c:pt>
                <c:pt idx="559">
                  <c:v>560</c:v>
                </c:pt>
                <c:pt idx="560">
                  <c:v>561</c:v>
                </c:pt>
                <c:pt idx="561">
                  <c:v>562</c:v>
                </c:pt>
                <c:pt idx="562">
                  <c:v>563</c:v>
                </c:pt>
                <c:pt idx="563">
                  <c:v>564</c:v>
                </c:pt>
                <c:pt idx="564">
                  <c:v>565</c:v>
                </c:pt>
                <c:pt idx="565">
                  <c:v>566</c:v>
                </c:pt>
                <c:pt idx="566">
                  <c:v>567</c:v>
                </c:pt>
                <c:pt idx="567">
                  <c:v>568</c:v>
                </c:pt>
                <c:pt idx="568">
                  <c:v>569</c:v>
                </c:pt>
                <c:pt idx="569">
                  <c:v>570</c:v>
                </c:pt>
                <c:pt idx="570">
                  <c:v>571</c:v>
                </c:pt>
                <c:pt idx="571">
                  <c:v>572</c:v>
                </c:pt>
                <c:pt idx="572">
                  <c:v>573</c:v>
                </c:pt>
                <c:pt idx="573">
                  <c:v>574</c:v>
                </c:pt>
                <c:pt idx="574">
                  <c:v>575</c:v>
                </c:pt>
                <c:pt idx="575">
                  <c:v>576</c:v>
                </c:pt>
                <c:pt idx="576">
                  <c:v>577</c:v>
                </c:pt>
                <c:pt idx="577">
                  <c:v>578</c:v>
                </c:pt>
                <c:pt idx="578">
                  <c:v>579</c:v>
                </c:pt>
                <c:pt idx="579">
                  <c:v>580</c:v>
                </c:pt>
                <c:pt idx="580">
                  <c:v>581</c:v>
                </c:pt>
                <c:pt idx="581">
                  <c:v>582</c:v>
                </c:pt>
                <c:pt idx="582">
                  <c:v>583</c:v>
                </c:pt>
                <c:pt idx="583">
                  <c:v>584</c:v>
                </c:pt>
                <c:pt idx="584">
                  <c:v>585</c:v>
                </c:pt>
              </c:numCache>
            </c:numRef>
          </c:cat>
          <c:val>
            <c:numRef>
              <c:f>'10127D221A 200ug'!$C$2:$C$586</c:f>
              <c:numCache>
                <c:formatCode>0</c:formatCode>
                <c:ptCount val="585"/>
                <c:pt idx="0">
                  <c:v>5.75</c:v>
                </c:pt>
                <c:pt idx="1">
                  <c:v>4.5</c:v>
                </c:pt>
                <c:pt idx="2">
                  <c:v>5.25</c:v>
                </c:pt>
                <c:pt idx="3">
                  <c:v>3.25</c:v>
                </c:pt>
                <c:pt idx="4">
                  <c:v>3.25</c:v>
                </c:pt>
                <c:pt idx="5">
                  <c:v>6.25</c:v>
                </c:pt>
                <c:pt idx="6">
                  <c:v>3.25</c:v>
                </c:pt>
                <c:pt idx="7">
                  <c:v>5.75</c:v>
                </c:pt>
                <c:pt idx="8">
                  <c:v>4.75</c:v>
                </c:pt>
                <c:pt idx="9">
                  <c:v>2.5</c:v>
                </c:pt>
                <c:pt idx="10">
                  <c:v>5.5</c:v>
                </c:pt>
                <c:pt idx="11">
                  <c:v>7</c:v>
                </c:pt>
                <c:pt idx="12">
                  <c:v>4</c:v>
                </c:pt>
                <c:pt idx="13">
                  <c:v>6.25</c:v>
                </c:pt>
                <c:pt idx="14">
                  <c:v>6.75</c:v>
                </c:pt>
                <c:pt idx="15">
                  <c:v>4.75</c:v>
                </c:pt>
                <c:pt idx="16">
                  <c:v>3.25</c:v>
                </c:pt>
                <c:pt idx="17">
                  <c:v>4.5</c:v>
                </c:pt>
                <c:pt idx="18">
                  <c:v>2.75</c:v>
                </c:pt>
                <c:pt idx="19">
                  <c:v>4.75</c:v>
                </c:pt>
                <c:pt idx="20">
                  <c:v>5.75</c:v>
                </c:pt>
                <c:pt idx="21">
                  <c:v>5.25</c:v>
                </c:pt>
                <c:pt idx="22">
                  <c:v>5</c:v>
                </c:pt>
                <c:pt idx="23">
                  <c:v>16</c:v>
                </c:pt>
                <c:pt idx="24">
                  <c:v>1.75</c:v>
                </c:pt>
                <c:pt idx="25">
                  <c:v>3.75</c:v>
                </c:pt>
                <c:pt idx="26">
                  <c:v>6.75</c:v>
                </c:pt>
                <c:pt idx="27">
                  <c:v>2.5</c:v>
                </c:pt>
                <c:pt idx="28">
                  <c:v>4.25</c:v>
                </c:pt>
                <c:pt idx="29">
                  <c:v>3</c:v>
                </c:pt>
                <c:pt idx="30">
                  <c:v>21.25</c:v>
                </c:pt>
                <c:pt idx="31">
                  <c:v>1.75</c:v>
                </c:pt>
                <c:pt idx="32">
                  <c:v>15.75</c:v>
                </c:pt>
                <c:pt idx="33">
                  <c:v>6.5</c:v>
                </c:pt>
                <c:pt idx="34">
                  <c:v>6.75</c:v>
                </c:pt>
                <c:pt idx="35">
                  <c:v>2.75</c:v>
                </c:pt>
                <c:pt idx="36">
                  <c:v>9</c:v>
                </c:pt>
                <c:pt idx="37">
                  <c:v>6.75</c:v>
                </c:pt>
                <c:pt idx="38">
                  <c:v>3.75</c:v>
                </c:pt>
                <c:pt idx="39">
                  <c:v>5.25</c:v>
                </c:pt>
                <c:pt idx="40">
                  <c:v>3.75</c:v>
                </c:pt>
                <c:pt idx="41">
                  <c:v>4.25</c:v>
                </c:pt>
                <c:pt idx="42">
                  <c:v>4.75</c:v>
                </c:pt>
                <c:pt idx="43">
                  <c:v>6</c:v>
                </c:pt>
                <c:pt idx="44">
                  <c:v>4.5</c:v>
                </c:pt>
                <c:pt idx="45">
                  <c:v>3.75</c:v>
                </c:pt>
                <c:pt idx="46">
                  <c:v>2.5</c:v>
                </c:pt>
                <c:pt idx="47">
                  <c:v>3.5</c:v>
                </c:pt>
                <c:pt idx="48">
                  <c:v>8</c:v>
                </c:pt>
                <c:pt idx="49">
                  <c:v>2.25</c:v>
                </c:pt>
                <c:pt idx="50">
                  <c:v>3</c:v>
                </c:pt>
                <c:pt idx="51">
                  <c:v>1.75</c:v>
                </c:pt>
                <c:pt idx="52">
                  <c:v>2.5</c:v>
                </c:pt>
                <c:pt idx="53">
                  <c:v>2.5</c:v>
                </c:pt>
                <c:pt idx="54">
                  <c:v>2.5</c:v>
                </c:pt>
                <c:pt idx="55">
                  <c:v>5.75</c:v>
                </c:pt>
                <c:pt idx="56">
                  <c:v>6.25</c:v>
                </c:pt>
                <c:pt idx="57">
                  <c:v>8.25</c:v>
                </c:pt>
                <c:pt idx="58">
                  <c:v>2.5</c:v>
                </c:pt>
                <c:pt idx="59">
                  <c:v>5.75</c:v>
                </c:pt>
                <c:pt idx="60">
                  <c:v>5.5</c:v>
                </c:pt>
                <c:pt idx="61">
                  <c:v>2.5</c:v>
                </c:pt>
                <c:pt idx="62">
                  <c:v>5</c:v>
                </c:pt>
                <c:pt idx="63">
                  <c:v>3.25</c:v>
                </c:pt>
                <c:pt idx="64">
                  <c:v>5.25</c:v>
                </c:pt>
                <c:pt idx="65">
                  <c:v>2.75</c:v>
                </c:pt>
                <c:pt idx="66">
                  <c:v>5</c:v>
                </c:pt>
                <c:pt idx="67">
                  <c:v>3.75</c:v>
                </c:pt>
                <c:pt idx="68">
                  <c:v>7.75</c:v>
                </c:pt>
                <c:pt idx="69">
                  <c:v>10</c:v>
                </c:pt>
                <c:pt idx="70">
                  <c:v>3.25</c:v>
                </c:pt>
                <c:pt idx="71">
                  <c:v>29.25</c:v>
                </c:pt>
                <c:pt idx="72">
                  <c:v>2.5</c:v>
                </c:pt>
                <c:pt idx="73">
                  <c:v>3.25</c:v>
                </c:pt>
                <c:pt idx="74">
                  <c:v>3.25</c:v>
                </c:pt>
                <c:pt idx="75">
                  <c:v>3.5</c:v>
                </c:pt>
                <c:pt idx="76">
                  <c:v>3.25</c:v>
                </c:pt>
                <c:pt idx="77">
                  <c:v>5</c:v>
                </c:pt>
                <c:pt idx="78">
                  <c:v>3</c:v>
                </c:pt>
                <c:pt idx="79">
                  <c:v>3.5</c:v>
                </c:pt>
                <c:pt idx="80">
                  <c:v>6</c:v>
                </c:pt>
                <c:pt idx="81">
                  <c:v>3.5</c:v>
                </c:pt>
                <c:pt idx="82">
                  <c:v>5.25</c:v>
                </c:pt>
                <c:pt idx="83">
                  <c:v>6</c:v>
                </c:pt>
                <c:pt idx="84">
                  <c:v>4.25</c:v>
                </c:pt>
                <c:pt idx="85">
                  <c:v>1.75</c:v>
                </c:pt>
                <c:pt idx="86">
                  <c:v>63.75</c:v>
                </c:pt>
                <c:pt idx="87">
                  <c:v>4</c:v>
                </c:pt>
                <c:pt idx="88">
                  <c:v>5.75</c:v>
                </c:pt>
                <c:pt idx="89">
                  <c:v>3</c:v>
                </c:pt>
                <c:pt idx="90">
                  <c:v>6</c:v>
                </c:pt>
                <c:pt idx="91">
                  <c:v>5</c:v>
                </c:pt>
                <c:pt idx="92">
                  <c:v>2.75</c:v>
                </c:pt>
                <c:pt idx="93">
                  <c:v>3.5</c:v>
                </c:pt>
                <c:pt idx="94">
                  <c:v>3.5</c:v>
                </c:pt>
                <c:pt idx="95">
                  <c:v>3.75</c:v>
                </c:pt>
                <c:pt idx="96">
                  <c:v>6</c:v>
                </c:pt>
                <c:pt idx="97">
                  <c:v>4.5</c:v>
                </c:pt>
                <c:pt idx="98">
                  <c:v>3.75</c:v>
                </c:pt>
                <c:pt idx="99">
                  <c:v>3.75</c:v>
                </c:pt>
                <c:pt idx="100">
                  <c:v>4</c:v>
                </c:pt>
                <c:pt idx="101">
                  <c:v>3.75</c:v>
                </c:pt>
                <c:pt idx="102">
                  <c:v>2.5</c:v>
                </c:pt>
                <c:pt idx="103">
                  <c:v>1.5</c:v>
                </c:pt>
                <c:pt idx="104">
                  <c:v>3.25</c:v>
                </c:pt>
                <c:pt idx="105">
                  <c:v>3.5</c:v>
                </c:pt>
                <c:pt idx="106">
                  <c:v>4.25</c:v>
                </c:pt>
                <c:pt idx="107">
                  <c:v>3.75</c:v>
                </c:pt>
                <c:pt idx="108">
                  <c:v>4.75</c:v>
                </c:pt>
                <c:pt idx="109">
                  <c:v>3.5</c:v>
                </c:pt>
                <c:pt idx="110">
                  <c:v>4.25</c:v>
                </c:pt>
                <c:pt idx="111">
                  <c:v>3.75</c:v>
                </c:pt>
                <c:pt idx="112">
                  <c:v>2.75</c:v>
                </c:pt>
                <c:pt idx="113">
                  <c:v>4</c:v>
                </c:pt>
                <c:pt idx="114">
                  <c:v>3.75</c:v>
                </c:pt>
                <c:pt idx="115">
                  <c:v>5</c:v>
                </c:pt>
                <c:pt idx="116">
                  <c:v>4.25</c:v>
                </c:pt>
                <c:pt idx="117">
                  <c:v>3.25</c:v>
                </c:pt>
                <c:pt idx="118">
                  <c:v>3.75</c:v>
                </c:pt>
                <c:pt idx="119">
                  <c:v>2.75</c:v>
                </c:pt>
                <c:pt idx="120">
                  <c:v>5.25</c:v>
                </c:pt>
                <c:pt idx="121">
                  <c:v>3.75</c:v>
                </c:pt>
                <c:pt idx="122">
                  <c:v>18.75</c:v>
                </c:pt>
                <c:pt idx="123">
                  <c:v>4.25</c:v>
                </c:pt>
                <c:pt idx="124">
                  <c:v>4.25</c:v>
                </c:pt>
                <c:pt idx="125">
                  <c:v>3</c:v>
                </c:pt>
                <c:pt idx="126">
                  <c:v>3.75</c:v>
                </c:pt>
                <c:pt idx="127">
                  <c:v>3.5</c:v>
                </c:pt>
                <c:pt idx="128">
                  <c:v>4.75</c:v>
                </c:pt>
                <c:pt idx="129">
                  <c:v>4</c:v>
                </c:pt>
                <c:pt idx="130">
                  <c:v>3.75</c:v>
                </c:pt>
                <c:pt idx="131">
                  <c:v>3.5</c:v>
                </c:pt>
                <c:pt idx="132">
                  <c:v>4.5</c:v>
                </c:pt>
                <c:pt idx="133">
                  <c:v>2.5</c:v>
                </c:pt>
                <c:pt idx="134">
                  <c:v>5.25</c:v>
                </c:pt>
                <c:pt idx="135">
                  <c:v>1.5</c:v>
                </c:pt>
                <c:pt idx="136">
                  <c:v>3.25</c:v>
                </c:pt>
                <c:pt idx="137">
                  <c:v>3.5</c:v>
                </c:pt>
                <c:pt idx="138">
                  <c:v>4.25</c:v>
                </c:pt>
                <c:pt idx="139">
                  <c:v>3.25</c:v>
                </c:pt>
                <c:pt idx="140">
                  <c:v>5.25</c:v>
                </c:pt>
                <c:pt idx="141">
                  <c:v>3.25</c:v>
                </c:pt>
                <c:pt idx="142">
                  <c:v>3.75</c:v>
                </c:pt>
                <c:pt idx="143">
                  <c:v>3</c:v>
                </c:pt>
                <c:pt idx="144">
                  <c:v>3.75</c:v>
                </c:pt>
                <c:pt idx="145">
                  <c:v>5.25</c:v>
                </c:pt>
                <c:pt idx="146">
                  <c:v>1.5</c:v>
                </c:pt>
                <c:pt idx="147">
                  <c:v>2</c:v>
                </c:pt>
                <c:pt idx="148">
                  <c:v>3</c:v>
                </c:pt>
                <c:pt idx="149">
                  <c:v>4.5</c:v>
                </c:pt>
                <c:pt idx="150">
                  <c:v>4.5</c:v>
                </c:pt>
                <c:pt idx="151">
                  <c:v>4.5</c:v>
                </c:pt>
                <c:pt idx="152">
                  <c:v>11.25</c:v>
                </c:pt>
                <c:pt idx="153">
                  <c:v>55.75</c:v>
                </c:pt>
                <c:pt idx="154">
                  <c:v>2.75</c:v>
                </c:pt>
                <c:pt idx="155">
                  <c:v>4.5</c:v>
                </c:pt>
                <c:pt idx="156">
                  <c:v>2.25</c:v>
                </c:pt>
                <c:pt idx="157">
                  <c:v>3.75</c:v>
                </c:pt>
                <c:pt idx="158">
                  <c:v>3.5</c:v>
                </c:pt>
                <c:pt idx="159">
                  <c:v>3</c:v>
                </c:pt>
                <c:pt idx="160">
                  <c:v>4.25</c:v>
                </c:pt>
                <c:pt idx="161">
                  <c:v>3</c:v>
                </c:pt>
                <c:pt idx="162">
                  <c:v>3</c:v>
                </c:pt>
                <c:pt idx="163">
                  <c:v>3</c:v>
                </c:pt>
                <c:pt idx="164">
                  <c:v>2.75</c:v>
                </c:pt>
                <c:pt idx="165">
                  <c:v>3</c:v>
                </c:pt>
                <c:pt idx="166">
                  <c:v>10</c:v>
                </c:pt>
                <c:pt idx="167">
                  <c:v>3.75</c:v>
                </c:pt>
                <c:pt idx="168">
                  <c:v>4.5</c:v>
                </c:pt>
                <c:pt idx="169">
                  <c:v>2</c:v>
                </c:pt>
                <c:pt idx="170">
                  <c:v>4.5</c:v>
                </c:pt>
                <c:pt idx="171">
                  <c:v>4.5</c:v>
                </c:pt>
                <c:pt idx="172">
                  <c:v>2.75</c:v>
                </c:pt>
                <c:pt idx="173">
                  <c:v>4.5</c:v>
                </c:pt>
                <c:pt idx="174">
                  <c:v>2</c:v>
                </c:pt>
                <c:pt idx="175">
                  <c:v>3.25</c:v>
                </c:pt>
                <c:pt idx="176">
                  <c:v>2.5</c:v>
                </c:pt>
                <c:pt idx="177">
                  <c:v>3.75</c:v>
                </c:pt>
                <c:pt idx="178">
                  <c:v>4.25</c:v>
                </c:pt>
                <c:pt idx="179">
                  <c:v>2.75</c:v>
                </c:pt>
                <c:pt idx="180">
                  <c:v>3</c:v>
                </c:pt>
                <c:pt idx="181">
                  <c:v>2.5</c:v>
                </c:pt>
                <c:pt idx="182">
                  <c:v>2.25</c:v>
                </c:pt>
                <c:pt idx="183">
                  <c:v>2</c:v>
                </c:pt>
                <c:pt idx="184">
                  <c:v>4.25</c:v>
                </c:pt>
                <c:pt idx="185">
                  <c:v>3.25</c:v>
                </c:pt>
                <c:pt idx="186">
                  <c:v>21.5</c:v>
                </c:pt>
                <c:pt idx="187">
                  <c:v>3</c:v>
                </c:pt>
                <c:pt idx="188">
                  <c:v>2.25</c:v>
                </c:pt>
                <c:pt idx="189">
                  <c:v>4.25</c:v>
                </c:pt>
                <c:pt idx="190">
                  <c:v>2.5</c:v>
                </c:pt>
                <c:pt idx="191">
                  <c:v>3.75</c:v>
                </c:pt>
                <c:pt idx="192">
                  <c:v>2.75</c:v>
                </c:pt>
                <c:pt idx="193">
                  <c:v>5.75</c:v>
                </c:pt>
                <c:pt idx="194">
                  <c:v>3.75</c:v>
                </c:pt>
                <c:pt idx="195">
                  <c:v>5.25</c:v>
                </c:pt>
                <c:pt idx="196">
                  <c:v>3</c:v>
                </c:pt>
                <c:pt idx="197">
                  <c:v>3.5</c:v>
                </c:pt>
                <c:pt idx="198">
                  <c:v>4.5</c:v>
                </c:pt>
                <c:pt idx="199">
                  <c:v>7.5</c:v>
                </c:pt>
                <c:pt idx="200">
                  <c:v>8.75</c:v>
                </c:pt>
                <c:pt idx="201">
                  <c:v>5.75</c:v>
                </c:pt>
                <c:pt idx="202">
                  <c:v>4.5</c:v>
                </c:pt>
                <c:pt idx="203">
                  <c:v>4.25</c:v>
                </c:pt>
                <c:pt idx="204">
                  <c:v>3</c:v>
                </c:pt>
                <c:pt idx="205">
                  <c:v>4</c:v>
                </c:pt>
                <c:pt idx="206">
                  <c:v>5</c:v>
                </c:pt>
                <c:pt idx="207">
                  <c:v>4.5</c:v>
                </c:pt>
                <c:pt idx="208">
                  <c:v>4</c:v>
                </c:pt>
                <c:pt idx="209">
                  <c:v>9</c:v>
                </c:pt>
                <c:pt idx="210">
                  <c:v>2</c:v>
                </c:pt>
                <c:pt idx="211">
                  <c:v>2.75</c:v>
                </c:pt>
                <c:pt idx="212">
                  <c:v>3.75</c:v>
                </c:pt>
                <c:pt idx="213">
                  <c:v>3.75</c:v>
                </c:pt>
                <c:pt idx="214">
                  <c:v>4.25</c:v>
                </c:pt>
                <c:pt idx="215">
                  <c:v>3.25</c:v>
                </c:pt>
                <c:pt idx="216">
                  <c:v>11.75</c:v>
                </c:pt>
                <c:pt idx="217">
                  <c:v>4.25</c:v>
                </c:pt>
                <c:pt idx="218">
                  <c:v>4.5</c:v>
                </c:pt>
                <c:pt idx="219">
                  <c:v>4.25</c:v>
                </c:pt>
                <c:pt idx="220">
                  <c:v>4</c:v>
                </c:pt>
                <c:pt idx="221">
                  <c:v>3.5</c:v>
                </c:pt>
                <c:pt idx="222">
                  <c:v>2.25</c:v>
                </c:pt>
                <c:pt idx="223">
                  <c:v>4</c:v>
                </c:pt>
                <c:pt idx="224">
                  <c:v>2.5</c:v>
                </c:pt>
                <c:pt idx="225">
                  <c:v>3.25</c:v>
                </c:pt>
                <c:pt idx="226">
                  <c:v>3.75</c:v>
                </c:pt>
                <c:pt idx="227">
                  <c:v>4.25</c:v>
                </c:pt>
                <c:pt idx="228">
                  <c:v>4.25</c:v>
                </c:pt>
                <c:pt idx="229">
                  <c:v>3.75</c:v>
                </c:pt>
                <c:pt idx="230">
                  <c:v>1.75</c:v>
                </c:pt>
                <c:pt idx="231">
                  <c:v>3</c:v>
                </c:pt>
                <c:pt idx="232">
                  <c:v>2</c:v>
                </c:pt>
                <c:pt idx="233">
                  <c:v>2</c:v>
                </c:pt>
                <c:pt idx="234">
                  <c:v>5</c:v>
                </c:pt>
                <c:pt idx="235">
                  <c:v>3.75</c:v>
                </c:pt>
                <c:pt idx="236">
                  <c:v>5.75</c:v>
                </c:pt>
                <c:pt idx="237">
                  <c:v>4</c:v>
                </c:pt>
                <c:pt idx="238">
                  <c:v>6.75</c:v>
                </c:pt>
                <c:pt idx="239">
                  <c:v>2.5</c:v>
                </c:pt>
                <c:pt idx="240">
                  <c:v>11.5</c:v>
                </c:pt>
                <c:pt idx="241">
                  <c:v>3.75</c:v>
                </c:pt>
                <c:pt idx="242">
                  <c:v>4.75</c:v>
                </c:pt>
                <c:pt idx="243">
                  <c:v>2</c:v>
                </c:pt>
                <c:pt idx="244">
                  <c:v>4.25</c:v>
                </c:pt>
                <c:pt idx="245">
                  <c:v>4</c:v>
                </c:pt>
                <c:pt idx="246">
                  <c:v>3.75</c:v>
                </c:pt>
                <c:pt idx="247">
                  <c:v>9.75</c:v>
                </c:pt>
                <c:pt idx="248">
                  <c:v>792</c:v>
                </c:pt>
                <c:pt idx="249">
                  <c:v>6.5</c:v>
                </c:pt>
                <c:pt idx="250">
                  <c:v>6.75</c:v>
                </c:pt>
                <c:pt idx="251">
                  <c:v>63.25</c:v>
                </c:pt>
                <c:pt idx="252">
                  <c:v>267.5</c:v>
                </c:pt>
                <c:pt idx="253">
                  <c:v>3.75</c:v>
                </c:pt>
                <c:pt idx="254">
                  <c:v>3.5</c:v>
                </c:pt>
                <c:pt idx="255">
                  <c:v>2.25</c:v>
                </c:pt>
                <c:pt idx="256">
                  <c:v>3.25</c:v>
                </c:pt>
                <c:pt idx="257">
                  <c:v>4.5</c:v>
                </c:pt>
                <c:pt idx="258">
                  <c:v>4.75</c:v>
                </c:pt>
                <c:pt idx="259">
                  <c:v>2.5</c:v>
                </c:pt>
                <c:pt idx="260">
                  <c:v>17</c:v>
                </c:pt>
                <c:pt idx="261">
                  <c:v>1.75</c:v>
                </c:pt>
                <c:pt idx="262">
                  <c:v>5</c:v>
                </c:pt>
                <c:pt idx="263">
                  <c:v>2.75</c:v>
                </c:pt>
                <c:pt idx="264">
                  <c:v>4</c:v>
                </c:pt>
                <c:pt idx="265">
                  <c:v>5.5</c:v>
                </c:pt>
                <c:pt idx="266">
                  <c:v>4.25</c:v>
                </c:pt>
                <c:pt idx="267">
                  <c:v>4</c:v>
                </c:pt>
                <c:pt idx="268">
                  <c:v>4.5</c:v>
                </c:pt>
                <c:pt idx="269">
                  <c:v>5.25</c:v>
                </c:pt>
                <c:pt idx="270">
                  <c:v>3.75</c:v>
                </c:pt>
                <c:pt idx="271">
                  <c:v>3.25</c:v>
                </c:pt>
                <c:pt idx="272">
                  <c:v>5.25</c:v>
                </c:pt>
                <c:pt idx="273">
                  <c:v>2.25</c:v>
                </c:pt>
                <c:pt idx="274">
                  <c:v>3.5</c:v>
                </c:pt>
                <c:pt idx="275">
                  <c:v>3.25</c:v>
                </c:pt>
                <c:pt idx="276">
                  <c:v>3.5</c:v>
                </c:pt>
                <c:pt idx="277">
                  <c:v>15.75</c:v>
                </c:pt>
                <c:pt idx="278">
                  <c:v>3.75</c:v>
                </c:pt>
                <c:pt idx="279">
                  <c:v>3.25</c:v>
                </c:pt>
                <c:pt idx="280">
                  <c:v>4.75</c:v>
                </c:pt>
                <c:pt idx="281">
                  <c:v>3.5</c:v>
                </c:pt>
                <c:pt idx="282">
                  <c:v>5.5</c:v>
                </c:pt>
                <c:pt idx="283">
                  <c:v>4</c:v>
                </c:pt>
                <c:pt idx="284">
                  <c:v>2.75</c:v>
                </c:pt>
                <c:pt idx="285">
                  <c:v>8.25</c:v>
                </c:pt>
                <c:pt idx="286">
                  <c:v>5.5</c:v>
                </c:pt>
                <c:pt idx="287">
                  <c:v>5.5</c:v>
                </c:pt>
                <c:pt idx="288">
                  <c:v>5.75</c:v>
                </c:pt>
                <c:pt idx="289">
                  <c:v>4.75</c:v>
                </c:pt>
                <c:pt idx="290">
                  <c:v>3</c:v>
                </c:pt>
                <c:pt idx="291">
                  <c:v>8.75</c:v>
                </c:pt>
                <c:pt idx="292">
                  <c:v>7.25</c:v>
                </c:pt>
                <c:pt idx="293">
                  <c:v>12.75</c:v>
                </c:pt>
                <c:pt idx="294">
                  <c:v>16.5</c:v>
                </c:pt>
                <c:pt idx="295">
                  <c:v>2.25</c:v>
                </c:pt>
                <c:pt idx="296">
                  <c:v>3</c:v>
                </c:pt>
                <c:pt idx="297">
                  <c:v>2.5</c:v>
                </c:pt>
                <c:pt idx="298">
                  <c:v>2.75</c:v>
                </c:pt>
                <c:pt idx="299">
                  <c:v>3</c:v>
                </c:pt>
                <c:pt idx="300">
                  <c:v>3.75</c:v>
                </c:pt>
                <c:pt idx="301">
                  <c:v>3</c:v>
                </c:pt>
                <c:pt idx="302">
                  <c:v>4.75</c:v>
                </c:pt>
                <c:pt idx="303">
                  <c:v>15.25</c:v>
                </c:pt>
                <c:pt idx="304">
                  <c:v>5.25</c:v>
                </c:pt>
                <c:pt idx="305">
                  <c:v>2.25</c:v>
                </c:pt>
                <c:pt idx="306">
                  <c:v>4</c:v>
                </c:pt>
                <c:pt idx="307">
                  <c:v>3.5</c:v>
                </c:pt>
                <c:pt idx="308">
                  <c:v>11.75</c:v>
                </c:pt>
                <c:pt idx="309">
                  <c:v>3.75</c:v>
                </c:pt>
                <c:pt idx="310">
                  <c:v>3</c:v>
                </c:pt>
                <c:pt idx="311">
                  <c:v>3.75</c:v>
                </c:pt>
                <c:pt idx="312">
                  <c:v>2.5</c:v>
                </c:pt>
                <c:pt idx="313">
                  <c:v>3.75</c:v>
                </c:pt>
                <c:pt idx="314">
                  <c:v>2.5</c:v>
                </c:pt>
                <c:pt idx="315">
                  <c:v>5.5</c:v>
                </c:pt>
                <c:pt idx="316">
                  <c:v>2.75</c:v>
                </c:pt>
                <c:pt idx="317">
                  <c:v>4.5</c:v>
                </c:pt>
                <c:pt idx="318">
                  <c:v>6.75</c:v>
                </c:pt>
                <c:pt idx="319">
                  <c:v>2.25</c:v>
                </c:pt>
                <c:pt idx="320">
                  <c:v>2.5</c:v>
                </c:pt>
                <c:pt idx="321">
                  <c:v>3.5</c:v>
                </c:pt>
                <c:pt idx="322">
                  <c:v>3.25</c:v>
                </c:pt>
                <c:pt idx="323">
                  <c:v>1.5</c:v>
                </c:pt>
                <c:pt idx="324">
                  <c:v>7.75</c:v>
                </c:pt>
                <c:pt idx="325">
                  <c:v>2.25</c:v>
                </c:pt>
                <c:pt idx="326">
                  <c:v>3.25</c:v>
                </c:pt>
                <c:pt idx="327">
                  <c:v>5</c:v>
                </c:pt>
                <c:pt idx="328">
                  <c:v>1.75</c:v>
                </c:pt>
                <c:pt idx="329">
                  <c:v>5</c:v>
                </c:pt>
                <c:pt idx="330">
                  <c:v>6.25</c:v>
                </c:pt>
                <c:pt idx="331">
                  <c:v>3</c:v>
                </c:pt>
                <c:pt idx="332">
                  <c:v>3.5</c:v>
                </c:pt>
                <c:pt idx="333">
                  <c:v>2.5</c:v>
                </c:pt>
                <c:pt idx="334">
                  <c:v>3.25</c:v>
                </c:pt>
                <c:pt idx="335">
                  <c:v>55</c:v>
                </c:pt>
                <c:pt idx="336">
                  <c:v>3.75</c:v>
                </c:pt>
                <c:pt idx="337">
                  <c:v>3.25</c:v>
                </c:pt>
                <c:pt idx="338">
                  <c:v>3.25</c:v>
                </c:pt>
                <c:pt idx="339">
                  <c:v>1.75</c:v>
                </c:pt>
                <c:pt idx="340">
                  <c:v>2.5</c:v>
                </c:pt>
                <c:pt idx="341">
                  <c:v>2.5</c:v>
                </c:pt>
                <c:pt idx="342">
                  <c:v>3.75</c:v>
                </c:pt>
                <c:pt idx="343">
                  <c:v>4</c:v>
                </c:pt>
                <c:pt idx="344">
                  <c:v>3.5</c:v>
                </c:pt>
                <c:pt idx="345">
                  <c:v>8.25</c:v>
                </c:pt>
                <c:pt idx="346">
                  <c:v>4</c:v>
                </c:pt>
                <c:pt idx="347">
                  <c:v>6</c:v>
                </c:pt>
                <c:pt idx="348">
                  <c:v>4</c:v>
                </c:pt>
                <c:pt idx="349">
                  <c:v>10.25</c:v>
                </c:pt>
                <c:pt idx="350">
                  <c:v>3</c:v>
                </c:pt>
                <c:pt idx="351">
                  <c:v>4</c:v>
                </c:pt>
                <c:pt idx="352">
                  <c:v>3</c:v>
                </c:pt>
                <c:pt idx="353">
                  <c:v>228.25</c:v>
                </c:pt>
                <c:pt idx="354">
                  <c:v>375.25</c:v>
                </c:pt>
                <c:pt idx="355">
                  <c:v>6.25</c:v>
                </c:pt>
                <c:pt idx="356">
                  <c:v>3.75</c:v>
                </c:pt>
                <c:pt idx="357">
                  <c:v>4.25</c:v>
                </c:pt>
                <c:pt idx="358">
                  <c:v>289.75</c:v>
                </c:pt>
                <c:pt idx="359">
                  <c:v>2.5</c:v>
                </c:pt>
                <c:pt idx="360">
                  <c:v>3.25</c:v>
                </c:pt>
                <c:pt idx="361">
                  <c:v>3</c:v>
                </c:pt>
                <c:pt idx="362">
                  <c:v>3.25</c:v>
                </c:pt>
                <c:pt idx="363">
                  <c:v>3.5</c:v>
                </c:pt>
                <c:pt idx="364">
                  <c:v>4.5</c:v>
                </c:pt>
                <c:pt idx="365">
                  <c:v>5</c:v>
                </c:pt>
                <c:pt idx="366">
                  <c:v>3</c:v>
                </c:pt>
                <c:pt idx="367">
                  <c:v>3.5</c:v>
                </c:pt>
                <c:pt idx="368">
                  <c:v>6</c:v>
                </c:pt>
                <c:pt idx="369">
                  <c:v>1</c:v>
                </c:pt>
                <c:pt idx="370">
                  <c:v>1.25</c:v>
                </c:pt>
                <c:pt idx="371">
                  <c:v>21.75</c:v>
                </c:pt>
                <c:pt idx="372">
                  <c:v>273.5</c:v>
                </c:pt>
                <c:pt idx="373">
                  <c:v>2.5</c:v>
                </c:pt>
                <c:pt idx="374">
                  <c:v>3.25</c:v>
                </c:pt>
                <c:pt idx="375">
                  <c:v>2.25</c:v>
                </c:pt>
                <c:pt idx="376">
                  <c:v>2.75</c:v>
                </c:pt>
                <c:pt idx="377">
                  <c:v>3.5</c:v>
                </c:pt>
                <c:pt idx="378">
                  <c:v>2.5</c:v>
                </c:pt>
                <c:pt idx="379">
                  <c:v>2.25</c:v>
                </c:pt>
                <c:pt idx="380">
                  <c:v>2.25</c:v>
                </c:pt>
                <c:pt idx="381">
                  <c:v>3.25</c:v>
                </c:pt>
                <c:pt idx="382">
                  <c:v>3.25</c:v>
                </c:pt>
                <c:pt idx="383">
                  <c:v>1.75</c:v>
                </c:pt>
                <c:pt idx="384">
                  <c:v>3.25</c:v>
                </c:pt>
                <c:pt idx="385">
                  <c:v>3.5</c:v>
                </c:pt>
                <c:pt idx="386">
                  <c:v>2.75</c:v>
                </c:pt>
                <c:pt idx="387">
                  <c:v>5.75</c:v>
                </c:pt>
                <c:pt idx="388">
                  <c:v>1072.25</c:v>
                </c:pt>
                <c:pt idx="389">
                  <c:v>1.25</c:v>
                </c:pt>
                <c:pt idx="390">
                  <c:v>2.25</c:v>
                </c:pt>
                <c:pt idx="391">
                  <c:v>1.75</c:v>
                </c:pt>
                <c:pt idx="392">
                  <c:v>3.25</c:v>
                </c:pt>
                <c:pt idx="393">
                  <c:v>3</c:v>
                </c:pt>
                <c:pt idx="394">
                  <c:v>2</c:v>
                </c:pt>
                <c:pt idx="395">
                  <c:v>4.25</c:v>
                </c:pt>
                <c:pt idx="396">
                  <c:v>11.5</c:v>
                </c:pt>
                <c:pt idx="397">
                  <c:v>3.25</c:v>
                </c:pt>
                <c:pt idx="398">
                  <c:v>4.25</c:v>
                </c:pt>
                <c:pt idx="399">
                  <c:v>2.5</c:v>
                </c:pt>
                <c:pt idx="400">
                  <c:v>2.25</c:v>
                </c:pt>
                <c:pt idx="401">
                  <c:v>2.5</c:v>
                </c:pt>
                <c:pt idx="402">
                  <c:v>1.5</c:v>
                </c:pt>
                <c:pt idx="403">
                  <c:v>8</c:v>
                </c:pt>
                <c:pt idx="404">
                  <c:v>5.25</c:v>
                </c:pt>
                <c:pt idx="405">
                  <c:v>1.5</c:v>
                </c:pt>
                <c:pt idx="406">
                  <c:v>2</c:v>
                </c:pt>
                <c:pt idx="407">
                  <c:v>1.75</c:v>
                </c:pt>
                <c:pt idx="408">
                  <c:v>10.5</c:v>
                </c:pt>
                <c:pt idx="409">
                  <c:v>3</c:v>
                </c:pt>
                <c:pt idx="410">
                  <c:v>5</c:v>
                </c:pt>
                <c:pt idx="411">
                  <c:v>8.5</c:v>
                </c:pt>
                <c:pt idx="412">
                  <c:v>16.5</c:v>
                </c:pt>
                <c:pt idx="413">
                  <c:v>3.25</c:v>
                </c:pt>
                <c:pt idx="414">
                  <c:v>5.5</c:v>
                </c:pt>
                <c:pt idx="415">
                  <c:v>0.75</c:v>
                </c:pt>
                <c:pt idx="416">
                  <c:v>3</c:v>
                </c:pt>
                <c:pt idx="417">
                  <c:v>2.5</c:v>
                </c:pt>
                <c:pt idx="418">
                  <c:v>410.75</c:v>
                </c:pt>
                <c:pt idx="419">
                  <c:v>4.75</c:v>
                </c:pt>
                <c:pt idx="420">
                  <c:v>7.5</c:v>
                </c:pt>
                <c:pt idx="421">
                  <c:v>3</c:v>
                </c:pt>
                <c:pt idx="422">
                  <c:v>2.25</c:v>
                </c:pt>
                <c:pt idx="423">
                  <c:v>2</c:v>
                </c:pt>
                <c:pt idx="424">
                  <c:v>2.75</c:v>
                </c:pt>
                <c:pt idx="425">
                  <c:v>1.5</c:v>
                </c:pt>
                <c:pt idx="426">
                  <c:v>2.25</c:v>
                </c:pt>
                <c:pt idx="427">
                  <c:v>1.75</c:v>
                </c:pt>
                <c:pt idx="428">
                  <c:v>2.75</c:v>
                </c:pt>
                <c:pt idx="429">
                  <c:v>2.5</c:v>
                </c:pt>
                <c:pt idx="430">
                  <c:v>3</c:v>
                </c:pt>
                <c:pt idx="431">
                  <c:v>2.25</c:v>
                </c:pt>
                <c:pt idx="432">
                  <c:v>9</c:v>
                </c:pt>
                <c:pt idx="433">
                  <c:v>3.5</c:v>
                </c:pt>
                <c:pt idx="434">
                  <c:v>2</c:v>
                </c:pt>
                <c:pt idx="435">
                  <c:v>4</c:v>
                </c:pt>
                <c:pt idx="436">
                  <c:v>4.75</c:v>
                </c:pt>
                <c:pt idx="437">
                  <c:v>206.75</c:v>
                </c:pt>
                <c:pt idx="438">
                  <c:v>10.75</c:v>
                </c:pt>
                <c:pt idx="439">
                  <c:v>4</c:v>
                </c:pt>
                <c:pt idx="440">
                  <c:v>2.5</c:v>
                </c:pt>
                <c:pt idx="441">
                  <c:v>2</c:v>
                </c:pt>
                <c:pt idx="442">
                  <c:v>2.5</c:v>
                </c:pt>
                <c:pt idx="443">
                  <c:v>1.25</c:v>
                </c:pt>
                <c:pt idx="444">
                  <c:v>7.75</c:v>
                </c:pt>
                <c:pt idx="445">
                  <c:v>10</c:v>
                </c:pt>
                <c:pt idx="446">
                  <c:v>2.75</c:v>
                </c:pt>
                <c:pt idx="447">
                  <c:v>4.75</c:v>
                </c:pt>
                <c:pt idx="448">
                  <c:v>3.5</c:v>
                </c:pt>
                <c:pt idx="449">
                  <c:v>2</c:v>
                </c:pt>
                <c:pt idx="450">
                  <c:v>3.5</c:v>
                </c:pt>
                <c:pt idx="451">
                  <c:v>2.75</c:v>
                </c:pt>
                <c:pt idx="452">
                  <c:v>1.75</c:v>
                </c:pt>
                <c:pt idx="453">
                  <c:v>2.25</c:v>
                </c:pt>
                <c:pt idx="454">
                  <c:v>1.75</c:v>
                </c:pt>
                <c:pt idx="455">
                  <c:v>1.25</c:v>
                </c:pt>
                <c:pt idx="456">
                  <c:v>3</c:v>
                </c:pt>
                <c:pt idx="457">
                  <c:v>2.5</c:v>
                </c:pt>
                <c:pt idx="458">
                  <c:v>1.25</c:v>
                </c:pt>
                <c:pt idx="459">
                  <c:v>2.5</c:v>
                </c:pt>
                <c:pt idx="460">
                  <c:v>2.5</c:v>
                </c:pt>
                <c:pt idx="461">
                  <c:v>3.25</c:v>
                </c:pt>
                <c:pt idx="462">
                  <c:v>5.25</c:v>
                </c:pt>
                <c:pt idx="463">
                  <c:v>2.75</c:v>
                </c:pt>
                <c:pt idx="464">
                  <c:v>9.5</c:v>
                </c:pt>
                <c:pt idx="465">
                  <c:v>5</c:v>
                </c:pt>
                <c:pt idx="466">
                  <c:v>4.5</c:v>
                </c:pt>
                <c:pt idx="467">
                  <c:v>6.25</c:v>
                </c:pt>
                <c:pt idx="468">
                  <c:v>1</c:v>
                </c:pt>
                <c:pt idx="469">
                  <c:v>17</c:v>
                </c:pt>
                <c:pt idx="470">
                  <c:v>2.5</c:v>
                </c:pt>
                <c:pt idx="471">
                  <c:v>3.5</c:v>
                </c:pt>
                <c:pt idx="472">
                  <c:v>1.25</c:v>
                </c:pt>
                <c:pt idx="473">
                  <c:v>3.75</c:v>
                </c:pt>
                <c:pt idx="474">
                  <c:v>3.25</c:v>
                </c:pt>
                <c:pt idx="475">
                  <c:v>5</c:v>
                </c:pt>
                <c:pt idx="476">
                  <c:v>11</c:v>
                </c:pt>
                <c:pt idx="477">
                  <c:v>3.75</c:v>
                </c:pt>
                <c:pt idx="478">
                  <c:v>3</c:v>
                </c:pt>
                <c:pt idx="479">
                  <c:v>2</c:v>
                </c:pt>
                <c:pt idx="480">
                  <c:v>3</c:v>
                </c:pt>
                <c:pt idx="481">
                  <c:v>3.25</c:v>
                </c:pt>
                <c:pt idx="482">
                  <c:v>2.25</c:v>
                </c:pt>
                <c:pt idx="483">
                  <c:v>5</c:v>
                </c:pt>
                <c:pt idx="484">
                  <c:v>12.75</c:v>
                </c:pt>
                <c:pt idx="485">
                  <c:v>4</c:v>
                </c:pt>
                <c:pt idx="486">
                  <c:v>1.75</c:v>
                </c:pt>
                <c:pt idx="487">
                  <c:v>6.75</c:v>
                </c:pt>
                <c:pt idx="488">
                  <c:v>3.25</c:v>
                </c:pt>
                <c:pt idx="489">
                  <c:v>1.75</c:v>
                </c:pt>
                <c:pt idx="490">
                  <c:v>3.75</c:v>
                </c:pt>
                <c:pt idx="491">
                  <c:v>5.5</c:v>
                </c:pt>
                <c:pt idx="492">
                  <c:v>9.75</c:v>
                </c:pt>
                <c:pt idx="493">
                  <c:v>3.75</c:v>
                </c:pt>
                <c:pt idx="494">
                  <c:v>2.5</c:v>
                </c:pt>
                <c:pt idx="495">
                  <c:v>2.5</c:v>
                </c:pt>
                <c:pt idx="496">
                  <c:v>4.5</c:v>
                </c:pt>
                <c:pt idx="497">
                  <c:v>6</c:v>
                </c:pt>
                <c:pt idx="498">
                  <c:v>1.75</c:v>
                </c:pt>
                <c:pt idx="499">
                  <c:v>1.5</c:v>
                </c:pt>
                <c:pt idx="500">
                  <c:v>2.5</c:v>
                </c:pt>
                <c:pt idx="501">
                  <c:v>2.25</c:v>
                </c:pt>
                <c:pt idx="502">
                  <c:v>3</c:v>
                </c:pt>
                <c:pt idx="503">
                  <c:v>2.5</c:v>
                </c:pt>
                <c:pt idx="504">
                  <c:v>1.5</c:v>
                </c:pt>
                <c:pt idx="505">
                  <c:v>2.75</c:v>
                </c:pt>
                <c:pt idx="506">
                  <c:v>2.75</c:v>
                </c:pt>
                <c:pt idx="507">
                  <c:v>18.75</c:v>
                </c:pt>
                <c:pt idx="508">
                  <c:v>2.75</c:v>
                </c:pt>
                <c:pt idx="509">
                  <c:v>1.75</c:v>
                </c:pt>
                <c:pt idx="510">
                  <c:v>1.75</c:v>
                </c:pt>
                <c:pt idx="511">
                  <c:v>2.25</c:v>
                </c:pt>
                <c:pt idx="512">
                  <c:v>1.75</c:v>
                </c:pt>
                <c:pt idx="513">
                  <c:v>1.75</c:v>
                </c:pt>
                <c:pt idx="514">
                  <c:v>1.75</c:v>
                </c:pt>
                <c:pt idx="515">
                  <c:v>2.25</c:v>
                </c:pt>
                <c:pt idx="516">
                  <c:v>2.5</c:v>
                </c:pt>
                <c:pt idx="517">
                  <c:v>1.25</c:v>
                </c:pt>
                <c:pt idx="518">
                  <c:v>1</c:v>
                </c:pt>
                <c:pt idx="519">
                  <c:v>2.25</c:v>
                </c:pt>
                <c:pt idx="520">
                  <c:v>1.25</c:v>
                </c:pt>
                <c:pt idx="521">
                  <c:v>2.25</c:v>
                </c:pt>
                <c:pt idx="522">
                  <c:v>2.5</c:v>
                </c:pt>
                <c:pt idx="523">
                  <c:v>2.75</c:v>
                </c:pt>
                <c:pt idx="524">
                  <c:v>9.5</c:v>
                </c:pt>
                <c:pt idx="525">
                  <c:v>428</c:v>
                </c:pt>
                <c:pt idx="526">
                  <c:v>2.25</c:v>
                </c:pt>
                <c:pt idx="527">
                  <c:v>1.75</c:v>
                </c:pt>
                <c:pt idx="528">
                  <c:v>1.5</c:v>
                </c:pt>
                <c:pt idx="529">
                  <c:v>8.5</c:v>
                </c:pt>
                <c:pt idx="530">
                  <c:v>18.25</c:v>
                </c:pt>
                <c:pt idx="531">
                  <c:v>1.75</c:v>
                </c:pt>
                <c:pt idx="532">
                  <c:v>1.5</c:v>
                </c:pt>
                <c:pt idx="533">
                  <c:v>4.75</c:v>
                </c:pt>
                <c:pt idx="534">
                  <c:v>22</c:v>
                </c:pt>
                <c:pt idx="535">
                  <c:v>2.5</c:v>
                </c:pt>
                <c:pt idx="536">
                  <c:v>8.75</c:v>
                </c:pt>
                <c:pt idx="537">
                  <c:v>4</c:v>
                </c:pt>
                <c:pt idx="538">
                  <c:v>1.5</c:v>
                </c:pt>
                <c:pt idx="539">
                  <c:v>1.25</c:v>
                </c:pt>
                <c:pt idx="540">
                  <c:v>3.5</c:v>
                </c:pt>
                <c:pt idx="541">
                  <c:v>0.5</c:v>
                </c:pt>
                <c:pt idx="542">
                  <c:v>3</c:v>
                </c:pt>
                <c:pt idx="543">
                  <c:v>1</c:v>
                </c:pt>
                <c:pt idx="544">
                  <c:v>10.75</c:v>
                </c:pt>
                <c:pt idx="545">
                  <c:v>16.5</c:v>
                </c:pt>
                <c:pt idx="546">
                  <c:v>8.75</c:v>
                </c:pt>
                <c:pt idx="547">
                  <c:v>2</c:v>
                </c:pt>
                <c:pt idx="548">
                  <c:v>2</c:v>
                </c:pt>
                <c:pt idx="549">
                  <c:v>2.25</c:v>
                </c:pt>
                <c:pt idx="550">
                  <c:v>6.5</c:v>
                </c:pt>
                <c:pt idx="551">
                  <c:v>9</c:v>
                </c:pt>
                <c:pt idx="552">
                  <c:v>3</c:v>
                </c:pt>
                <c:pt idx="553">
                  <c:v>5.25</c:v>
                </c:pt>
                <c:pt idx="554">
                  <c:v>2</c:v>
                </c:pt>
                <c:pt idx="555">
                  <c:v>2.25</c:v>
                </c:pt>
                <c:pt idx="556">
                  <c:v>7.5</c:v>
                </c:pt>
                <c:pt idx="557">
                  <c:v>11.75</c:v>
                </c:pt>
                <c:pt idx="558">
                  <c:v>2.25</c:v>
                </c:pt>
                <c:pt idx="559">
                  <c:v>4.75</c:v>
                </c:pt>
                <c:pt idx="560">
                  <c:v>9.25</c:v>
                </c:pt>
                <c:pt idx="561">
                  <c:v>10</c:v>
                </c:pt>
                <c:pt idx="562">
                  <c:v>9.25</c:v>
                </c:pt>
                <c:pt idx="563">
                  <c:v>5.25</c:v>
                </c:pt>
                <c:pt idx="564">
                  <c:v>5.75</c:v>
                </c:pt>
                <c:pt idx="565">
                  <c:v>24.5</c:v>
                </c:pt>
                <c:pt idx="566">
                  <c:v>1.5</c:v>
                </c:pt>
                <c:pt idx="567">
                  <c:v>1.5</c:v>
                </c:pt>
                <c:pt idx="568">
                  <c:v>2</c:v>
                </c:pt>
                <c:pt idx="569">
                  <c:v>16</c:v>
                </c:pt>
                <c:pt idx="570">
                  <c:v>2.75</c:v>
                </c:pt>
                <c:pt idx="571">
                  <c:v>2</c:v>
                </c:pt>
                <c:pt idx="572">
                  <c:v>1.5</c:v>
                </c:pt>
                <c:pt idx="573">
                  <c:v>1.5</c:v>
                </c:pt>
                <c:pt idx="574">
                  <c:v>1.75</c:v>
                </c:pt>
                <c:pt idx="575">
                  <c:v>3</c:v>
                </c:pt>
                <c:pt idx="576">
                  <c:v>2.5</c:v>
                </c:pt>
                <c:pt idx="577">
                  <c:v>4.25</c:v>
                </c:pt>
                <c:pt idx="578">
                  <c:v>2</c:v>
                </c:pt>
                <c:pt idx="579">
                  <c:v>1.75</c:v>
                </c:pt>
                <c:pt idx="580">
                  <c:v>14.5</c:v>
                </c:pt>
                <c:pt idx="581">
                  <c:v>13.25</c:v>
                </c:pt>
                <c:pt idx="582">
                  <c:v>4.25</c:v>
                </c:pt>
                <c:pt idx="583">
                  <c:v>11.75</c:v>
                </c:pt>
                <c:pt idx="584">
                  <c:v>2.25</c:v>
                </c:pt>
              </c:numCache>
            </c:numRef>
          </c:val>
          <c:extLst>
            <c:ext xmlns:c16="http://schemas.microsoft.com/office/drawing/2014/chart" uri="{C3380CC4-5D6E-409C-BE32-E72D297353CC}">
              <c16:uniqueId val="{00000000-BCC8-4631-A9AA-6AF3FB751F68}"/>
            </c:ext>
          </c:extLst>
        </c:ser>
        <c:dLbls>
          <c:showLegendKey val="0"/>
          <c:showVal val="0"/>
          <c:showCatName val="0"/>
          <c:showSerName val="0"/>
          <c:showPercent val="0"/>
          <c:showBubbleSize val="0"/>
        </c:dLbls>
        <c:gapWidth val="300"/>
        <c:axId val="2114370344"/>
        <c:axId val="2114375848"/>
      </c:barChart>
      <c:catAx>
        <c:axId val="2114370344"/>
        <c:scaling>
          <c:orientation val="minMax"/>
        </c:scaling>
        <c:delete val="0"/>
        <c:axPos val="b"/>
        <c:title>
          <c:tx>
            <c:rich>
              <a:bodyPr/>
              <a:lstStyle/>
              <a:p>
                <a:pPr>
                  <a:defRPr/>
                </a:pPr>
                <a:r>
                  <a:rPr lang="en-US" dirty="0"/>
                  <a:t>Glycan ID</a:t>
                </a:r>
              </a:p>
            </c:rich>
          </c:tx>
          <c:overlay val="0"/>
        </c:title>
        <c:numFmt formatCode="General" sourceLinked="1"/>
        <c:majorTickMark val="out"/>
        <c:minorTickMark val="none"/>
        <c:tickLblPos val="nextTo"/>
        <c:spPr>
          <a:effectLst/>
        </c:spPr>
        <c:txPr>
          <a:bodyPr rot="-5400000" vert="horz"/>
          <a:lstStyle/>
          <a:p>
            <a:pPr>
              <a:defRPr sz="1050"/>
            </a:pPr>
            <a:endParaRPr lang="en-US"/>
          </a:p>
        </c:txPr>
        <c:crossAx val="2114375848"/>
        <c:crosses val="autoZero"/>
        <c:auto val="1"/>
        <c:lblAlgn val="ctr"/>
        <c:lblOffset val="100"/>
        <c:tickLblSkip val="20"/>
        <c:noMultiLvlLbl val="0"/>
      </c:catAx>
      <c:valAx>
        <c:axId val="2114375848"/>
        <c:scaling>
          <c:orientation val="minMax"/>
          <c:min val="0"/>
        </c:scaling>
        <c:delete val="0"/>
        <c:axPos val="l"/>
        <c:majorGridlines/>
        <c:title>
          <c:tx>
            <c:rich>
              <a:bodyPr rot="-5400000" vert="horz"/>
              <a:lstStyle/>
              <a:p>
                <a:pPr>
                  <a:defRPr/>
                </a:pPr>
                <a:r>
                  <a:rPr lang="en-US"/>
                  <a:t>Average RFU</a:t>
                </a:r>
              </a:p>
            </c:rich>
          </c:tx>
          <c:overlay val="0"/>
        </c:title>
        <c:numFmt formatCode="0" sourceLinked="1"/>
        <c:majorTickMark val="out"/>
        <c:minorTickMark val="none"/>
        <c:tickLblPos val="nextTo"/>
        <c:spPr>
          <a:effectLst/>
        </c:spPr>
        <c:txPr>
          <a:bodyPr/>
          <a:lstStyle/>
          <a:p>
            <a:pPr>
              <a:defRPr sz="1200"/>
            </a:pPr>
            <a:endParaRPr lang="en-US"/>
          </a:p>
        </c:txPr>
        <c:crossAx val="2114370344"/>
        <c:crosses val="autoZero"/>
        <c:crossBetween val="between"/>
      </c:valAx>
      <c:spPr>
        <a:noFill/>
        <a:ln w="3175">
          <a:solidFill>
            <a:srgbClr val="000000"/>
          </a:solidFill>
          <a:prstDash val="solid"/>
        </a:ln>
      </c:spPr>
    </c:plotArea>
    <c:plotVisOnly val="1"/>
    <c:dispBlanksAs val="gap"/>
    <c:showDLblsOverMax val="0"/>
  </c:chart>
  <c:txPr>
    <a:bodyPr/>
    <a:lstStyle/>
    <a:p>
      <a:pPr>
        <a:defRPr sz="1400">
          <a:latin typeface="Arial" panose="020B0604020202020204" pitchFamily="34" charset="0"/>
          <a:cs typeface="Arial" panose="020B0604020202020204" pitchFamily="34" charset="0"/>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EBF3070-D26A-4018-A9E7-8861EB58D05D}" type="datetimeFigureOut">
              <a:rPr lang="en-GB" smtClean="0"/>
              <a:t>17/04/2020</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8B402B-D850-4F71-8A3C-4B6670D6060A}" type="slidenum">
              <a:rPr lang="en-GB" smtClean="0"/>
              <a:t>‹#›</a:t>
            </a:fld>
            <a:endParaRPr lang="en-GB"/>
          </a:p>
        </p:txBody>
      </p:sp>
    </p:spTree>
    <p:extLst>
      <p:ext uri="{BB962C8B-B14F-4D97-AF65-F5344CB8AC3E}">
        <p14:creationId xmlns:p14="http://schemas.microsoft.com/office/powerpoint/2010/main" val="5322957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sz="1200" kern="1200" dirty="0">
              <a:solidFill>
                <a:schemeClr val="tx1"/>
              </a:solidFill>
              <a:effectLst/>
              <a:latin typeface="+mn-lt"/>
              <a:ea typeface="+mn-ea"/>
              <a:cs typeface="+mn-cs"/>
            </a:endParaRPr>
          </a:p>
          <a:p>
            <a:r>
              <a:rPr lang="en-GB" sz="1200" b="1" kern="1200" dirty="0">
                <a:solidFill>
                  <a:schemeClr val="tx1"/>
                </a:solidFill>
                <a:effectLst/>
                <a:latin typeface="+mn-lt"/>
                <a:ea typeface="+mn-ea"/>
                <a:cs typeface="+mn-cs"/>
              </a:rPr>
              <a:t>A.</a:t>
            </a:r>
            <a:r>
              <a:rPr lang="en-GB" sz="1200" kern="1200" dirty="0">
                <a:solidFill>
                  <a:schemeClr val="tx1"/>
                </a:solidFill>
                <a:effectLst/>
                <a:latin typeface="+mn-lt"/>
                <a:ea typeface="+mn-ea"/>
                <a:cs typeface="+mn-cs"/>
              </a:rPr>
              <a:t>  β-fucose in the E1_10125 wild-type binding site. The yellow, green and magenta meshes represent the </a:t>
            </a:r>
            <a:r>
              <a:rPr lang="en-GB" sz="1200" kern="1200" dirty="0" err="1">
                <a:solidFill>
                  <a:schemeClr val="tx1"/>
                </a:solidFill>
                <a:effectLst/>
                <a:latin typeface="+mn-lt"/>
                <a:ea typeface="+mn-ea"/>
                <a:cs typeface="+mn-cs"/>
              </a:rPr>
              <a:t>Fo</a:t>
            </a:r>
            <a:r>
              <a:rPr lang="en-GB" sz="1200" kern="1200" dirty="0">
                <a:solidFill>
                  <a:schemeClr val="tx1"/>
                </a:solidFill>
                <a:effectLst/>
                <a:latin typeface="+mn-lt"/>
                <a:ea typeface="+mn-ea"/>
                <a:cs typeface="+mn-cs"/>
              </a:rPr>
              <a:t>-Fc difference maps at σ levels of 2, 3 and 5 respectively. </a:t>
            </a:r>
            <a:r>
              <a:rPr lang="en-GB" sz="1200" b="1" kern="1200" dirty="0">
                <a:solidFill>
                  <a:schemeClr val="tx1"/>
                </a:solidFill>
                <a:effectLst/>
                <a:latin typeface="+mn-lt"/>
                <a:ea typeface="+mn-ea"/>
                <a:cs typeface="+mn-cs"/>
              </a:rPr>
              <a:t>B.</a:t>
            </a:r>
            <a:r>
              <a:rPr lang="en-GB" sz="1200" kern="1200" dirty="0">
                <a:solidFill>
                  <a:schemeClr val="tx1"/>
                </a:solidFill>
                <a:effectLst/>
                <a:latin typeface="+mn-lt"/>
                <a:ea typeface="+mn-ea"/>
                <a:cs typeface="+mn-cs"/>
              </a:rPr>
              <a:t> Electron density is present for both α-fucose and β-fucose in the E1_10125 D221A mutant. </a:t>
            </a:r>
            <a:r>
              <a:rPr lang="en-GB" sz="1200" kern="1200" dirty="0" err="1">
                <a:solidFill>
                  <a:schemeClr val="tx1"/>
                </a:solidFill>
                <a:effectLst/>
                <a:latin typeface="+mn-lt"/>
                <a:ea typeface="+mn-ea"/>
                <a:cs typeface="+mn-cs"/>
              </a:rPr>
              <a:t>Fo</a:t>
            </a:r>
            <a:r>
              <a:rPr lang="en-GB" sz="1200" kern="1200" dirty="0">
                <a:solidFill>
                  <a:schemeClr val="tx1"/>
                </a:solidFill>
                <a:effectLst/>
                <a:latin typeface="+mn-lt"/>
                <a:ea typeface="+mn-ea"/>
                <a:cs typeface="+mn-cs"/>
              </a:rPr>
              <a:t>-Fc difference maps are coloured as above. </a:t>
            </a:r>
            <a:r>
              <a:rPr lang="en-GB" sz="1200" b="1" kern="1200" dirty="0">
                <a:solidFill>
                  <a:schemeClr val="tx1"/>
                </a:solidFill>
                <a:effectLst/>
                <a:latin typeface="+mn-lt"/>
                <a:ea typeface="+mn-ea"/>
                <a:cs typeface="+mn-cs"/>
              </a:rPr>
              <a:t>C.</a:t>
            </a:r>
            <a:r>
              <a:rPr lang="en-GB" sz="1200" b="0" i="0" u="none" strike="noStrike" kern="1200" baseline="0" dirty="0">
                <a:solidFill>
                  <a:schemeClr val="tx1"/>
                </a:solidFill>
                <a:latin typeface="+mn-lt"/>
                <a:ea typeface="+mn-ea"/>
                <a:cs typeface="+mn-cs"/>
              </a:rPr>
              <a:t> Complex between </a:t>
            </a:r>
            <a:r>
              <a:rPr lang="en-GB" sz="1200" b="0" i="1" u="none" strike="noStrike" kern="1200" baseline="0" dirty="0">
                <a:solidFill>
                  <a:schemeClr val="tx1"/>
                </a:solidFill>
                <a:latin typeface="+mn-lt"/>
                <a:ea typeface="+mn-ea"/>
                <a:cs typeface="+mn-cs"/>
              </a:rPr>
              <a:t>B. </a:t>
            </a:r>
            <a:r>
              <a:rPr lang="en-GB" sz="1200" b="0" i="1" u="none" strike="noStrike" kern="1200" baseline="0" dirty="0" err="1">
                <a:solidFill>
                  <a:schemeClr val="tx1"/>
                </a:solidFill>
                <a:latin typeface="+mn-lt"/>
                <a:ea typeface="+mn-ea"/>
                <a:cs typeface="+mn-cs"/>
              </a:rPr>
              <a:t>longum</a:t>
            </a:r>
            <a:r>
              <a:rPr lang="en-GB" sz="1200" b="0" i="1" u="none" strike="noStrike" kern="1200" baseline="0" dirty="0">
                <a:solidFill>
                  <a:schemeClr val="tx1"/>
                </a:solidFill>
                <a:latin typeface="+mn-lt"/>
                <a:ea typeface="+mn-ea"/>
                <a:cs typeface="+mn-cs"/>
              </a:rPr>
              <a:t> </a:t>
            </a:r>
            <a:r>
              <a:rPr lang="en-GB" sz="1200" b="0" i="0" u="none" strike="noStrike" kern="1200" baseline="0" dirty="0">
                <a:solidFill>
                  <a:schemeClr val="tx1"/>
                </a:solidFill>
                <a:latin typeface="+mn-lt"/>
                <a:ea typeface="+mn-ea"/>
                <a:cs typeface="+mn-cs"/>
              </a:rPr>
              <a:t>subsp. </a:t>
            </a:r>
            <a:r>
              <a:rPr lang="en-GB" sz="1200" b="0" i="0" u="none" strike="noStrike" kern="1200" baseline="0" dirty="0" err="1">
                <a:solidFill>
                  <a:schemeClr val="tx1"/>
                </a:solidFill>
                <a:latin typeface="+mn-lt"/>
                <a:ea typeface="+mn-ea"/>
                <a:cs typeface="+mn-cs"/>
              </a:rPr>
              <a:t>infantis</a:t>
            </a:r>
            <a:r>
              <a:rPr lang="en-GB" sz="1200" b="0" i="0" u="none" strike="noStrike" kern="1200" baseline="0" dirty="0">
                <a:solidFill>
                  <a:schemeClr val="tx1"/>
                </a:solidFill>
                <a:latin typeface="+mn-lt"/>
                <a:ea typeface="+mn-ea"/>
                <a:cs typeface="+mn-cs"/>
              </a:rPr>
              <a:t> GH29 fucosidase and </a:t>
            </a:r>
            <a:r>
              <a:rPr lang="en-GB" sz="1200" b="0" i="0" u="none" strike="noStrike" kern="1200" baseline="0" dirty="0" err="1">
                <a:solidFill>
                  <a:schemeClr val="tx1"/>
                </a:solidFill>
                <a:latin typeface="+mn-lt"/>
                <a:ea typeface="+mn-ea"/>
                <a:cs typeface="+mn-cs"/>
              </a:rPr>
              <a:t>LeA</a:t>
            </a:r>
            <a:r>
              <a:rPr lang="en-GB" sz="1200" b="0" i="0" u="none" strike="noStrike" kern="1200" baseline="0" dirty="0">
                <a:solidFill>
                  <a:schemeClr val="tx1"/>
                </a:solidFill>
                <a:latin typeface="+mn-lt"/>
                <a:ea typeface="+mn-ea"/>
                <a:cs typeface="+mn-cs"/>
              </a:rPr>
              <a:t> (pdb: 3UET). </a:t>
            </a:r>
            <a:r>
              <a:rPr lang="en-GB" sz="1200" b="0" i="0" u="none" strike="noStrike" kern="1200" baseline="0" dirty="0" err="1">
                <a:solidFill>
                  <a:schemeClr val="tx1"/>
                </a:solidFill>
                <a:latin typeface="+mn-lt"/>
                <a:ea typeface="+mn-ea"/>
                <a:cs typeface="+mn-cs"/>
              </a:rPr>
              <a:t>Fuc</a:t>
            </a:r>
            <a:r>
              <a:rPr lang="en-GB" sz="1200" b="0" i="0" u="none" strike="noStrike" kern="1200" baseline="0" dirty="0">
                <a:solidFill>
                  <a:schemeClr val="tx1"/>
                </a:solidFill>
                <a:latin typeface="+mn-lt"/>
                <a:ea typeface="+mn-ea"/>
                <a:cs typeface="+mn-cs"/>
              </a:rPr>
              <a:t> is shown in yellow, </a:t>
            </a:r>
            <a:r>
              <a:rPr lang="en-GB" sz="1200" b="0" i="0" u="none" strike="noStrike" kern="1200" baseline="0" dirty="0" err="1">
                <a:solidFill>
                  <a:schemeClr val="tx1"/>
                </a:solidFill>
                <a:latin typeface="+mn-lt"/>
                <a:ea typeface="+mn-ea"/>
                <a:cs typeface="+mn-cs"/>
              </a:rPr>
              <a:t>GlcNAc</a:t>
            </a:r>
            <a:r>
              <a:rPr lang="en-GB" sz="1200" b="0" i="0" u="none" strike="noStrike" kern="1200" baseline="0" dirty="0">
                <a:solidFill>
                  <a:schemeClr val="tx1"/>
                </a:solidFill>
                <a:latin typeface="+mn-lt"/>
                <a:ea typeface="+mn-ea"/>
                <a:cs typeface="+mn-cs"/>
              </a:rPr>
              <a:t> in cyan and Gal in orange. Residues that interact with the Gal residue and nearby residues that may impede binding of sialylated substrates are represented as sticks. Dashed black lines indicate hydrogen-bonding interactions. Residue identifiers refer to the wild type sequence. </a:t>
            </a:r>
            <a:r>
              <a:rPr lang="en-GB" sz="1200" b="1" i="0" u="none" strike="noStrike" kern="1200" baseline="0" dirty="0">
                <a:solidFill>
                  <a:schemeClr val="tx1"/>
                </a:solidFill>
                <a:latin typeface="+mn-lt"/>
                <a:ea typeface="+mn-ea"/>
                <a:cs typeface="+mn-cs"/>
              </a:rPr>
              <a:t>D. </a:t>
            </a:r>
            <a:r>
              <a:rPr lang="en-GB" sz="1200" b="0" i="0" u="none" strike="noStrike" kern="1200" baseline="0" dirty="0">
                <a:solidFill>
                  <a:schemeClr val="tx1"/>
                </a:solidFill>
                <a:latin typeface="+mn-lt"/>
                <a:ea typeface="+mn-ea"/>
                <a:cs typeface="+mn-cs"/>
              </a:rPr>
              <a:t>Complex between </a:t>
            </a:r>
            <a:r>
              <a:rPr lang="en-GB" sz="1200" b="0" i="1" u="none" strike="noStrike" kern="1200" baseline="0" dirty="0">
                <a:solidFill>
                  <a:schemeClr val="tx1"/>
                </a:solidFill>
                <a:latin typeface="+mn-lt"/>
                <a:ea typeface="+mn-ea"/>
                <a:cs typeface="+mn-cs"/>
              </a:rPr>
              <a:t>S. pneumoniae </a:t>
            </a:r>
            <a:r>
              <a:rPr lang="en-GB" sz="1200" b="0" i="0" u="none" strike="noStrike" kern="1200" baseline="0" dirty="0">
                <a:solidFill>
                  <a:schemeClr val="tx1"/>
                </a:solidFill>
                <a:latin typeface="+mn-lt"/>
                <a:ea typeface="+mn-ea"/>
                <a:cs typeface="+mn-cs"/>
              </a:rPr>
              <a:t>GH29 fucosidase and </a:t>
            </a:r>
            <a:r>
              <a:rPr lang="en-GB" sz="1200" b="0" i="0" u="none" strike="noStrike" kern="1200" baseline="0" dirty="0" err="1">
                <a:solidFill>
                  <a:schemeClr val="tx1"/>
                </a:solidFill>
                <a:latin typeface="+mn-lt"/>
                <a:ea typeface="+mn-ea"/>
                <a:cs typeface="+mn-cs"/>
              </a:rPr>
              <a:t>LeA</a:t>
            </a:r>
            <a:r>
              <a:rPr lang="en-GB" sz="1200" b="0" i="0" u="none" strike="noStrike" kern="1200" baseline="0" dirty="0">
                <a:solidFill>
                  <a:schemeClr val="tx1"/>
                </a:solidFill>
                <a:latin typeface="+mn-lt"/>
                <a:ea typeface="+mn-ea"/>
                <a:cs typeface="+mn-cs"/>
              </a:rPr>
              <a:t> (pdb: 60R4). </a:t>
            </a:r>
            <a:r>
              <a:rPr lang="en-GB" sz="1200" b="1" i="0" u="none" strike="noStrike" kern="1200" baseline="0" dirty="0">
                <a:solidFill>
                  <a:schemeClr val="tx1"/>
                </a:solidFill>
                <a:latin typeface="+mn-lt"/>
                <a:ea typeface="+mn-ea"/>
                <a:cs typeface="+mn-cs"/>
              </a:rPr>
              <a:t>E. </a:t>
            </a:r>
            <a:r>
              <a:rPr lang="en-GB" sz="1200" b="0" i="0" u="none" strike="noStrike" kern="1200" baseline="0" dirty="0">
                <a:solidFill>
                  <a:schemeClr val="tx1"/>
                </a:solidFill>
                <a:latin typeface="+mn-lt"/>
                <a:ea typeface="+mn-ea"/>
                <a:cs typeface="+mn-cs"/>
              </a:rPr>
              <a:t>Complex between </a:t>
            </a:r>
            <a:r>
              <a:rPr lang="en-GB" sz="1200" b="0" i="1" u="none" strike="noStrike" kern="1200" baseline="0" dirty="0">
                <a:solidFill>
                  <a:schemeClr val="tx1"/>
                </a:solidFill>
                <a:latin typeface="+mn-lt"/>
                <a:ea typeface="+mn-ea"/>
                <a:cs typeface="+mn-cs"/>
              </a:rPr>
              <a:t>S. pneumoniae </a:t>
            </a:r>
            <a:r>
              <a:rPr lang="en-GB" sz="1200" b="0" i="0" u="none" strike="noStrike" kern="1200" baseline="0" dirty="0">
                <a:solidFill>
                  <a:schemeClr val="tx1"/>
                </a:solidFill>
                <a:latin typeface="+mn-lt"/>
                <a:ea typeface="+mn-ea"/>
                <a:cs typeface="+mn-cs"/>
              </a:rPr>
              <a:t>GH29 fucosidase (pdb: 60RF) and </a:t>
            </a:r>
            <a:r>
              <a:rPr lang="en-GB" sz="1200" b="0" i="0" u="none" strike="noStrike" kern="1200" baseline="0" dirty="0" err="1">
                <a:solidFill>
                  <a:schemeClr val="tx1"/>
                </a:solidFill>
                <a:latin typeface="+mn-lt"/>
                <a:ea typeface="+mn-ea"/>
                <a:cs typeface="+mn-cs"/>
              </a:rPr>
              <a:t>LeX</a:t>
            </a:r>
            <a:r>
              <a:rPr lang="en-GB" sz="1200" b="0" i="0" u="none" strike="noStrike" kern="1200" baseline="0" dirty="0">
                <a:solidFill>
                  <a:schemeClr val="tx1"/>
                </a:solidFill>
                <a:latin typeface="+mn-lt"/>
                <a:ea typeface="+mn-ea"/>
                <a:cs typeface="+mn-cs"/>
              </a:rPr>
              <a:t>. </a:t>
            </a:r>
            <a:r>
              <a:rPr lang="en-GB" sz="1200" b="1" i="0" u="none" strike="noStrike" kern="1200" baseline="0" dirty="0">
                <a:solidFill>
                  <a:schemeClr val="tx1"/>
                </a:solidFill>
                <a:latin typeface="+mn-lt"/>
                <a:ea typeface="+mn-ea"/>
                <a:cs typeface="+mn-cs"/>
              </a:rPr>
              <a:t>F. </a:t>
            </a:r>
            <a:r>
              <a:rPr lang="en-GB" sz="1200" b="0" i="0" u="none" strike="noStrike" kern="1200" baseline="0" dirty="0">
                <a:solidFill>
                  <a:schemeClr val="tx1"/>
                </a:solidFill>
                <a:latin typeface="+mn-lt"/>
                <a:ea typeface="+mn-ea"/>
                <a:cs typeface="+mn-cs"/>
              </a:rPr>
              <a:t> </a:t>
            </a:r>
            <a:r>
              <a:rPr lang="en-GB" sz="1200" b="0" i="1" u="none" strike="noStrike" kern="1200" baseline="0" dirty="0">
                <a:solidFill>
                  <a:schemeClr val="tx1"/>
                </a:solidFill>
                <a:latin typeface="+mn-lt"/>
                <a:ea typeface="+mn-ea"/>
                <a:cs typeface="+mn-cs"/>
              </a:rPr>
              <a:t>R. gnavus </a:t>
            </a:r>
            <a:r>
              <a:rPr lang="en-GB" sz="1200" b="0" i="0" u="none" strike="noStrike" kern="1200" baseline="0" dirty="0">
                <a:solidFill>
                  <a:schemeClr val="tx1"/>
                </a:solidFill>
                <a:latin typeface="+mn-lt"/>
                <a:ea typeface="+mn-ea"/>
                <a:cs typeface="+mn-cs"/>
              </a:rPr>
              <a:t>E1_10125 model in complex with </a:t>
            </a:r>
            <a:r>
              <a:rPr lang="en-GB" sz="1200" kern="1200" dirty="0">
                <a:solidFill>
                  <a:schemeClr val="tx1"/>
                </a:solidFill>
                <a:effectLst/>
                <a:latin typeface="+mn-lt"/>
                <a:ea typeface="+mn-ea"/>
                <a:cs typeface="+mn-cs"/>
              </a:rPr>
              <a:t>β-fucose. </a:t>
            </a:r>
            <a:r>
              <a:rPr lang="en-GB" sz="1200" b="1" i="0" u="none" strike="noStrike" kern="1200" baseline="0" dirty="0">
                <a:solidFill>
                  <a:schemeClr val="tx1"/>
                </a:solidFill>
                <a:effectLst/>
                <a:latin typeface="+mn-lt"/>
                <a:ea typeface="+mn-ea"/>
                <a:cs typeface="+mn-cs"/>
              </a:rPr>
              <a:t>G</a:t>
            </a:r>
            <a:r>
              <a:rPr lang="en-GB" sz="1200" b="1" i="0" u="none" strike="noStrike" kern="1200" baseline="0" dirty="0">
                <a:solidFill>
                  <a:schemeClr val="tx1"/>
                </a:solidFill>
                <a:latin typeface="+mn-lt"/>
                <a:ea typeface="+mn-ea"/>
                <a:cs typeface="+mn-cs"/>
              </a:rPr>
              <a:t>. </a:t>
            </a:r>
            <a:r>
              <a:rPr lang="en-GB" sz="1200" b="0" i="0" u="none" strike="noStrike" kern="1200" baseline="0" dirty="0">
                <a:solidFill>
                  <a:schemeClr val="tx1"/>
                </a:solidFill>
                <a:latin typeface="+mn-lt"/>
                <a:ea typeface="+mn-ea"/>
                <a:cs typeface="+mn-cs"/>
              </a:rPr>
              <a:t>Model of the orientation and conformation of </a:t>
            </a:r>
            <a:r>
              <a:rPr lang="en-GB" sz="1200" b="0" i="0" u="none" strike="noStrike" kern="1200" baseline="0" dirty="0" err="1">
                <a:solidFill>
                  <a:schemeClr val="tx1"/>
                </a:solidFill>
                <a:latin typeface="+mn-lt"/>
                <a:ea typeface="+mn-ea"/>
                <a:cs typeface="+mn-cs"/>
              </a:rPr>
              <a:t>sialyl-LeX</a:t>
            </a:r>
            <a:r>
              <a:rPr lang="en-GB" sz="1200" b="0" i="0" u="none" strike="noStrike" kern="1200" baseline="0" dirty="0">
                <a:solidFill>
                  <a:schemeClr val="tx1"/>
                </a:solidFill>
                <a:latin typeface="+mn-lt"/>
                <a:ea typeface="+mn-ea"/>
                <a:cs typeface="+mn-cs"/>
              </a:rPr>
              <a:t> bound to </a:t>
            </a:r>
            <a:r>
              <a:rPr lang="en-GB" sz="1200" b="0" i="1" u="none" strike="noStrike" kern="1200" baseline="0" dirty="0">
                <a:solidFill>
                  <a:schemeClr val="tx1"/>
                </a:solidFill>
                <a:latin typeface="+mn-lt"/>
                <a:ea typeface="+mn-ea"/>
                <a:cs typeface="+mn-cs"/>
              </a:rPr>
              <a:t>R. gnavus </a:t>
            </a:r>
            <a:r>
              <a:rPr lang="en-GB" sz="1200" b="0" i="0" u="none" strike="noStrike" kern="1200" baseline="0" dirty="0">
                <a:solidFill>
                  <a:schemeClr val="tx1"/>
                </a:solidFill>
                <a:latin typeface="+mn-lt"/>
                <a:ea typeface="+mn-ea"/>
                <a:cs typeface="+mn-cs"/>
              </a:rPr>
              <a:t>E1_10125 proposed by </a:t>
            </a:r>
            <a:r>
              <a:rPr lang="en-GB" sz="1200" b="0" i="1" u="none" strike="noStrike" kern="1200" baseline="0" dirty="0">
                <a:solidFill>
                  <a:schemeClr val="tx1"/>
                </a:solidFill>
                <a:latin typeface="+mn-lt"/>
                <a:ea typeface="+mn-ea"/>
                <a:cs typeface="+mn-cs"/>
              </a:rPr>
              <a:t>in </a:t>
            </a:r>
            <a:r>
              <a:rPr lang="en-GB" sz="1200" b="0" i="1" u="none" strike="noStrike" kern="1200" baseline="0" dirty="0" err="1">
                <a:solidFill>
                  <a:schemeClr val="tx1"/>
                </a:solidFill>
                <a:latin typeface="+mn-lt"/>
                <a:ea typeface="+mn-ea"/>
                <a:cs typeface="+mn-cs"/>
              </a:rPr>
              <a:t>silico</a:t>
            </a:r>
            <a:r>
              <a:rPr lang="en-GB" sz="1200" b="0" i="0" u="none" strike="noStrike" kern="1200" baseline="0" dirty="0">
                <a:solidFill>
                  <a:schemeClr val="tx1"/>
                </a:solidFill>
                <a:latin typeface="+mn-lt"/>
                <a:ea typeface="+mn-ea"/>
                <a:cs typeface="+mn-cs"/>
              </a:rPr>
              <a:t> docking.</a:t>
            </a:r>
            <a:endParaRPr lang="en-GB" dirty="0"/>
          </a:p>
          <a:p>
            <a:endParaRPr lang="en-GB" dirty="0"/>
          </a:p>
        </p:txBody>
      </p:sp>
      <p:sp>
        <p:nvSpPr>
          <p:cNvPr id="4" name="Slide Number Placeholder 3"/>
          <p:cNvSpPr>
            <a:spLocks noGrp="1"/>
          </p:cNvSpPr>
          <p:nvPr>
            <p:ph type="sldNum" sz="quarter" idx="10"/>
          </p:nvPr>
        </p:nvSpPr>
        <p:spPr/>
        <p:txBody>
          <a:bodyPr/>
          <a:lstStyle/>
          <a:p>
            <a:fld id="{B5FE592C-52B5-409C-B38B-182C86C2EA6D}" type="slidenum">
              <a:rPr lang="en-GB" smtClean="0"/>
              <a:t>4</a:t>
            </a:fld>
            <a:endParaRPr lang="en-GB"/>
          </a:p>
        </p:txBody>
      </p:sp>
    </p:spTree>
    <p:extLst>
      <p:ext uri="{BB962C8B-B14F-4D97-AF65-F5344CB8AC3E}">
        <p14:creationId xmlns:p14="http://schemas.microsoft.com/office/powerpoint/2010/main" val="25486958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D8320C-D0C5-41BB-B32D-32603D6FDCE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3C7D8A1C-547E-433D-BA9A-8001AA59F6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6AF32BFF-A80A-4D7A-9333-BBFEC26A75CB}"/>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39DDDECD-A3FA-4F01-B215-A13EC619899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364EC05-CDA5-4558-A156-783926BE6012}"/>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6872292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C1D713-979A-49B6-8762-C608E8AC93F5}"/>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5DF3074-2E85-4F3B-9CA0-D8A189538BE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0EF2E04-8A3A-4778-B10C-973F7AD2FD8E}"/>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1DF1E31C-6D36-4024-9A1C-B6B0E0F0795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040B2C0-3AB7-4601-929A-0F06C4C3092E}"/>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6789598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7722D84-AADF-4264-AECF-4FED500DB37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0AC20351-9FD1-4420-8B0A-DA8EE9ACCDA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8B20955-A7C6-4229-9A0B-46FEB4F91275}"/>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E71D7119-B405-46A7-A6D0-2CB7955D56A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26A25EB-C7A0-43FE-A642-52DE5A69F587}"/>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8960984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61CA38-4F3D-49C1-8157-2B56CCD05F9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CE97C463-2301-4597-89F3-49A7A570AC5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90B23E47-9902-448A-8658-39095DC1635B}"/>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60D7C62F-79D0-4198-B086-C027B72C979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6A2ACDF-3487-4EE9-8FAA-3FB8BB79F597}"/>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6129755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F58E1F-92C2-4D45-8E9D-FBB642CC72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E5B5EAA9-0DE0-44D1-90B7-BBC220489EC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052ACFD-AC5D-4E71-BB04-C850974EFDE6}"/>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A5FE6CD8-06FB-4ED4-82E5-791C64DC208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05B52A7-5DAB-4DAE-94E0-4AD003CDBAF5}"/>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00629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1B7FB3-0F24-4682-AB72-D36B8E26DA7C}"/>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B7F4065D-7FB9-45F1-84D2-4698C801472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629B90FA-D1B8-4589-8FFE-752154041BC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010C962-80CE-4484-BE88-48047ECAAF14}"/>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6" name="Footer Placeholder 5">
            <a:extLst>
              <a:ext uri="{FF2B5EF4-FFF2-40B4-BE49-F238E27FC236}">
                <a16:creationId xmlns:a16="http://schemas.microsoft.com/office/drawing/2014/main" id="{6C2CDF49-E29A-4F74-A1A7-C43FFC5C6A5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2B1BAC0-0D56-4B3B-AC74-5C5280BFE985}"/>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37543417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223D88-F9AE-4F39-86E0-7BF5BF242A64}"/>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4681A82E-947C-4A1F-89DD-6A87194A33D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484E441-22FE-46E8-897B-304B8827F19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69FD94F3-83BA-4507-85FA-CEC2544F5EC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395B04A-D174-49D2-8975-F82007BDC8A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7351BF65-AF6F-440E-A52C-32ADD4EB3FE4}"/>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8" name="Footer Placeholder 7">
            <a:extLst>
              <a:ext uri="{FF2B5EF4-FFF2-40B4-BE49-F238E27FC236}">
                <a16:creationId xmlns:a16="http://schemas.microsoft.com/office/drawing/2014/main" id="{E6EC3810-8C26-49DC-8BA1-9C8729097B33}"/>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54DB65BC-87F7-4389-B5A5-42AD5C48DE03}"/>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1084804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0953B2-0A47-4D69-97F1-91565785CF1B}"/>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83C9FB23-BE73-4C05-9656-9ED52E31D1A8}"/>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4" name="Footer Placeholder 3">
            <a:extLst>
              <a:ext uri="{FF2B5EF4-FFF2-40B4-BE49-F238E27FC236}">
                <a16:creationId xmlns:a16="http://schemas.microsoft.com/office/drawing/2014/main" id="{8D52C76A-8BE7-4919-BFCD-913B63EC6436}"/>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BA1D88DB-E7BF-44F6-B428-8CE9674BFCA7}"/>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19444171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2838ADC-BEBB-4896-97B8-FEDADFC164E1}"/>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3" name="Footer Placeholder 2">
            <a:extLst>
              <a:ext uri="{FF2B5EF4-FFF2-40B4-BE49-F238E27FC236}">
                <a16:creationId xmlns:a16="http://schemas.microsoft.com/office/drawing/2014/main" id="{F1342A9F-247F-4D30-93EB-4D10E6B87DF3}"/>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87C8751F-F453-4935-AA3B-27C317D8F94B}"/>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5054017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FC99AE-820D-4909-AC43-ED3FA790C24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E0FFE156-9EF7-4401-9BED-096C8C8F265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97979A57-2A1B-4541-8774-0A9F80AFC47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E4AD4D1-AF94-4E77-B4E5-0D18E668552A}"/>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6" name="Footer Placeholder 5">
            <a:extLst>
              <a:ext uri="{FF2B5EF4-FFF2-40B4-BE49-F238E27FC236}">
                <a16:creationId xmlns:a16="http://schemas.microsoft.com/office/drawing/2014/main" id="{04DE269C-ACDD-49C8-A212-4837F18D632A}"/>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B093F8F-B652-4897-9EA8-1999DA90D5CA}"/>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23616980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BB2C74-D515-44D0-A455-E9F41F57E0F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8531A636-89EF-470F-AAFF-5D2D60C7417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B8F05D8F-302B-4BA4-BF8A-CFA00F2CCC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8AD11F7-2C07-405B-AF68-B43BE08225C1}"/>
              </a:ext>
            </a:extLst>
          </p:cNvPr>
          <p:cNvSpPr>
            <a:spLocks noGrp="1"/>
          </p:cNvSpPr>
          <p:nvPr>
            <p:ph type="dt" sz="half" idx="10"/>
          </p:nvPr>
        </p:nvSpPr>
        <p:spPr/>
        <p:txBody>
          <a:bodyPr/>
          <a:lstStyle/>
          <a:p>
            <a:fld id="{921A5FC6-57F8-418F-AA37-27ED203EAD1D}" type="datetimeFigureOut">
              <a:rPr lang="en-GB" smtClean="0"/>
              <a:t>17/04/2020</a:t>
            </a:fld>
            <a:endParaRPr lang="en-GB"/>
          </a:p>
        </p:txBody>
      </p:sp>
      <p:sp>
        <p:nvSpPr>
          <p:cNvPr id="6" name="Footer Placeholder 5">
            <a:extLst>
              <a:ext uri="{FF2B5EF4-FFF2-40B4-BE49-F238E27FC236}">
                <a16:creationId xmlns:a16="http://schemas.microsoft.com/office/drawing/2014/main" id="{EC4437A3-01C9-4E34-A943-1C08575C903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2C02BB3-3CD8-401D-B6C4-0F38B5E60507}"/>
              </a:ext>
            </a:extLst>
          </p:cNvPr>
          <p:cNvSpPr>
            <a:spLocks noGrp="1"/>
          </p:cNvSpPr>
          <p:nvPr>
            <p:ph type="sldNum" sz="quarter" idx="12"/>
          </p:nvPr>
        </p:nvSpPr>
        <p:spPr/>
        <p:txBody>
          <a:bodyPr/>
          <a:lstStyle/>
          <a:p>
            <a:fld id="{07AD84A1-2B35-4E58-83DA-0711D5044334}" type="slidenum">
              <a:rPr lang="en-GB" smtClean="0"/>
              <a:t>‹#›</a:t>
            </a:fld>
            <a:endParaRPr lang="en-GB"/>
          </a:p>
        </p:txBody>
      </p:sp>
    </p:spTree>
    <p:extLst>
      <p:ext uri="{BB962C8B-B14F-4D97-AF65-F5344CB8AC3E}">
        <p14:creationId xmlns:p14="http://schemas.microsoft.com/office/powerpoint/2010/main" val="33090818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25E1A2E-81B1-4612-99FA-761D49F130D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50D88A7-D0F5-42CB-B70E-4F7BDE84A0A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1B5DDC6-6A77-460F-83CC-7AA086F0CA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21A5FC6-57F8-418F-AA37-27ED203EAD1D}" type="datetimeFigureOut">
              <a:rPr lang="en-GB" smtClean="0"/>
              <a:t>17/04/2020</a:t>
            </a:fld>
            <a:endParaRPr lang="en-GB"/>
          </a:p>
        </p:txBody>
      </p:sp>
      <p:sp>
        <p:nvSpPr>
          <p:cNvPr id="5" name="Footer Placeholder 4">
            <a:extLst>
              <a:ext uri="{FF2B5EF4-FFF2-40B4-BE49-F238E27FC236}">
                <a16:creationId xmlns:a16="http://schemas.microsoft.com/office/drawing/2014/main" id="{32383F57-CC15-4948-8583-9C623E86688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D0627D6D-7328-4988-BA47-1306852F7DD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AD84A1-2B35-4E58-83DA-0711D5044334}" type="slidenum">
              <a:rPr lang="en-GB" smtClean="0"/>
              <a:t>‹#›</a:t>
            </a:fld>
            <a:endParaRPr lang="en-GB"/>
          </a:p>
        </p:txBody>
      </p:sp>
    </p:spTree>
    <p:extLst>
      <p:ext uri="{BB962C8B-B14F-4D97-AF65-F5344CB8AC3E}">
        <p14:creationId xmlns:p14="http://schemas.microsoft.com/office/powerpoint/2010/main" val="7519335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8.png"/><Relationship Id="rId11" Type="http://schemas.openxmlformats.org/officeDocument/2006/relationships/image" Target="../media/image13.png"/><Relationship Id="rId5" Type="http://schemas.openxmlformats.org/officeDocument/2006/relationships/image" Target="../media/image7.png"/><Relationship Id="rId10" Type="http://schemas.openxmlformats.org/officeDocument/2006/relationships/image" Target="../media/image12.png"/><Relationship Id="rId4" Type="http://schemas.openxmlformats.org/officeDocument/2006/relationships/image" Target="../media/image6.png"/><Relationship Id="rId9" Type="http://schemas.openxmlformats.org/officeDocument/2006/relationships/image" Target="../media/image11.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chart" Target="../charts/chart1.xml"/><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5B74A74-3604-47B9-82C8-5D87AFE87219}"/>
              </a:ext>
            </a:extLst>
          </p:cNvPr>
          <p:cNvSpPr/>
          <p:nvPr/>
        </p:nvSpPr>
        <p:spPr>
          <a:xfrm>
            <a:off x="313678" y="0"/>
            <a:ext cx="11221375" cy="6867649"/>
          </a:xfrm>
          <a:prstGeom prst="rect">
            <a:avLst/>
          </a:prstGeom>
        </p:spPr>
        <p:txBody>
          <a:bodyPr wrap="square">
            <a:spAutoFit/>
          </a:bodyPr>
          <a:lstStyle/>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Supplementary files</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dirty="0">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ure S1.</a:t>
            </a:r>
            <a:r>
              <a:rPr lang="en-GB" sz="1200" dirty="0">
                <a:latin typeface="Times New Roman" panose="02020603050405020304" pitchFamily="18" charset="0"/>
                <a:ea typeface="Calibri" panose="020F0502020204030204" pitchFamily="34" charset="0"/>
                <a:cs typeface="Times New Roman" panose="02020603050405020304" pitchFamily="18" charset="0"/>
              </a:rPr>
              <a:t> SSN analysis of GH29 and GH95 sequences</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A.</a:t>
            </a:r>
            <a:r>
              <a:rPr lang="en-GB" sz="1200" dirty="0">
                <a:latin typeface="Times New Roman" panose="02020603050405020304" pitchFamily="18" charset="0"/>
                <a:ea typeface="Calibri" panose="020F0502020204030204" pitchFamily="34" charset="0"/>
                <a:cs typeface="Times New Roman" panose="02020603050405020304" pitchFamily="18" charset="0"/>
              </a:rPr>
              <a:t> SSN of 6736 sequences from family GH29 representing in 5318 nodes. </a:t>
            </a:r>
            <a:r>
              <a:rPr lang="en-GB" sz="1200" b="1" dirty="0">
                <a:latin typeface="Times New Roman" panose="02020603050405020304" pitchFamily="18" charset="0"/>
                <a:ea typeface="Calibri" panose="020F0502020204030204" pitchFamily="34" charset="0"/>
                <a:cs typeface="Times New Roman" panose="02020603050405020304" pitchFamily="18" charset="0"/>
              </a:rPr>
              <a:t>B.</a:t>
            </a:r>
            <a:r>
              <a:rPr lang="en-GB" sz="1200" dirty="0">
                <a:latin typeface="Times New Roman" panose="02020603050405020304" pitchFamily="18" charset="0"/>
                <a:ea typeface="Calibri" panose="020F0502020204030204" pitchFamily="34" charset="0"/>
                <a:cs typeface="Times New Roman" panose="02020603050405020304" pitchFamily="18" charset="0"/>
              </a:rPr>
              <a:t> SSN of 825 sequences from family GH95 representing in 825 nodes. Blue node: sequences extracted from the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AZy</a:t>
            </a:r>
            <a:r>
              <a:rPr lang="en-GB" sz="1200" dirty="0">
                <a:latin typeface="Times New Roman" panose="02020603050405020304" pitchFamily="18" charset="0"/>
                <a:ea typeface="Calibri" panose="020F0502020204030204" pitchFamily="34" charset="0"/>
                <a:cs typeface="Times New Roman" panose="02020603050405020304" pitchFamily="18" charset="0"/>
              </a:rPr>
              <a:t> database encoding functionally characterised enzymes. Red nodes sequences from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1 strain. Cyan nodes, sequences from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dirty="0">
                <a:latin typeface="Times New Roman" panose="02020603050405020304" pitchFamily="18" charset="0"/>
                <a:ea typeface="Calibri" panose="020F0502020204030204" pitchFamily="34" charset="0"/>
                <a:cs typeface="Times New Roman" panose="02020603050405020304" pitchFamily="18" charset="0"/>
              </a:rPr>
              <a:t> ATCC29149 strain. Green nodes, sequences common to both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1 and ATCC29149 strains.</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dirty="0">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ure S2</a:t>
            </a:r>
            <a:r>
              <a:rPr lang="en-GB" sz="1200" dirty="0">
                <a:latin typeface="Times New Roman" panose="02020603050405020304" pitchFamily="18" charset="0"/>
                <a:ea typeface="Calibri" panose="020F0502020204030204" pitchFamily="34" charset="0"/>
                <a:cs typeface="Times New Roman" panose="02020603050405020304" pitchFamily="18" charset="0"/>
              </a:rPr>
              <a:t>. Optimal pH of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dirty="0">
                <a:latin typeface="Times New Roman" panose="02020603050405020304" pitchFamily="18" charset="0"/>
                <a:ea typeface="Calibri" panose="020F0502020204030204" pitchFamily="34" charset="0"/>
                <a:cs typeface="Times New Roman" panose="02020603050405020304" pitchFamily="18" charset="0"/>
              </a:rPr>
              <a:t> GH29 and GH95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s</a:t>
            </a:r>
            <a:r>
              <a:rPr lang="en-GB" sz="1200" dirty="0">
                <a:latin typeface="Times New Roman" panose="02020603050405020304" pitchFamily="18" charset="0"/>
                <a:ea typeface="Calibri" panose="020F0502020204030204" pitchFamily="34" charset="0"/>
                <a:cs typeface="Times New Roman" panose="02020603050405020304" pitchFamily="18" charset="0"/>
              </a:rPr>
              <a:t> characterised in this study. </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ure S3. </a:t>
            </a:r>
            <a:r>
              <a:rPr lang="en-GB" sz="1200" dirty="0">
                <a:latin typeface="Times New Roman" panose="02020603050405020304" pitchFamily="18" charset="0"/>
                <a:ea typeface="Calibri" panose="020F0502020204030204" pitchFamily="34" charset="0"/>
                <a:cs typeface="Times New Roman" panose="02020603050405020304" pitchFamily="18" charset="0"/>
              </a:rPr>
              <a:t>Substrate interactions with GH29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s</a:t>
            </a:r>
            <a:r>
              <a:rPr lang="en-GB" sz="1200" dirty="0">
                <a:latin typeface="Times New Roman" panose="02020603050405020304" pitchFamily="18" charset="0"/>
                <a:ea typeface="Calibri" panose="020F0502020204030204" pitchFamily="34" charset="0"/>
                <a:cs typeface="Times New Roman" panose="02020603050405020304" pitchFamily="18" charset="0"/>
              </a:rPr>
              <a:t> from bacteria. </a:t>
            </a:r>
            <a:r>
              <a:rPr lang="en-GB" sz="1200" b="1" dirty="0">
                <a:latin typeface="Times New Roman" panose="02020603050405020304" pitchFamily="18" charset="0"/>
                <a:ea typeface="Calibri" panose="020F0502020204030204" pitchFamily="34" charset="0"/>
                <a:cs typeface="Times New Roman" panose="02020603050405020304" pitchFamily="18" charset="0"/>
              </a:rPr>
              <a:t>A. </a:t>
            </a:r>
            <a:r>
              <a:rPr lang="el-GR" sz="1200" dirty="0">
                <a:latin typeface="Times New Roman" panose="02020603050405020304" pitchFamily="18" charset="0"/>
                <a:ea typeface="Calibri" panose="020F0502020204030204" pitchFamily="34" charset="0"/>
                <a:cs typeface="Times New Roman" panose="02020603050405020304" pitchFamily="18" charset="0"/>
              </a:rPr>
              <a:t>β-</a:t>
            </a:r>
            <a:r>
              <a:rPr lang="en-GB" sz="1200" dirty="0">
                <a:latin typeface="Times New Roman" panose="02020603050405020304" pitchFamily="18" charset="0"/>
                <a:ea typeface="Calibri" panose="020F0502020204030204" pitchFamily="34" charset="0"/>
                <a:cs typeface="Times New Roman" panose="02020603050405020304" pitchFamily="18" charset="0"/>
              </a:rPr>
              <a:t>fucose in the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GH29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a:t>
            </a:r>
            <a:r>
              <a:rPr lang="en-GB" sz="1200" dirty="0">
                <a:latin typeface="Times New Roman" panose="02020603050405020304" pitchFamily="18" charset="0"/>
                <a:ea typeface="Calibri" panose="020F0502020204030204" pitchFamily="34" charset="0"/>
                <a:cs typeface="Times New Roman" panose="02020603050405020304" pitchFamily="18" charset="0"/>
              </a:rPr>
              <a:t> E1_10125 wild-type binding site. The yellow, green and magenta meshes represent the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o</a:t>
            </a:r>
            <a:r>
              <a:rPr lang="en-GB" sz="1200" dirty="0">
                <a:latin typeface="Times New Roman" panose="02020603050405020304" pitchFamily="18" charset="0"/>
                <a:ea typeface="Calibri" panose="020F0502020204030204" pitchFamily="34" charset="0"/>
                <a:cs typeface="Times New Roman" panose="02020603050405020304" pitchFamily="18" charset="0"/>
              </a:rPr>
              <a:t>-Fc difference maps at </a:t>
            </a:r>
            <a:r>
              <a:rPr lang="el-GR" sz="1200" dirty="0">
                <a:latin typeface="Times New Roman" panose="02020603050405020304" pitchFamily="18" charset="0"/>
                <a:ea typeface="Calibri" panose="020F0502020204030204" pitchFamily="34" charset="0"/>
                <a:cs typeface="Times New Roman" panose="02020603050405020304" pitchFamily="18" charset="0"/>
              </a:rPr>
              <a:t>σ </a:t>
            </a:r>
            <a:r>
              <a:rPr lang="en-GB" sz="1200" dirty="0">
                <a:latin typeface="Times New Roman" panose="02020603050405020304" pitchFamily="18" charset="0"/>
                <a:ea typeface="Calibri" panose="020F0502020204030204" pitchFamily="34" charset="0"/>
                <a:cs typeface="Times New Roman" panose="02020603050405020304" pitchFamily="18" charset="0"/>
              </a:rPr>
              <a:t>levels of 2, 3 and 5 respectively. </a:t>
            </a:r>
            <a:r>
              <a:rPr lang="en-GB" sz="1200" b="1" dirty="0">
                <a:latin typeface="Times New Roman" panose="02020603050405020304" pitchFamily="18" charset="0"/>
                <a:ea typeface="Calibri" panose="020F0502020204030204" pitchFamily="34" charset="0"/>
                <a:cs typeface="Times New Roman" panose="02020603050405020304" pitchFamily="18" charset="0"/>
              </a:rPr>
              <a:t>B.</a:t>
            </a:r>
            <a:r>
              <a:rPr lang="en-GB" sz="1200" dirty="0">
                <a:latin typeface="Times New Roman" panose="02020603050405020304" pitchFamily="18" charset="0"/>
                <a:ea typeface="Calibri" panose="020F0502020204030204" pitchFamily="34" charset="0"/>
                <a:cs typeface="Times New Roman" panose="02020603050405020304" pitchFamily="18" charset="0"/>
              </a:rPr>
              <a:t> Electron density is present for both </a:t>
            </a:r>
            <a:r>
              <a:rPr lang="el-GR" sz="1200" dirty="0">
                <a:latin typeface="Times New Roman" panose="02020603050405020304" pitchFamily="18" charset="0"/>
                <a:ea typeface="Calibri" panose="020F0502020204030204" pitchFamily="34" charset="0"/>
                <a:cs typeface="Times New Roman" panose="02020603050405020304" pitchFamily="18" charset="0"/>
              </a:rPr>
              <a:t>α-</a:t>
            </a:r>
            <a:r>
              <a:rPr lang="en-GB" sz="1200" dirty="0">
                <a:latin typeface="Times New Roman" panose="02020603050405020304" pitchFamily="18" charset="0"/>
                <a:ea typeface="Calibri" panose="020F0502020204030204" pitchFamily="34" charset="0"/>
                <a:cs typeface="Times New Roman" panose="02020603050405020304" pitchFamily="18" charset="0"/>
              </a:rPr>
              <a:t>fucose and </a:t>
            </a:r>
            <a:r>
              <a:rPr lang="el-GR" sz="1200" dirty="0">
                <a:latin typeface="Times New Roman" panose="02020603050405020304" pitchFamily="18" charset="0"/>
                <a:ea typeface="Calibri" panose="020F0502020204030204" pitchFamily="34" charset="0"/>
                <a:cs typeface="Times New Roman" panose="02020603050405020304" pitchFamily="18" charset="0"/>
              </a:rPr>
              <a:t>β-</a:t>
            </a:r>
            <a:r>
              <a:rPr lang="en-GB" sz="1200" dirty="0">
                <a:latin typeface="Times New Roman" panose="02020603050405020304" pitchFamily="18" charset="0"/>
                <a:ea typeface="Calibri" panose="020F0502020204030204" pitchFamily="34" charset="0"/>
                <a:cs typeface="Times New Roman" panose="02020603050405020304" pitchFamily="18" charset="0"/>
              </a:rPr>
              <a:t>fucose in the E1_10125 D221A mutan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o</a:t>
            </a:r>
            <a:r>
              <a:rPr lang="en-GB" sz="1200" dirty="0">
                <a:latin typeface="Times New Roman" panose="02020603050405020304" pitchFamily="18" charset="0"/>
                <a:ea typeface="Calibri" panose="020F0502020204030204" pitchFamily="34" charset="0"/>
                <a:cs typeface="Times New Roman" panose="02020603050405020304" pitchFamily="18" charset="0"/>
              </a:rPr>
              <a:t>-Fc difference maps are coloured as above. </a:t>
            </a:r>
            <a:r>
              <a:rPr lang="en-GB" sz="1200" b="1" dirty="0">
                <a:latin typeface="Times New Roman" panose="02020603050405020304" pitchFamily="18" charset="0"/>
                <a:ea typeface="Calibri" panose="020F0502020204030204" pitchFamily="34" charset="0"/>
                <a:cs typeface="Times New Roman" panose="02020603050405020304" pitchFamily="18" charset="0"/>
              </a:rPr>
              <a:t>C. </a:t>
            </a:r>
            <a:r>
              <a:rPr lang="en-GB" sz="1200" dirty="0">
                <a:latin typeface="Times New Roman" panose="02020603050405020304" pitchFamily="18" charset="0"/>
                <a:ea typeface="Calibri" panose="020F0502020204030204" pitchFamily="34" charset="0"/>
                <a:cs typeface="Times New Roman" panose="02020603050405020304" pitchFamily="18" charset="0"/>
              </a:rPr>
              <a:t>Complex between </a:t>
            </a:r>
            <a:r>
              <a:rPr lang="en-GB" sz="1200" i="1" dirty="0">
                <a:latin typeface="Times New Roman" panose="02020603050405020304" pitchFamily="18" charset="0"/>
                <a:ea typeface="Calibri" panose="020F0502020204030204" pitchFamily="34" charset="0"/>
                <a:cs typeface="Times New Roman" panose="02020603050405020304" pitchFamily="18" charset="0"/>
              </a:rPr>
              <a:t>B.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longum</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subsp. </a:t>
            </a:r>
            <a:r>
              <a:rPr lang="en-GB" sz="1200" dirty="0" err="1">
                <a:latin typeface="Times New Roman" panose="02020603050405020304" pitchFamily="18" charset="0"/>
                <a:ea typeface="Calibri" panose="020F0502020204030204" pitchFamily="34" charset="0"/>
                <a:cs typeface="Times New Roman" panose="02020603050405020304" pitchFamily="18" charset="0"/>
              </a:rPr>
              <a:t>infantis</a:t>
            </a:r>
            <a:r>
              <a:rPr lang="en-GB" sz="1200" dirty="0">
                <a:latin typeface="Times New Roman" panose="02020603050405020304" pitchFamily="18" charset="0"/>
                <a:ea typeface="Calibri" panose="020F0502020204030204" pitchFamily="34" charset="0"/>
                <a:cs typeface="Times New Roman" panose="02020603050405020304" pitchFamily="18" charset="0"/>
              </a:rPr>
              <a:t> GH29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a:t>
            </a:r>
            <a:r>
              <a:rPr lang="en-GB" sz="1200" dirty="0">
                <a:latin typeface="Times New Roman" panose="02020603050405020304" pitchFamily="18" charset="0"/>
                <a:ea typeface="Calibri" panose="020F0502020204030204" pitchFamily="34" charset="0"/>
                <a:cs typeface="Times New Roman" panose="02020603050405020304" pitchFamily="18" charset="0"/>
              </a:rPr>
              <a:t> and </a:t>
            </a:r>
            <a:r>
              <a:rPr lang="en-GB" sz="1200" dirty="0" err="1">
                <a:latin typeface="Times New Roman" panose="02020603050405020304" pitchFamily="18" charset="0"/>
                <a:ea typeface="Calibri" panose="020F0502020204030204" pitchFamily="34" charset="0"/>
                <a:cs typeface="Times New Roman" panose="02020603050405020304" pitchFamily="18" charset="0"/>
              </a:rPr>
              <a:t>LeA</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pdb</a:t>
            </a:r>
            <a:r>
              <a:rPr lang="en-GB" sz="1200" dirty="0">
                <a:latin typeface="Times New Roman" panose="02020603050405020304" pitchFamily="18" charset="0"/>
                <a:ea typeface="Calibri" panose="020F0502020204030204" pitchFamily="34" charset="0"/>
                <a:cs typeface="Times New Roman" panose="02020603050405020304" pitchFamily="18" charset="0"/>
              </a:rPr>
              <a:t>: 3UE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a:t>
            </a:r>
            <a:r>
              <a:rPr lang="en-GB" sz="1200" dirty="0">
                <a:latin typeface="Times New Roman" panose="02020603050405020304" pitchFamily="18" charset="0"/>
                <a:ea typeface="Calibri" panose="020F0502020204030204" pitchFamily="34" charset="0"/>
                <a:cs typeface="Times New Roman" panose="02020603050405020304" pitchFamily="18" charset="0"/>
              </a:rPr>
              <a:t> is shown in yellow, </a:t>
            </a:r>
            <a:r>
              <a:rPr lang="en-GB" sz="1200" dirty="0" err="1">
                <a:latin typeface="Times New Roman" panose="02020603050405020304" pitchFamily="18" charset="0"/>
                <a:ea typeface="Calibri" panose="020F0502020204030204" pitchFamily="34" charset="0"/>
                <a:cs typeface="Times New Roman" panose="02020603050405020304" pitchFamily="18" charset="0"/>
              </a:rPr>
              <a:t>GlcNAc</a:t>
            </a:r>
            <a:r>
              <a:rPr lang="en-GB" sz="1200" dirty="0">
                <a:latin typeface="Times New Roman" panose="02020603050405020304" pitchFamily="18" charset="0"/>
                <a:ea typeface="Calibri" panose="020F0502020204030204" pitchFamily="34" charset="0"/>
                <a:cs typeface="Times New Roman" panose="02020603050405020304" pitchFamily="18" charset="0"/>
              </a:rPr>
              <a:t> in cyan and Gal in orange. Residues that interact with the Gal residue and nearby residues that may impede binding of </a:t>
            </a:r>
            <a:r>
              <a:rPr lang="en-GB" sz="1200" dirty="0" err="1">
                <a:latin typeface="Times New Roman" panose="02020603050405020304" pitchFamily="18" charset="0"/>
                <a:ea typeface="Calibri" panose="020F0502020204030204" pitchFamily="34" charset="0"/>
                <a:cs typeface="Times New Roman" panose="02020603050405020304" pitchFamily="18" charset="0"/>
              </a:rPr>
              <a:t>sialylated</a:t>
            </a:r>
            <a:r>
              <a:rPr lang="en-GB" sz="1200" dirty="0">
                <a:latin typeface="Times New Roman" panose="02020603050405020304" pitchFamily="18" charset="0"/>
                <a:ea typeface="Calibri" panose="020F0502020204030204" pitchFamily="34" charset="0"/>
                <a:cs typeface="Times New Roman" panose="02020603050405020304" pitchFamily="18" charset="0"/>
              </a:rPr>
              <a:t> substrates are represented as sticks. Dashed black lines indicate hydrogen-bonding interactions. Residue identifiers refer to the wild type sequence. </a:t>
            </a:r>
            <a:r>
              <a:rPr lang="en-GB" sz="1200" b="1" dirty="0">
                <a:latin typeface="Times New Roman" panose="02020603050405020304" pitchFamily="18" charset="0"/>
                <a:ea typeface="Calibri" panose="020F0502020204030204" pitchFamily="34" charset="0"/>
                <a:cs typeface="Times New Roman" panose="02020603050405020304" pitchFamily="18" charset="0"/>
              </a:rPr>
              <a:t>D. </a:t>
            </a:r>
            <a:r>
              <a:rPr lang="en-GB" sz="1200" dirty="0">
                <a:latin typeface="Times New Roman" panose="02020603050405020304" pitchFamily="18" charset="0"/>
                <a:ea typeface="Calibri" panose="020F0502020204030204" pitchFamily="34" charset="0"/>
                <a:cs typeface="Times New Roman" panose="02020603050405020304" pitchFamily="18" charset="0"/>
              </a:rPr>
              <a:t>Complex between </a:t>
            </a:r>
            <a:r>
              <a:rPr lang="en-GB" sz="1200" i="1" dirty="0">
                <a:latin typeface="Times New Roman" panose="02020603050405020304" pitchFamily="18" charset="0"/>
                <a:ea typeface="Calibri" panose="020F0502020204030204" pitchFamily="34" charset="0"/>
                <a:cs typeface="Times New Roman" panose="02020603050405020304" pitchFamily="18" charset="0"/>
              </a:rPr>
              <a:t>S. pneumoniae </a:t>
            </a:r>
            <a:r>
              <a:rPr lang="en-GB" sz="1200" dirty="0">
                <a:latin typeface="Times New Roman" panose="02020603050405020304" pitchFamily="18" charset="0"/>
                <a:ea typeface="Calibri" panose="020F0502020204030204" pitchFamily="34" charset="0"/>
                <a:cs typeface="Times New Roman" panose="02020603050405020304" pitchFamily="18" charset="0"/>
              </a:rPr>
              <a:t>GH29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a:t>
            </a:r>
            <a:r>
              <a:rPr lang="en-GB" sz="1200" dirty="0">
                <a:latin typeface="Times New Roman" panose="02020603050405020304" pitchFamily="18" charset="0"/>
                <a:ea typeface="Calibri" panose="020F0502020204030204" pitchFamily="34" charset="0"/>
                <a:cs typeface="Times New Roman" panose="02020603050405020304" pitchFamily="18" charset="0"/>
              </a:rPr>
              <a:t> and </a:t>
            </a:r>
            <a:r>
              <a:rPr lang="en-GB" sz="1200" dirty="0" err="1">
                <a:latin typeface="Times New Roman" panose="02020603050405020304" pitchFamily="18" charset="0"/>
                <a:ea typeface="Calibri" panose="020F0502020204030204" pitchFamily="34" charset="0"/>
                <a:cs typeface="Times New Roman" panose="02020603050405020304" pitchFamily="18" charset="0"/>
              </a:rPr>
              <a:t>LeA</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pdb</a:t>
            </a:r>
            <a:r>
              <a:rPr lang="en-GB" sz="1200" dirty="0">
                <a:latin typeface="Times New Roman" panose="02020603050405020304" pitchFamily="18" charset="0"/>
                <a:ea typeface="Calibri" panose="020F0502020204030204" pitchFamily="34" charset="0"/>
                <a:cs typeface="Times New Roman" panose="02020603050405020304" pitchFamily="18" charset="0"/>
              </a:rPr>
              <a:t>: 60R4). </a:t>
            </a:r>
            <a:r>
              <a:rPr lang="en-GB" sz="1200" b="1" dirty="0">
                <a:latin typeface="Times New Roman" panose="02020603050405020304" pitchFamily="18" charset="0"/>
                <a:ea typeface="Calibri" panose="020F0502020204030204" pitchFamily="34" charset="0"/>
                <a:cs typeface="Times New Roman" panose="02020603050405020304" pitchFamily="18" charset="0"/>
              </a:rPr>
              <a:t>E. </a:t>
            </a:r>
            <a:r>
              <a:rPr lang="en-GB" sz="1200" dirty="0">
                <a:latin typeface="Times New Roman" panose="02020603050405020304" pitchFamily="18" charset="0"/>
                <a:ea typeface="Calibri" panose="020F0502020204030204" pitchFamily="34" charset="0"/>
                <a:cs typeface="Times New Roman" panose="02020603050405020304" pitchFamily="18" charset="0"/>
              </a:rPr>
              <a:t>Complex between </a:t>
            </a:r>
            <a:r>
              <a:rPr lang="en-GB" sz="1200" i="1" dirty="0">
                <a:latin typeface="Times New Roman" panose="02020603050405020304" pitchFamily="18" charset="0"/>
                <a:ea typeface="Calibri" panose="020F0502020204030204" pitchFamily="34" charset="0"/>
                <a:cs typeface="Times New Roman" panose="02020603050405020304" pitchFamily="18" charset="0"/>
              </a:rPr>
              <a:t>S. pneumoniae </a:t>
            </a:r>
            <a:r>
              <a:rPr lang="en-GB" sz="1200" dirty="0">
                <a:latin typeface="Times New Roman" panose="02020603050405020304" pitchFamily="18" charset="0"/>
                <a:ea typeface="Calibri" panose="020F0502020204030204" pitchFamily="34" charset="0"/>
                <a:cs typeface="Times New Roman" panose="02020603050405020304" pitchFamily="18" charset="0"/>
              </a:rPr>
              <a:t>GH29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pdb</a:t>
            </a:r>
            <a:r>
              <a:rPr lang="en-GB" sz="1200" dirty="0">
                <a:latin typeface="Times New Roman" panose="02020603050405020304" pitchFamily="18" charset="0"/>
                <a:ea typeface="Calibri" panose="020F0502020204030204" pitchFamily="34" charset="0"/>
                <a:cs typeface="Times New Roman" panose="02020603050405020304" pitchFamily="18" charset="0"/>
              </a:rPr>
              <a:t>: 60RF) and </a:t>
            </a:r>
            <a:r>
              <a:rPr lang="en-GB" sz="1200" dirty="0" err="1">
                <a:latin typeface="Times New Roman" panose="02020603050405020304" pitchFamily="18" charset="0"/>
                <a:ea typeface="Calibri" panose="020F0502020204030204" pitchFamily="34" charset="0"/>
                <a:cs typeface="Times New Roman" panose="02020603050405020304" pitchFamily="18" charset="0"/>
              </a:rPr>
              <a:t>LeX</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b="1" dirty="0">
                <a:latin typeface="Times New Roman" panose="02020603050405020304" pitchFamily="18" charset="0"/>
                <a:ea typeface="Calibri" panose="020F0502020204030204" pitchFamily="34" charset="0"/>
                <a:cs typeface="Times New Roman" panose="02020603050405020304" pitchFamily="18" charset="0"/>
              </a:rPr>
              <a:t>F.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1_10125 model in complex with </a:t>
            </a:r>
            <a:r>
              <a:rPr lang="el-GR" sz="1200" dirty="0">
                <a:latin typeface="Times New Roman" panose="02020603050405020304" pitchFamily="18" charset="0"/>
                <a:ea typeface="Calibri" panose="020F0502020204030204" pitchFamily="34" charset="0"/>
                <a:cs typeface="Times New Roman" panose="02020603050405020304" pitchFamily="18" charset="0"/>
              </a:rPr>
              <a:t>β-</a:t>
            </a:r>
            <a:r>
              <a:rPr lang="en-GB" sz="1200" dirty="0">
                <a:latin typeface="Times New Roman" panose="02020603050405020304" pitchFamily="18" charset="0"/>
                <a:ea typeface="Calibri" panose="020F0502020204030204" pitchFamily="34" charset="0"/>
                <a:cs typeface="Times New Roman" panose="02020603050405020304" pitchFamily="18" charset="0"/>
              </a:rPr>
              <a:t>fucose. </a:t>
            </a:r>
            <a:r>
              <a:rPr lang="en-GB" sz="1200" b="1" dirty="0">
                <a:latin typeface="Times New Roman" panose="02020603050405020304" pitchFamily="18" charset="0"/>
                <a:ea typeface="Calibri" panose="020F0502020204030204" pitchFamily="34" charset="0"/>
                <a:cs typeface="Times New Roman" panose="02020603050405020304" pitchFamily="18" charset="0"/>
              </a:rPr>
              <a:t>G. </a:t>
            </a:r>
            <a:r>
              <a:rPr lang="en-GB" sz="1200" dirty="0">
                <a:latin typeface="Times New Roman" panose="02020603050405020304" pitchFamily="18" charset="0"/>
                <a:ea typeface="Calibri" panose="020F0502020204030204" pitchFamily="34" charset="0"/>
                <a:cs typeface="Times New Roman" panose="02020603050405020304" pitchFamily="18" charset="0"/>
              </a:rPr>
              <a:t>Model of the orientation and conformation of </a:t>
            </a:r>
            <a:r>
              <a:rPr lang="en-GB" sz="1200" dirty="0" err="1">
                <a:latin typeface="Times New Roman" panose="02020603050405020304" pitchFamily="18" charset="0"/>
                <a:ea typeface="Calibri" panose="020F0502020204030204" pitchFamily="34" charset="0"/>
                <a:cs typeface="Times New Roman" panose="02020603050405020304" pitchFamily="18" charset="0"/>
              </a:rPr>
              <a:t>sLeX</a:t>
            </a:r>
            <a:r>
              <a:rPr lang="en-GB" sz="1200" dirty="0">
                <a:latin typeface="Times New Roman" panose="02020603050405020304" pitchFamily="18" charset="0"/>
                <a:ea typeface="Calibri" panose="020F0502020204030204" pitchFamily="34" charset="0"/>
                <a:cs typeface="Times New Roman" panose="02020603050405020304" pitchFamily="18" charset="0"/>
              </a:rPr>
              <a:t> bound to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1_10125 proposed by </a:t>
            </a:r>
            <a:r>
              <a:rPr lang="en-GB" sz="1200" i="1" dirty="0">
                <a:latin typeface="Times New Roman" panose="02020603050405020304" pitchFamily="18" charset="0"/>
                <a:ea typeface="Calibri" panose="020F0502020204030204" pitchFamily="34" charset="0"/>
                <a:cs typeface="Times New Roman" panose="02020603050405020304" pitchFamily="18" charset="0"/>
              </a:rPr>
              <a:t>in silico </a:t>
            </a:r>
            <a:r>
              <a:rPr lang="en-GB" sz="1200" dirty="0">
                <a:latin typeface="Times New Roman" panose="02020603050405020304" pitchFamily="18" charset="0"/>
                <a:ea typeface="Calibri" panose="020F0502020204030204" pitchFamily="34" charset="0"/>
                <a:cs typeface="Times New Roman" panose="02020603050405020304" pitchFamily="18" charset="0"/>
              </a:rPr>
              <a:t>docking.</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6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Figure S4.</a:t>
            </a:r>
            <a:r>
              <a:rPr lang="en-GB" sz="1200" dirty="0">
                <a:latin typeface="Times New Roman" panose="02020603050405020304" pitchFamily="18" charset="0"/>
                <a:ea typeface="Calibri" panose="020F0502020204030204" pitchFamily="34" charset="0"/>
                <a:cs typeface="Times New Roman" panose="02020603050405020304" pitchFamily="18" charset="0"/>
              </a:rPr>
              <a:t> Binding of </a:t>
            </a:r>
            <a:r>
              <a:rPr lang="en-GB" sz="1200" i="1" dirty="0">
                <a:latin typeface="Times New Roman" panose="02020603050405020304" pitchFamily="18" charset="0"/>
                <a:ea typeface="Calibri" panose="020F0502020204030204" pitchFamily="34" charset="0"/>
                <a:cs typeface="Times New Roman" panose="02020603050405020304" pitchFamily="18" charset="0"/>
              </a:rPr>
              <a:t>R.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gnavus</a:t>
            </a:r>
            <a:r>
              <a:rPr lang="en-GB" sz="1200" i="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1_10125 D221A </a:t>
            </a:r>
            <a:r>
              <a:rPr lang="en-GB" sz="1200" dirty="0" err="1">
                <a:latin typeface="Times New Roman" panose="02020603050405020304" pitchFamily="18" charset="0"/>
                <a:ea typeface="Calibri" panose="020F0502020204030204" pitchFamily="34" charset="0"/>
                <a:cs typeface="Times New Roman" panose="02020603050405020304" pitchFamily="18" charset="0"/>
              </a:rPr>
              <a:t>fucosidase</a:t>
            </a:r>
            <a:r>
              <a:rPr lang="en-GB" sz="1200" dirty="0">
                <a:latin typeface="Times New Roman" panose="02020603050405020304" pitchFamily="18" charset="0"/>
                <a:ea typeface="Calibri" panose="020F0502020204030204" pitchFamily="34" charset="0"/>
                <a:cs typeface="Times New Roman" panose="02020603050405020304" pitchFamily="18" charset="0"/>
              </a:rPr>
              <a:t> mutant to CFG core H glycans. </a:t>
            </a:r>
            <a:r>
              <a:rPr lang="en-GB" sz="1200" b="1" dirty="0">
                <a:latin typeface="Times New Roman" panose="02020603050405020304" pitchFamily="18" charset="0"/>
                <a:ea typeface="Calibri" panose="020F0502020204030204" pitchFamily="34" charset="0"/>
                <a:cs typeface="Times New Roman" panose="02020603050405020304" pitchFamily="18" charset="0"/>
              </a:rPr>
              <a:t>A.</a:t>
            </a:r>
            <a:r>
              <a:rPr lang="en-GB" sz="1200" dirty="0">
                <a:latin typeface="Times New Roman" panose="02020603050405020304" pitchFamily="18" charset="0"/>
                <a:ea typeface="Calibri" panose="020F0502020204030204" pitchFamily="34" charset="0"/>
                <a:cs typeface="Times New Roman" panose="02020603050405020304" pitchFamily="18" charset="0"/>
              </a:rPr>
              <a:t> Heat map of core H glycan microarray screening. Mammalian </a:t>
            </a:r>
            <a:r>
              <a:rPr lang="en-GB" sz="1200" dirty="0" err="1">
                <a:latin typeface="Times New Roman" panose="02020603050405020304" pitchFamily="18" charset="0"/>
                <a:ea typeface="Calibri" panose="020F0502020204030204" pitchFamily="34" charset="0"/>
                <a:cs typeface="Times New Roman" panose="02020603050405020304" pitchFamily="18" charset="0"/>
              </a:rPr>
              <a:t>glyans</a:t>
            </a:r>
            <a:r>
              <a:rPr lang="en-GB" sz="1200" dirty="0">
                <a:latin typeface="Times New Roman" panose="02020603050405020304" pitchFamily="18" charset="0"/>
                <a:ea typeface="Calibri" panose="020F0502020204030204" pitchFamily="34" charset="0"/>
                <a:cs typeface="Times New Roman" panose="02020603050405020304" pitchFamily="18" charset="0"/>
              </a:rPr>
              <a:t> (over 585) were screened against increasing concentrations of recombinant His6-tagged E1_10125 D221A mutant (</a:t>
            </a:r>
            <a:r>
              <a:rPr lang="en-GB" sz="1200">
                <a:latin typeface="Times New Roman" panose="02020603050405020304" pitchFamily="18" charset="0"/>
                <a:ea typeface="Calibri" panose="020F0502020204030204" pitchFamily="34" charset="0"/>
                <a:cs typeface="Times New Roman" panose="02020603050405020304" pitchFamily="18" charset="0"/>
              </a:rPr>
              <a:t>5 µg/ml, 50 µg/ml, </a:t>
            </a:r>
            <a:r>
              <a:rPr lang="en-GB" sz="1200" dirty="0">
                <a:latin typeface="Times New Roman" panose="02020603050405020304" pitchFamily="18" charset="0"/>
                <a:ea typeface="Calibri" panose="020F0502020204030204" pitchFamily="34" charset="0"/>
                <a:cs typeface="Times New Roman" panose="02020603050405020304" pitchFamily="18" charset="0"/>
              </a:rPr>
              <a:t>and 200 µg /ml) and the data analysed using GLAD (Glycan Array Dashboard) tool version 2.0 (Mehta and Cummings, 2019). The strength of each binding interaction is reported in relative fluorescence units (RFU) </a:t>
            </a:r>
            <a:r>
              <a:rPr lang="en-GB" sz="1200" b="1" dirty="0">
                <a:latin typeface="Times New Roman" panose="02020603050405020304" pitchFamily="18" charset="0"/>
                <a:ea typeface="Calibri" panose="020F0502020204030204" pitchFamily="34" charset="0"/>
                <a:cs typeface="Times New Roman" panose="02020603050405020304" pitchFamily="18" charset="0"/>
              </a:rPr>
              <a:t>B</a:t>
            </a:r>
            <a:r>
              <a:rPr lang="en-GB" sz="1200" dirty="0">
                <a:latin typeface="Times New Roman" panose="02020603050405020304" pitchFamily="18" charset="0"/>
                <a:ea typeface="Calibri" panose="020F0502020204030204" pitchFamily="34" charset="0"/>
                <a:cs typeface="Times New Roman" panose="02020603050405020304" pitchFamily="18" charset="0"/>
              </a:rPr>
              <a:t>. Structure of core H glycans with the highest RFU values (&gt;200 RFU).</a:t>
            </a:r>
            <a:endParaRPr lang="en-GB"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200" dirty="0">
                <a:latin typeface="Calibri" panose="020F0502020204030204" pitchFamily="34" charset="0"/>
                <a:ea typeface="Calibri" panose="020F0502020204030204" pitchFamily="34" charset="0"/>
                <a:cs typeface="Times New Roman" panose="02020603050405020304" pitchFamily="18" charset="0"/>
              </a:rPr>
              <a:t> </a:t>
            </a:r>
          </a:p>
        </p:txBody>
      </p:sp>
    </p:spTree>
    <p:extLst>
      <p:ext uri="{BB962C8B-B14F-4D97-AF65-F5344CB8AC3E}">
        <p14:creationId xmlns:p14="http://schemas.microsoft.com/office/powerpoint/2010/main" val="1477472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a:extLst>
              <a:ext uri="{FF2B5EF4-FFF2-40B4-BE49-F238E27FC236}">
                <a16:creationId xmlns:a16="http://schemas.microsoft.com/office/drawing/2014/main" id="{82282A50-F97B-44DE-A01D-0915FA0FC741}"/>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670872" y="0"/>
            <a:ext cx="4850256" cy="6858000"/>
          </a:xfrm>
          <a:prstGeom prst="rect">
            <a:avLst/>
          </a:prstGeom>
        </p:spPr>
      </p:pic>
    </p:spTree>
    <p:extLst>
      <p:ext uri="{BB962C8B-B14F-4D97-AF65-F5344CB8AC3E}">
        <p14:creationId xmlns:p14="http://schemas.microsoft.com/office/powerpoint/2010/main" val="3382738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phic 2">
            <a:extLst>
              <a:ext uri="{FF2B5EF4-FFF2-40B4-BE49-F238E27FC236}">
                <a16:creationId xmlns:a16="http://schemas.microsoft.com/office/drawing/2014/main" id="{70150397-8243-4F29-8439-A8584EF0529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3670872" y="0"/>
            <a:ext cx="4850256" cy="6858000"/>
          </a:xfrm>
          <a:prstGeom prst="rect">
            <a:avLst/>
          </a:prstGeom>
        </p:spPr>
      </p:pic>
    </p:spTree>
    <p:extLst>
      <p:ext uri="{BB962C8B-B14F-4D97-AF65-F5344CB8AC3E}">
        <p14:creationId xmlns:p14="http://schemas.microsoft.com/office/powerpoint/2010/main" val="41267630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01BAC306-4C7D-4D2E-A9CD-033A568313AC}"/>
              </a:ext>
            </a:extLst>
          </p:cNvPr>
          <p:cNvSpPr txBox="1"/>
          <p:nvPr/>
        </p:nvSpPr>
        <p:spPr>
          <a:xfrm>
            <a:off x="352483" y="480610"/>
            <a:ext cx="338554"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01BAC306-4C7D-4D2E-A9CD-033A568313AC}"/>
              </a:ext>
            </a:extLst>
          </p:cNvPr>
          <p:cNvSpPr txBox="1"/>
          <p:nvPr/>
        </p:nvSpPr>
        <p:spPr>
          <a:xfrm>
            <a:off x="1616031" y="446938"/>
            <a:ext cx="338554"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01BAC306-4C7D-4D2E-A9CD-033A568313AC}"/>
              </a:ext>
            </a:extLst>
          </p:cNvPr>
          <p:cNvSpPr txBox="1"/>
          <p:nvPr/>
        </p:nvSpPr>
        <p:spPr>
          <a:xfrm>
            <a:off x="6245008" y="179668"/>
            <a:ext cx="267320" cy="369332"/>
          </a:xfrm>
          <a:prstGeom prst="rect">
            <a:avLst/>
          </a:prstGeom>
          <a:noFill/>
        </p:spPr>
        <p:txBody>
          <a:bodyPr wrap="square" rtlCol="0">
            <a:spAutoFit/>
          </a:bodyPr>
          <a:lstStyle/>
          <a:p>
            <a:r>
              <a:rPr lang="en-GB" dirty="0">
                <a:latin typeface="Arial" panose="020B0604020202020204" pitchFamily="34" charset="0"/>
                <a:cs typeface="Arial" panose="020B0604020202020204" pitchFamily="34" charset="0"/>
              </a:rPr>
              <a:t>D</a:t>
            </a:r>
          </a:p>
        </p:txBody>
      </p:sp>
      <p:pic>
        <p:nvPicPr>
          <p:cNvPr id="2" name="Picture 1"/>
          <p:cNvPicPr>
            <a:picLocks noChangeAspect="1"/>
          </p:cNvPicPr>
          <p:nvPr/>
        </p:nvPicPr>
        <p:blipFill>
          <a:blip r:embed="rId3"/>
          <a:stretch>
            <a:fillRect/>
          </a:stretch>
        </p:blipFill>
        <p:spPr>
          <a:xfrm>
            <a:off x="3328300" y="549000"/>
            <a:ext cx="2880000" cy="2880000"/>
          </a:xfrm>
          <a:prstGeom prst="rect">
            <a:avLst/>
          </a:prstGeom>
        </p:spPr>
      </p:pic>
      <p:pic>
        <p:nvPicPr>
          <p:cNvPr id="3" name="Picture 2"/>
          <p:cNvPicPr>
            <a:picLocks noChangeAspect="1"/>
          </p:cNvPicPr>
          <p:nvPr/>
        </p:nvPicPr>
        <p:blipFill>
          <a:blip r:embed="rId4"/>
          <a:stretch>
            <a:fillRect/>
          </a:stretch>
        </p:blipFill>
        <p:spPr>
          <a:xfrm>
            <a:off x="6512328" y="549000"/>
            <a:ext cx="2880000" cy="2880000"/>
          </a:xfrm>
          <a:prstGeom prst="rect">
            <a:avLst/>
          </a:prstGeom>
        </p:spPr>
      </p:pic>
      <p:pic>
        <p:nvPicPr>
          <p:cNvPr id="13" name="Picture 12"/>
          <p:cNvPicPr>
            <a:picLocks noChangeAspect="1"/>
          </p:cNvPicPr>
          <p:nvPr/>
        </p:nvPicPr>
        <p:blipFill>
          <a:blip r:embed="rId5"/>
          <a:stretch>
            <a:fillRect/>
          </a:stretch>
        </p:blipFill>
        <p:spPr>
          <a:xfrm>
            <a:off x="144271" y="3744247"/>
            <a:ext cx="2880000" cy="2880000"/>
          </a:xfrm>
          <a:prstGeom prst="rect">
            <a:avLst/>
          </a:prstGeom>
        </p:spPr>
      </p:pic>
      <p:pic>
        <p:nvPicPr>
          <p:cNvPr id="14" name="Picture 13"/>
          <p:cNvPicPr>
            <a:picLocks noChangeAspect="1"/>
          </p:cNvPicPr>
          <p:nvPr/>
        </p:nvPicPr>
        <p:blipFill>
          <a:blip r:embed="rId6"/>
          <a:stretch>
            <a:fillRect/>
          </a:stretch>
        </p:blipFill>
        <p:spPr>
          <a:xfrm>
            <a:off x="3328300" y="3744247"/>
            <a:ext cx="2880000" cy="2880000"/>
          </a:xfrm>
          <a:prstGeom prst="rect">
            <a:avLst/>
          </a:prstGeom>
        </p:spPr>
      </p:pic>
      <p:pic>
        <p:nvPicPr>
          <p:cNvPr id="15" name="Picture 14"/>
          <p:cNvPicPr>
            <a:picLocks noChangeAspect="1"/>
          </p:cNvPicPr>
          <p:nvPr/>
        </p:nvPicPr>
        <p:blipFill>
          <a:blip r:embed="rId7"/>
          <a:stretch>
            <a:fillRect/>
          </a:stretch>
        </p:blipFill>
        <p:spPr>
          <a:xfrm>
            <a:off x="6512328" y="3744247"/>
            <a:ext cx="2880000" cy="2880000"/>
          </a:xfrm>
          <a:prstGeom prst="rect">
            <a:avLst/>
          </a:prstGeom>
        </p:spPr>
      </p:pic>
      <p:pic>
        <p:nvPicPr>
          <p:cNvPr id="16" name="Picture 15"/>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1461828" y="2117382"/>
            <a:ext cx="1440000" cy="1440000"/>
          </a:xfrm>
          <a:prstGeom prst="rect">
            <a:avLst/>
          </a:prstGeom>
        </p:spPr>
      </p:pic>
      <p:pic>
        <p:nvPicPr>
          <p:cNvPr id="17" name="Picture 16"/>
          <p:cNvPicPr>
            <a:picLocks noChangeAspect="1"/>
          </p:cNvPicPr>
          <p:nvPr/>
        </p:nvPicPr>
        <p:blipFill rotWithShape="1">
          <a:blip r:embed="rId9" cstate="print">
            <a:extLst>
              <a:ext uri="{28A0092B-C50C-407E-A947-70E740481C1C}">
                <a14:useLocalDpi xmlns:a14="http://schemas.microsoft.com/office/drawing/2010/main" val="0"/>
              </a:ext>
            </a:extLst>
          </a:blip>
          <a:srcRect t="7058"/>
          <a:stretch/>
        </p:blipFill>
        <p:spPr>
          <a:xfrm>
            <a:off x="86452" y="2119061"/>
            <a:ext cx="1549354" cy="1440000"/>
          </a:xfrm>
          <a:prstGeom prst="rect">
            <a:avLst/>
          </a:prstGeom>
        </p:spPr>
      </p:pic>
      <p:pic>
        <p:nvPicPr>
          <p:cNvPr id="18" name="Picture 17"/>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29857" y="782597"/>
            <a:ext cx="1440000" cy="1440000"/>
          </a:xfrm>
          <a:prstGeom prst="rect">
            <a:avLst/>
          </a:prstGeom>
        </p:spPr>
      </p:pic>
      <p:pic>
        <p:nvPicPr>
          <p:cNvPr id="19" name="Picture 18"/>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441103" y="802769"/>
            <a:ext cx="1440000" cy="1440000"/>
          </a:xfrm>
          <a:prstGeom prst="rect">
            <a:avLst/>
          </a:prstGeom>
        </p:spPr>
      </p:pic>
      <p:cxnSp>
        <p:nvCxnSpPr>
          <p:cNvPr id="20" name="Straight Connector 19"/>
          <p:cNvCxnSpPr>
            <a:stCxn id="22" idx="1"/>
          </p:cNvCxnSpPr>
          <p:nvPr/>
        </p:nvCxnSpPr>
        <p:spPr>
          <a:xfrm flipH="1" flipV="1">
            <a:off x="425896" y="2283557"/>
            <a:ext cx="2052182" cy="1681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2478078" y="2115703"/>
            <a:ext cx="701040" cy="369332"/>
          </a:xfrm>
          <a:prstGeom prst="rect">
            <a:avLst/>
          </a:prstGeom>
          <a:noFill/>
        </p:spPr>
        <p:txBody>
          <a:bodyPr wrap="square" rtlCol="0">
            <a:spAutoFit/>
          </a:bodyPr>
          <a:lstStyle/>
          <a:p>
            <a:r>
              <a:rPr lang="en-GB" dirty="0"/>
              <a:t>90</a:t>
            </a:r>
            <a:r>
              <a:rPr lang="en-GB" dirty="0">
                <a:latin typeface="Calibri" panose="020F0502020204030204" pitchFamily="34" charset="0"/>
                <a:cs typeface="Calibri" panose="020F0502020204030204" pitchFamily="34" charset="0"/>
              </a:rPr>
              <a:t>°</a:t>
            </a:r>
            <a:endParaRPr lang="en-GB" dirty="0"/>
          </a:p>
        </p:txBody>
      </p:sp>
      <p:sp>
        <p:nvSpPr>
          <p:cNvPr id="11" name="TextBox 10">
            <a:extLst>
              <a:ext uri="{FF2B5EF4-FFF2-40B4-BE49-F238E27FC236}">
                <a16:creationId xmlns:a16="http://schemas.microsoft.com/office/drawing/2014/main" id="{01BAC306-4C7D-4D2E-A9CD-033A568313AC}"/>
              </a:ext>
            </a:extLst>
          </p:cNvPr>
          <p:cNvSpPr txBox="1"/>
          <p:nvPr/>
        </p:nvSpPr>
        <p:spPr>
          <a:xfrm>
            <a:off x="64215" y="3366006"/>
            <a:ext cx="351378"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E</a:t>
            </a:r>
          </a:p>
        </p:txBody>
      </p:sp>
      <p:sp>
        <p:nvSpPr>
          <p:cNvPr id="26" name="TextBox 25">
            <a:extLst>
              <a:ext uri="{FF2B5EF4-FFF2-40B4-BE49-F238E27FC236}">
                <a16:creationId xmlns:a16="http://schemas.microsoft.com/office/drawing/2014/main" id="{01BAC306-4C7D-4D2E-A9CD-033A568313AC}"/>
              </a:ext>
            </a:extLst>
          </p:cNvPr>
          <p:cNvSpPr txBox="1"/>
          <p:nvPr/>
        </p:nvSpPr>
        <p:spPr>
          <a:xfrm>
            <a:off x="3164782" y="3366006"/>
            <a:ext cx="325730"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F</a:t>
            </a:r>
          </a:p>
        </p:txBody>
      </p:sp>
      <p:sp>
        <p:nvSpPr>
          <p:cNvPr id="27" name="TextBox 26">
            <a:extLst>
              <a:ext uri="{FF2B5EF4-FFF2-40B4-BE49-F238E27FC236}">
                <a16:creationId xmlns:a16="http://schemas.microsoft.com/office/drawing/2014/main" id="{01BAC306-4C7D-4D2E-A9CD-033A568313AC}"/>
              </a:ext>
            </a:extLst>
          </p:cNvPr>
          <p:cNvSpPr txBox="1"/>
          <p:nvPr/>
        </p:nvSpPr>
        <p:spPr>
          <a:xfrm>
            <a:off x="6245008" y="3374915"/>
            <a:ext cx="364202"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G</a:t>
            </a:r>
          </a:p>
        </p:txBody>
      </p:sp>
      <p:sp>
        <p:nvSpPr>
          <p:cNvPr id="30" name="TextBox 29">
            <a:extLst>
              <a:ext uri="{FF2B5EF4-FFF2-40B4-BE49-F238E27FC236}">
                <a16:creationId xmlns:a16="http://schemas.microsoft.com/office/drawing/2014/main" id="{01BAC306-4C7D-4D2E-A9CD-033A568313AC}"/>
              </a:ext>
            </a:extLst>
          </p:cNvPr>
          <p:cNvSpPr txBox="1"/>
          <p:nvPr/>
        </p:nvSpPr>
        <p:spPr>
          <a:xfrm>
            <a:off x="3159023" y="153183"/>
            <a:ext cx="351378" cy="369332"/>
          </a:xfrm>
          <a:prstGeom prst="rect">
            <a:avLst/>
          </a:prstGeom>
          <a:noFill/>
        </p:spPr>
        <p:txBody>
          <a:bodyPr wrap="none" rtlCol="0">
            <a:spAutoFit/>
          </a:bodyPr>
          <a:lstStyle/>
          <a:p>
            <a:r>
              <a:rPr lang="en-GB" dirty="0">
                <a:latin typeface="Arial" panose="020B0604020202020204" pitchFamily="34" charset="0"/>
                <a:cs typeface="Arial" panose="020B0604020202020204" pitchFamily="34" charset="0"/>
              </a:rPr>
              <a:t>C</a:t>
            </a:r>
          </a:p>
        </p:txBody>
      </p:sp>
      <p:sp>
        <p:nvSpPr>
          <p:cNvPr id="21" name="Rectangle 20">
            <a:extLst>
              <a:ext uri="{FF2B5EF4-FFF2-40B4-BE49-F238E27FC236}">
                <a16:creationId xmlns:a16="http://schemas.microsoft.com/office/drawing/2014/main" id="{65234751-FA3C-4E57-985F-1C2D4DA82BEC}"/>
              </a:ext>
            </a:extLst>
          </p:cNvPr>
          <p:cNvSpPr/>
          <p:nvPr/>
        </p:nvSpPr>
        <p:spPr>
          <a:xfrm>
            <a:off x="158580" y="84343"/>
            <a:ext cx="1088760" cy="369332"/>
          </a:xfrm>
          <a:prstGeom prst="rect">
            <a:avLst/>
          </a:prstGeom>
        </p:spPr>
        <p:txBody>
          <a:bodyPr wrap="none">
            <a:spAutoFit/>
          </a:bodyPr>
          <a:lstStyle/>
          <a:p>
            <a:r>
              <a:rPr lang="en-GB" dirty="0">
                <a:latin typeface="Times New Roman" panose="02020603050405020304" pitchFamily="18" charset="0"/>
                <a:ea typeface="Calibri" panose="020F0502020204030204" pitchFamily="34" charset="0"/>
              </a:rPr>
              <a:t>Figure S3</a:t>
            </a:r>
            <a:endParaRPr lang="en-GB" dirty="0"/>
          </a:p>
        </p:txBody>
      </p:sp>
    </p:spTree>
    <p:extLst>
      <p:ext uri="{BB962C8B-B14F-4D97-AF65-F5344CB8AC3E}">
        <p14:creationId xmlns:p14="http://schemas.microsoft.com/office/powerpoint/2010/main" val="9571674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32B2BDE9-51FE-4B40-A078-38FB87C3608D}"/>
              </a:ext>
            </a:extLst>
          </p:cNvPr>
          <p:cNvGrpSpPr/>
          <p:nvPr/>
        </p:nvGrpSpPr>
        <p:grpSpPr>
          <a:xfrm>
            <a:off x="2395481" y="108411"/>
            <a:ext cx="5349429" cy="3542208"/>
            <a:chOff x="1445957" y="1247777"/>
            <a:chExt cx="8577071" cy="5679442"/>
          </a:xfrm>
        </p:grpSpPr>
        <p:graphicFrame>
          <p:nvGraphicFramePr>
            <p:cNvPr id="4" name="Chart 3">
              <a:extLst>
                <a:ext uri="{FF2B5EF4-FFF2-40B4-BE49-F238E27FC236}">
                  <a16:creationId xmlns:a16="http://schemas.microsoft.com/office/drawing/2014/main" id="{57C5E476-E470-43E8-9F12-79F9067A93DF}"/>
                </a:ext>
              </a:extLst>
            </p:cNvPr>
            <p:cNvGraphicFramePr>
              <a:graphicFrameLocks noChangeAspect="1"/>
            </p:cNvGraphicFramePr>
            <p:nvPr/>
          </p:nvGraphicFramePr>
          <p:xfrm>
            <a:off x="1445957" y="1247777"/>
            <a:ext cx="8577071" cy="5679442"/>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1E3E8651-E6E8-4146-AC44-BD51E632D41F}"/>
                </a:ext>
              </a:extLst>
            </p:cNvPr>
            <p:cNvSpPr txBox="1"/>
            <p:nvPr/>
          </p:nvSpPr>
          <p:spPr>
            <a:xfrm>
              <a:off x="7055822" y="1385248"/>
              <a:ext cx="5822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389]</a:t>
              </a:r>
            </a:p>
          </p:txBody>
        </p:sp>
        <p:sp>
          <p:nvSpPr>
            <p:cNvPr id="6" name="TextBox 5">
              <a:extLst>
                <a:ext uri="{FF2B5EF4-FFF2-40B4-BE49-F238E27FC236}">
                  <a16:creationId xmlns:a16="http://schemas.microsoft.com/office/drawing/2014/main" id="{A30D8A16-24C5-40AF-9163-E23130FD3E6F}"/>
                </a:ext>
              </a:extLst>
            </p:cNvPr>
            <p:cNvSpPr txBox="1"/>
            <p:nvPr/>
          </p:nvSpPr>
          <p:spPr>
            <a:xfrm>
              <a:off x="5308294" y="1725338"/>
              <a:ext cx="5822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249]</a:t>
              </a:r>
            </a:p>
          </p:txBody>
        </p:sp>
        <p:sp>
          <p:nvSpPr>
            <p:cNvPr id="7" name="TextBox 6">
              <a:extLst>
                <a:ext uri="{FF2B5EF4-FFF2-40B4-BE49-F238E27FC236}">
                  <a16:creationId xmlns:a16="http://schemas.microsoft.com/office/drawing/2014/main" id="{8F96BCCF-6CA0-4816-98B7-CE1577184EDC}"/>
                </a:ext>
              </a:extLst>
            </p:cNvPr>
            <p:cNvSpPr txBox="1"/>
            <p:nvPr/>
          </p:nvSpPr>
          <p:spPr>
            <a:xfrm>
              <a:off x="8656497" y="3702231"/>
              <a:ext cx="5822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526]</a:t>
              </a:r>
            </a:p>
          </p:txBody>
        </p:sp>
      </p:grpSp>
      <p:sp>
        <p:nvSpPr>
          <p:cNvPr id="8" name="TextBox 7">
            <a:extLst>
              <a:ext uri="{FF2B5EF4-FFF2-40B4-BE49-F238E27FC236}">
                <a16:creationId xmlns:a16="http://schemas.microsoft.com/office/drawing/2014/main" id="{FBD62615-F717-4304-A49D-20755417979A}"/>
              </a:ext>
            </a:extLst>
          </p:cNvPr>
          <p:cNvSpPr txBox="1"/>
          <p:nvPr/>
        </p:nvSpPr>
        <p:spPr>
          <a:xfrm>
            <a:off x="3646426" y="3708094"/>
            <a:ext cx="853554" cy="307777"/>
          </a:xfrm>
          <a:prstGeom prst="rect">
            <a:avLst/>
          </a:prstGeom>
          <a:noFill/>
        </p:spPr>
        <p:txBody>
          <a:bodyPr wrap="square" rtlCol="0">
            <a:spAutoFit/>
          </a:bodyPr>
          <a:lstStyle/>
          <a:p>
            <a:r>
              <a:rPr lang="en-GB" sz="1400" dirty="0">
                <a:latin typeface="Arial" panose="020B0604020202020204" pitchFamily="34" charset="0"/>
                <a:cs typeface="Arial" panose="020B0604020202020204" pitchFamily="34" charset="0"/>
              </a:rPr>
              <a:t>[389]</a:t>
            </a:r>
          </a:p>
        </p:txBody>
      </p:sp>
      <p:sp>
        <p:nvSpPr>
          <p:cNvPr id="9" name="TextBox 8">
            <a:extLst>
              <a:ext uri="{FF2B5EF4-FFF2-40B4-BE49-F238E27FC236}">
                <a16:creationId xmlns:a16="http://schemas.microsoft.com/office/drawing/2014/main" id="{AA5E8A65-2FC3-40EF-82FB-391AC9AC204B}"/>
              </a:ext>
            </a:extLst>
          </p:cNvPr>
          <p:cNvSpPr txBox="1"/>
          <p:nvPr/>
        </p:nvSpPr>
        <p:spPr>
          <a:xfrm>
            <a:off x="5225411" y="3708094"/>
            <a:ext cx="5822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249]</a:t>
            </a:r>
          </a:p>
        </p:txBody>
      </p:sp>
      <p:sp>
        <p:nvSpPr>
          <p:cNvPr id="10" name="TextBox 9">
            <a:extLst>
              <a:ext uri="{FF2B5EF4-FFF2-40B4-BE49-F238E27FC236}">
                <a16:creationId xmlns:a16="http://schemas.microsoft.com/office/drawing/2014/main" id="{6864039A-C362-4C8B-A723-8C4D694B6901}"/>
              </a:ext>
            </a:extLst>
          </p:cNvPr>
          <p:cNvSpPr txBox="1"/>
          <p:nvPr/>
        </p:nvSpPr>
        <p:spPr>
          <a:xfrm>
            <a:off x="6533054" y="3708094"/>
            <a:ext cx="582211" cy="307777"/>
          </a:xfrm>
          <a:prstGeom prst="rect">
            <a:avLst/>
          </a:prstGeom>
          <a:noFill/>
        </p:spPr>
        <p:txBody>
          <a:bodyPr wrap="none" rtlCol="0">
            <a:spAutoFit/>
          </a:bodyPr>
          <a:lstStyle/>
          <a:p>
            <a:r>
              <a:rPr lang="en-GB" sz="1400" dirty="0">
                <a:latin typeface="Arial" panose="020B0604020202020204" pitchFamily="34" charset="0"/>
                <a:cs typeface="Arial" panose="020B0604020202020204" pitchFamily="34" charset="0"/>
              </a:rPr>
              <a:t>[526]</a:t>
            </a:r>
          </a:p>
        </p:txBody>
      </p:sp>
      <p:pic>
        <p:nvPicPr>
          <p:cNvPr id="11" name="Picture 10">
            <a:extLst>
              <a:ext uri="{FF2B5EF4-FFF2-40B4-BE49-F238E27FC236}">
                <a16:creationId xmlns:a16="http://schemas.microsoft.com/office/drawing/2014/main" id="{042EB436-5F45-4A22-AE32-E82B0D516B92}"/>
              </a:ext>
            </a:extLst>
          </p:cNvPr>
          <p:cNvPicPr>
            <a:picLocks noChangeAspect="1"/>
          </p:cNvPicPr>
          <p:nvPr/>
        </p:nvPicPr>
        <p:blipFill>
          <a:blip r:embed="rId3"/>
          <a:stretch>
            <a:fillRect/>
          </a:stretch>
        </p:blipFill>
        <p:spPr>
          <a:xfrm>
            <a:off x="5079620" y="4173146"/>
            <a:ext cx="796874" cy="2684854"/>
          </a:xfrm>
          <a:prstGeom prst="rect">
            <a:avLst/>
          </a:prstGeom>
        </p:spPr>
      </p:pic>
      <p:pic>
        <p:nvPicPr>
          <p:cNvPr id="12" name="Picture 11">
            <a:extLst>
              <a:ext uri="{FF2B5EF4-FFF2-40B4-BE49-F238E27FC236}">
                <a16:creationId xmlns:a16="http://schemas.microsoft.com/office/drawing/2014/main" id="{90ECE16A-E4CC-4321-9DAA-1EA5D8CAAD04}"/>
              </a:ext>
            </a:extLst>
          </p:cNvPr>
          <p:cNvPicPr>
            <a:picLocks noChangeAspect="1"/>
          </p:cNvPicPr>
          <p:nvPr/>
        </p:nvPicPr>
        <p:blipFill>
          <a:blip r:embed="rId4"/>
          <a:stretch>
            <a:fillRect/>
          </a:stretch>
        </p:blipFill>
        <p:spPr>
          <a:xfrm>
            <a:off x="3049619" y="4173146"/>
            <a:ext cx="1753124" cy="2678724"/>
          </a:xfrm>
          <a:prstGeom prst="rect">
            <a:avLst/>
          </a:prstGeom>
        </p:spPr>
      </p:pic>
      <p:pic>
        <p:nvPicPr>
          <p:cNvPr id="13" name="Picture 12">
            <a:extLst>
              <a:ext uri="{FF2B5EF4-FFF2-40B4-BE49-F238E27FC236}">
                <a16:creationId xmlns:a16="http://schemas.microsoft.com/office/drawing/2014/main" id="{53C5DAD6-B764-4E31-A70D-863CC90D3978}"/>
              </a:ext>
            </a:extLst>
          </p:cNvPr>
          <p:cNvPicPr>
            <a:picLocks noChangeAspect="1"/>
          </p:cNvPicPr>
          <p:nvPr/>
        </p:nvPicPr>
        <p:blipFill>
          <a:blip r:embed="rId5"/>
          <a:stretch>
            <a:fillRect/>
          </a:stretch>
        </p:blipFill>
        <p:spPr>
          <a:xfrm>
            <a:off x="6313174" y="4173146"/>
            <a:ext cx="753966" cy="1765383"/>
          </a:xfrm>
          <a:prstGeom prst="rect">
            <a:avLst/>
          </a:prstGeom>
        </p:spPr>
      </p:pic>
      <p:sp>
        <p:nvSpPr>
          <p:cNvPr id="14" name="Rectangle 13">
            <a:extLst>
              <a:ext uri="{FF2B5EF4-FFF2-40B4-BE49-F238E27FC236}">
                <a16:creationId xmlns:a16="http://schemas.microsoft.com/office/drawing/2014/main" id="{B84683BB-CA77-40EC-AC5B-C793B640C262}"/>
              </a:ext>
            </a:extLst>
          </p:cNvPr>
          <p:cNvSpPr/>
          <p:nvPr/>
        </p:nvSpPr>
        <p:spPr>
          <a:xfrm>
            <a:off x="218071" y="164250"/>
            <a:ext cx="1088760" cy="369332"/>
          </a:xfrm>
          <a:prstGeom prst="rect">
            <a:avLst/>
          </a:prstGeom>
        </p:spPr>
        <p:txBody>
          <a:bodyPr wrap="none">
            <a:spAutoFit/>
          </a:bodyPr>
          <a:lstStyle/>
          <a:p>
            <a:r>
              <a:rPr lang="en-GB" dirty="0">
                <a:latin typeface="Times New Roman" panose="02020603050405020304" pitchFamily="18" charset="0"/>
                <a:ea typeface="Calibri" panose="020F0502020204030204" pitchFamily="34" charset="0"/>
              </a:rPr>
              <a:t>Figure S4</a:t>
            </a:r>
            <a:endParaRPr lang="en-GB" dirty="0"/>
          </a:p>
        </p:txBody>
      </p:sp>
    </p:spTree>
    <p:extLst>
      <p:ext uri="{BB962C8B-B14F-4D97-AF65-F5344CB8AC3E}">
        <p14:creationId xmlns:p14="http://schemas.microsoft.com/office/powerpoint/2010/main" val="39491569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6</TotalTime>
  <Words>234</Words>
  <Application>Microsoft Office PowerPoint</Application>
  <PresentationFormat>Widescreen</PresentationFormat>
  <Paragraphs>32</Paragraphs>
  <Slides>5</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iyang Wu (QIB)</dc:creator>
  <cp:lastModifiedBy>Nathalie Juge (QIB)</cp:lastModifiedBy>
  <cp:revision>7</cp:revision>
  <dcterms:created xsi:type="dcterms:W3CDTF">2019-12-20T16:40:06Z</dcterms:created>
  <dcterms:modified xsi:type="dcterms:W3CDTF">2020-04-17T16:32:24Z</dcterms:modified>
</cp:coreProperties>
</file>